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8" r:id="rId5"/>
  </p:sldIdLst>
  <p:sldSz cx="9906000" cy="6858000" type="A4"/>
  <p:notesSz cx="9866313" cy="67357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42" userDrawn="1">
          <p15:clr>
            <a:srgbClr val="A4A3A4"/>
          </p15:clr>
        </p15:guide>
        <p15:guide id="2" pos="875" userDrawn="1">
          <p15:clr>
            <a:srgbClr val="A4A3A4"/>
          </p15:clr>
        </p15:guide>
        <p15:guide id="3" orient="horz" pos="22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DDDEE"/>
    <a:srgbClr val="FFCFCF"/>
    <a:srgbClr val="FFFFFF"/>
    <a:srgbClr val="FF1111"/>
    <a:srgbClr val="DAE3F3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65C1499-9051-4DCE-8995-C0AE10CD6F54}" v="35" dt="2023-06-26T06:14:31.46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1434" y="102"/>
      </p:cViewPr>
      <p:guideLst>
        <p:guide orient="horz" pos="4042"/>
        <p:guide pos="875"/>
        <p:guide orient="horz" pos="22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板野 精之" userId="d14abaad31e2099c" providerId="LiveId" clId="{337C60FC-62BA-49DE-B98E-1E28D14D543B}"/>
    <pc:docChg chg="undo custSel modSld">
      <pc:chgData name="板野 精之" userId="d14abaad31e2099c" providerId="LiveId" clId="{337C60FC-62BA-49DE-B98E-1E28D14D543B}" dt="2023-05-09T07:47:52.341" v="174" actId="5736"/>
      <pc:docMkLst>
        <pc:docMk/>
      </pc:docMkLst>
      <pc:sldChg chg="modSp mod">
        <pc:chgData name="板野 精之" userId="d14abaad31e2099c" providerId="LiveId" clId="{337C60FC-62BA-49DE-B98E-1E28D14D543B}" dt="2023-05-09T07:47:52.341" v="174" actId="5736"/>
        <pc:sldMkLst>
          <pc:docMk/>
          <pc:sldMk cId="2089187721" sldId="258"/>
        </pc:sldMkLst>
        <pc:graphicFrameChg chg="mod modGraphic">
          <ac:chgData name="板野 精之" userId="d14abaad31e2099c" providerId="LiveId" clId="{337C60FC-62BA-49DE-B98E-1E28D14D543B}" dt="2023-05-09T07:47:52.341" v="174" actId="5736"/>
          <ac:graphicFrameMkLst>
            <pc:docMk/>
            <pc:sldMk cId="2089187721" sldId="258"/>
            <ac:graphicFrameMk id="6" creationId="{647F7E30-80FD-4CFC-B3EA-6FA0814B7B06}"/>
          </ac:graphicFrameMkLst>
        </pc:graphicFrameChg>
      </pc:sldChg>
    </pc:docChg>
  </pc:docChgLst>
  <pc:docChgLst>
    <pc:chgData name="板野 精之" userId="d14abaad31e2099c" providerId="LiveId" clId="{40984B5C-7FD1-469C-ABAC-6ED3F3D9C99B}"/>
    <pc:docChg chg="undo custSel modSld">
      <pc:chgData name="板野 精之" userId="d14abaad31e2099c" providerId="LiveId" clId="{40984B5C-7FD1-469C-ABAC-6ED3F3D9C99B}" dt="2023-01-23T23:54:00.815" v="180" actId="5736"/>
      <pc:docMkLst>
        <pc:docMk/>
      </pc:docMkLst>
      <pc:sldChg chg="addSp delSp modSp mod">
        <pc:chgData name="板野 精之" userId="d14abaad31e2099c" providerId="LiveId" clId="{40984B5C-7FD1-469C-ABAC-6ED3F3D9C99B}" dt="2023-01-23T23:53:07.402" v="179" actId="164"/>
        <pc:sldMkLst>
          <pc:docMk/>
          <pc:sldMk cId="2006302855" sldId="256"/>
        </pc:sldMkLst>
        <pc:spChg chg="mod">
          <ac:chgData name="板野 精之" userId="d14abaad31e2099c" providerId="LiveId" clId="{40984B5C-7FD1-469C-ABAC-6ED3F3D9C99B}" dt="2023-01-23T07:46:24.736" v="128" actId="14100"/>
          <ac:spMkLst>
            <pc:docMk/>
            <pc:sldMk cId="2006302855" sldId="256"/>
            <ac:spMk id="4" creationId="{9A61A6A7-9D44-173A-CE81-E8A2C380BA1F}"/>
          </ac:spMkLst>
        </pc:spChg>
        <pc:spChg chg="add mod">
          <ac:chgData name="板野 精之" userId="d14abaad31e2099c" providerId="LiveId" clId="{40984B5C-7FD1-469C-ABAC-6ED3F3D9C99B}" dt="2023-01-23T23:53:07.402" v="179" actId="164"/>
          <ac:spMkLst>
            <pc:docMk/>
            <pc:sldMk cId="2006302855" sldId="256"/>
            <ac:spMk id="6" creationId="{E7B0B3AC-E0C8-B797-5539-BC8CF792274E}"/>
          </ac:spMkLst>
        </pc:spChg>
        <pc:spChg chg="del mod">
          <ac:chgData name="板野 精之" userId="d14abaad31e2099c" providerId="LiveId" clId="{40984B5C-7FD1-469C-ABAC-6ED3F3D9C99B}" dt="2023-01-23T07:46:08.182" v="125" actId="478"/>
          <ac:spMkLst>
            <pc:docMk/>
            <pc:sldMk cId="2006302855" sldId="256"/>
            <ac:spMk id="10" creationId="{F5752CD3-FDA7-B111-56D7-09676327FA7E}"/>
          </ac:spMkLst>
        </pc:spChg>
        <pc:spChg chg="add mod">
          <ac:chgData name="板野 精之" userId="d14abaad31e2099c" providerId="LiveId" clId="{40984B5C-7FD1-469C-ABAC-6ED3F3D9C99B}" dt="2023-01-23T23:53:07.402" v="179" actId="164"/>
          <ac:spMkLst>
            <pc:docMk/>
            <pc:sldMk cId="2006302855" sldId="256"/>
            <ac:spMk id="23" creationId="{56BE33CE-F2BF-EA91-44D9-8E72ECFDC65C}"/>
          </ac:spMkLst>
        </pc:spChg>
        <pc:spChg chg="del">
          <ac:chgData name="板野 精之" userId="d14abaad31e2099c" providerId="LiveId" clId="{40984B5C-7FD1-469C-ABAC-6ED3F3D9C99B}" dt="2023-01-23T07:46:06.271" v="124" actId="478"/>
          <ac:spMkLst>
            <pc:docMk/>
            <pc:sldMk cId="2006302855" sldId="256"/>
            <ac:spMk id="84" creationId="{E74E5502-4EC1-F401-242B-FDD67FE43AFD}"/>
          </ac:spMkLst>
        </pc:spChg>
        <pc:spChg chg="mod">
          <ac:chgData name="板野 精之" userId="d14abaad31e2099c" providerId="LiveId" clId="{40984B5C-7FD1-469C-ABAC-6ED3F3D9C99B}" dt="2023-01-23T07:42:43.149" v="53" actId="20577"/>
          <ac:spMkLst>
            <pc:docMk/>
            <pc:sldMk cId="2006302855" sldId="256"/>
            <ac:spMk id="260" creationId="{22115C42-6609-AB37-2AD2-9FD6C4B0A4B5}"/>
          </ac:spMkLst>
        </pc:spChg>
        <pc:spChg chg="mod">
          <ac:chgData name="板野 精之" userId="d14abaad31e2099c" providerId="LiveId" clId="{40984B5C-7FD1-469C-ABAC-6ED3F3D9C99B}" dt="2023-01-23T07:42:47.930" v="56" actId="20577"/>
          <ac:spMkLst>
            <pc:docMk/>
            <pc:sldMk cId="2006302855" sldId="256"/>
            <ac:spMk id="262" creationId="{50BD7C07-8047-5587-5276-973D878B000E}"/>
          </ac:spMkLst>
        </pc:spChg>
        <pc:spChg chg="mod">
          <ac:chgData name="板野 精之" userId="d14abaad31e2099c" providerId="LiveId" clId="{40984B5C-7FD1-469C-ABAC-6ED3F3D9C99B}" dt="2023-01-23T07:42:38.002" v="50" actId="20577"/>
          <ac:spMkLst>
            <pc:docMk/>
            <pc:sldMk cId="2006302855" sldId="256"/>
            <ac:spMk id="264" creationId="{864A04EE-1A36-EEA0-99FF-031823097EB0}"/>
          </ac:spMkLst>
        </pc:spChg>
        <pc:spChg chg="mod">
          <ac:chgData name="板野 精之" userId="d14abaad31e2099c" providerId="LiveId" clId="{40984B5C-7FD1-469C-ABAC-6ED3F3D9C99B}" dt="2023-01-23T07:42:57.775" v="62" actId="20577"/>
          <ac:spMkLst>
            <pc:docMk/>
            <pc:sldMk cId="2006302855" sldId="256"/>
            <ac:spMk id="266" creationId="{CCDA4E1C-ADD7-28E1-9BAD-F22245B38635}"/>
          </ac:spMkLst>
        </pc:spChg>
        <pc:spChg chg="mod">
          <ac:chgData name="板野 精之" userId="d14abaad31e2099c" providerId="LiveId" clId="{40984B5C-7FD1-469C-ABAC-6ED3F3D9C99B}" dt="2023-01-23T07:43:02.211" v="65" actId="20577"/>
          <ac:spMkLst>
            <pc:docMk/>
            <pc:sldMk cId="2006302855" sldId="256"/>
            <ac:spMk id="268" creationId="{7E74E2CD-03CF-BBCB-F832-5A088F27F6E8}"/>
          </ac:spMkLst>
        </pc:spChg>
        <pc:spChg chg="mod">
          <ac:chgData name="板野 精之" userId="d14abaad31e2099c" providerId="LiveId" clId="{40984B5C-7FD1-469C-ABAC-6ED3F3D9C99B}" dt="2023-01-23T07:42:52.311" v="59" actId="20577"/>
          <ac:spMkLst>
            <pc:docMk/>
            <pc:sldMk cId="2006302855" sldId="256"/>
            <ac:spMk id="270" creationId="{6EF9C3F7-DC64-DBE2-C345-AAAE20D2B5B8}"/>
          </ac:spMkLst>
        </pc:spChg>
        <pc:grpChg chg="mod">
          <ac:chgData name="板野 精之" userId="d14abaad31e2099c" providerId="LiveId" clId="{40984B5C-7FD1-469C-ABAC-6ED3F3D9C99B}" dt="2023-01-23T23:53:07.402" v="179" actId="164"/>
          <ac:grpSpMkLst>
            <pc:docMk/>
            <pc:sldMk cId="2006302855" sldId="256"/>
            <ac:grpSpMk id="2" creationId="{00000000-0000-0000-0000-000000000000}"/>
          </ac:grpSpMkLst>
        </pc:grpChg>
        <pc:grpChg chg="add mod">
          <ac:chgData name="板野 精之" userId="d14abaad31e2099c" providerId="LiveId" clId="{40984B5C-7FD1-469C-ABAC-6ED3F3D9C99B}" dt="2023-01-23T23:53:07.402" v="179" actId="164"/>
          <ac:grpSpMkLst>
            <pc:docMk/>
            <pc:sldMk cId="2006302855" sldId="256"/>
            <ac:grpSpMk id="26" creationId="{6A120EE0-7A08-5CA9-B04B-E4DB38A18185}"/>
          </ac:grpSpMkLst>
        </pc:grpChg>
      </pc:sldChg>
      <pc:sldChg chg="addSp delSp modSp mod">
        <pc:chgData name="板野 精之" userId="d14abaad31e2099c" providerId="LiveId" clId="{40984B5C-7FD1-469C-ABAC-6ED3F3D9C99B}" dt="2023-01-23T07:45:49.526" v="123" actId="1076"/>
        <pc:sldMkLst>
          <pc:docMk/>
          <pc:sldMk cId="1840233059" sldId="257"/>
        </pc:sldMkLst>
        <pc:spChg chg="add del mod">
          <ac:chgData name="板野 精之" userId="d14abaad31e2099c" providerId="LiveId" clId="{40984B5C-7FD1-469C-ABAC-6ED3F3D9C99B}" dt="2023-01-23T07:43:32.950" v="69"/>
          <ac:spMkLst>
            <pc:docMk/>
            <pc:sldMk cId="1840233059" sldId="257"/>
            <ac:spMk id="4" creationId="{C1276C7D-80AB-4041-39D1-BE0243CAF6A7}"/>
          </ac:spMkLst>
        </pc:spChg>
        <pc:spChg chg="mod">
          <ac:chgData name="板野 精之" userId="d14abaad31e2099c" providerId="LiveId" clId="{40984B5C-7FD1-469C-ABAC-6ED3F3D9C99B}" dt="2023-01-23T07:45:44.102" v="122" actId="1076"/>
          <ac:spMkLst>
            <pc:docMk/>
            <pc:sldMk cId="1840233059" sldId="257"/>
            <ac:spMk id="5" creationId="{ACE57591-480D-A2EB-97A9-8B715C3FED4A}"/>
          </ac:spMkLst>
        </pc:spChg>
        <pc:spChg chg="add del mod">
          <ac:chgData name="板野 精之" userId="d14abaad31e2099c" providerId="LiveId" clId="{40984B5C-7FD1-469C-ABAC-6ED3F3D9C99B}" dt="2023-01-23T07:43:32.950" v="69"/>
          <ac:spMkLst>
            <pc:docMk/>
            <pc:sldMk cId="1840233059" sldId="257"/>
            <ac:spMk id="10" creationId="{DC0200B9-B79A-6A37-D3B3-C6F14E2DA1AC}"/>
          </ac:spMkLst>
        </pc:spChg>
        <pc:spChg chg="add del mod">
          <ac:chgData name="板野 精之" userId="d14abaad31e2099c" providerId="LiveId" clId="{40984B5C-7FD1-469C-ABAC-6ED3F3D9C99B}" dt="2023-01-23T07:43:32.950" v="69"/>
          <ac:spMkLst>
            <pc:docMk/>
            <pc:sldMk cId="1840233059" sldId="257"/>
            <ac:spMk id="11" creationId="{8C07824B-BCB2-441D-C440-430583573FF9}"/>
          </ac:spMkLst>
        </pc:spChg>
        <pc:spChg chg="add del mod">
          <ac:chgData name="板野 精之" userId="d14abaad31e2099c" providerId="LiveId" clId="{40984B5C-7FD1-469C-ABAC-6ED3F3D9C99B}" dt="2023-01-23T07:43:32.950" v="69"/>
          <ac:spMkLst>
            <pc:docMk/>
            <pc:sldMk cId="1840233059" sldId="257"/>
            <ac:spMk id="12" creationId="{1EA2C37E-45B5-64A9-08F2-1F9ADCAC7349}"/>
          </ac:spMkLst>
        </pc:spChg>
        <pc:spChg chg="add del mod">
          <ac:chgData name="板野 精之" userId="d14abaad31e2099c" providerId="LiveId" clId="{40984B5C-7FD1-469C-ABAC-6ED3F3D9C99B}" dt="2023-01-23T07:43:32.950" v="69"/>
          <ac:spMkLst>
            <pc:docMk/>
            <pc:sldMk cId="1840233059" sldId="257"/>
            <ac:spMk id="13" creationId="{C2A735D2-CBB4-0A0D-53EA-31A2E87E0931}"/>
          </ac:spMkLst>
        </pc:spChg>
        <pc:spChg chg="add del mod">
          <ac:chgData name="板野 精之" userId="d14abaad31e2099c" providerId="LiveId" clId="{40984B5C-7FD1-469C-ABAC-6ED3F3D9C99B}" dt="2023-01-23T07:43:32.950" v="69"/>
          <ac:spMkLst>
            <pc:docMk/>
            <pc:sldMk cId="1840233059" sldId="257"/>
            <ac:spMk id="14" creationId="{DCE4B18A-5B84-F541-1080-E44B7B451528}"/>
          </ac:spMkLst>
        </pc:spChg>
        <pc:spChg chg="mod">
          <ac:chgData name="板野 精之" userId="d14abaad31e2099c" providerId="LiveId" clId="{40984B5C-7FD1-469C-ABAC-6ED3F3D9C99B}" dt="2023-01-23T07:45:10.066" v="105" actId="20577"/>
          <ac:spMkLst>
            <pc:docMk/>
            <pc:sldMk cId="1840233059" sldId="257"/>
            <ac:spMk id="24" creationId="{0C021420-5FA4-10B5-007D-0B2349AADB9F}"/>
          </ac:spMkLst>
        </pc:spChg>
        <pc:spChg chg="add del mod">
          <ac:chgData name="板野 精之" userId="d14abaad31e2099c" providerId="LiveId" clId="{40984B5C-7FD1-469C-ABAC-6ED3F3D9C99B}" dt="2023-01-23T07:43:44.847" v="77" actId="20577"/>
          <ac:spMkLst>
            <pc:docMk/>
            <pc:sldMk cId="1840233059" sldId="257"/>
            <ac:spMk id="43" creationId="{18384BB5-CEE5-BC2A-BF38-050E23033199}"/>
          </ac:spMkLst>
        </pc:spChg>
        <pc:spChg chg="mod">
          <ac:chgData name="板野 精之" userId="d14abaad31e2099c" providerId="LiveId" clId="{40984B5C-7FD1-469C-ABAC-6ED3F3D9C99B}" dt="2023-01-23T07:43:49.311" v="80" actId="20577"/>
          <ac:spMkLst>
            <pc:docMk/>
            <pc:sldMk cId="1840233059" sldId="257"/>
            <ac:spMk id="45" creationId="{77E7F0E5-A3A4-9A8D-96A2-5E3A3BA1CB4A}"/>
          </ac:spMkLst>
        </pc:spChg>
        <pc:spChg chg="add del mod">
          <ac:chgData name="板野 精之" userId="d14abaad31e2099c" providerId="LiveId" clId="{40984B5C-7FD1-469C-ABAC-6ED3F3D9C99B}" dt="2023-01-23T07:43:40.749" v="74" actId="20577"/>
          <ac:spMkLst>
            <pc:docMk/>
            <pc:sldMk cId="1840233059" sldId="257"/>
            <ac:spMk id="47" creationId="{85B9BF24-FF4A-F21E-8E20-419E72806C41}"/>
          </ac:spMkLst>
        </pc:spChg>
        <pc:spChg chg="mod">
          <ac:chgData name="板野 精之" userId="d14abaad31e2099c" providerId="LiveId" clId="{40984B5C-7FD1-469C-ABAC-6ED3F3D9C99B}" dt="2023-01-23T07:43:58.383" v="86" actId="20577"/>
          <ac:spMkLst>
            <pc:docMk/>
            <pc:sldMk cId="1840233059" sldId="257"/>
            <ac:spMk id="67" creationId="{EAC5493F-8E19-167B-411F-9C43F3CDBBA6}"/>
          </ac:spMkLst>
        </pc:spChg>
        <pc:spChg chg="mod">
          <ac:chgData name="板野 精之" userId="d14abaad31e2099c" providerId="LiveId" clId="{40984B5C-7FD1-469C-ABAC-6ED3F3D9C99B}" dt="2023-01-23T07:44:02.478" v="89" actId="20577"/>
          <ac:spMkLst>
            <pc:docMk/>
            <pc:sldMk cId="1840233059" sldId="257"/>
            <ac:spMk id="69" creationId="{E1C8FBC8-16F8-9571-A5FE-2FC0737E06AB}"/>
          </ac:spMkLst>
        </pc:spChg>
        <pc:spChg chg="mod">
          <ac:chgData name="板野 精之" userId="d14abaad31e2099c" providerId="LiveId" clId="{40984B5C-7FD1-469C-ABAC-6ED3F3D9C99B}" dt="2023-01-23T07:43:54.118" v="83" actId="20577"/>
          <ac:spMkLst>
            <pc:docMk/>
            <pc:sldMk cId="1840233059" sldId="257"/>
            <ac:spMk id="71" creationId="{B7A1B9C8-C862-1EDC-2370-45981E68C3D7}"/>
          </ac:spMkLst>
        </pc:spChg>
        <pc:spChg chg="mod">
          <ac:chgData name="板野 精之" userId="d14abaad31e2099c" providerId="LiveId" clId="{40984B5C-7FD1-469C-ABAC-6ED3F3D9C99B}" dt="2023-01-23T07:45:49.526" v="123" actId="1076"/>
          <ac:spMkLst>
            <pc:docMk/>
            <pc:sldMk cId="1840233059" sldId="257"/>
            <ac:spMk id="299" creationId="{86953137-9A11-CAE7-D8E0-5062E2E561F6}"/>
          </ac:spMkLst>
        </pc:spChg>
      </pc:sldChg>
      <pc:sldChg chg="modSp mod">
        <pc:chgData name="板野 精之" userId="d14abaad31e2099c" providerId="LiveId" clId="{40984B5C-7FD1-469C-ABAC-6ED3F3D9C99B}" dt="2023-01-23T23:54:00.815" v="180" actId="5736"/>
        <pc:sldMkLst>
          <pc:docMk/>
          <pc:sldMk cId="2089187721" sldId="258"/>
        </pc:sldMkLst>
        <pc:spChg chg="mod">
          <ac:chgData name="板野 精之" userId="d14abaad31e2099c" providerId="LiveId" clId="{40984B5C-7FD1-469C-ABAC-6ED3F3D9C99B}" dt="2023-01-23T23:54:00.815" v="180" actId="5736"/>
          <ac:spMkLst>
            <pc:docMk/>
            <pc:sldMk cId="2089187721" sldId="258"/>
            <ac:spMk id="5" creationId="{1D342F44-2B97-2DB3-88AC-C1C680222DD3}"/>
          </ac:spMkLst>
        </pc:spChg>
        <pc:graphicFrameChg chg="mod modGraphic">
          <ac:chgData name="板野 精之" userId="d14abaad31e2099c" providerId="LiveId" clId="{40984B5C-7FD1-469C-ABAC-6ED3F3D9C99B}" dt="2023-01-23T23:54:00.815" v="180" actId="5736"/>
          <ac:graphicFrameMkLst>
            <pc:docMk/>
            <pc:sldMk cId="2089187721" sldId="258"/>
            <ac:graphicFrameMk id="6" creationId="{647F7E30-80FD-4CFC-B3EA-6FA0814B7B06}"/>
          </ac:graphicFrameMkLst>
        </pc:graphicFrameChg>
      </pc:sldChg>
    </pc:docChg>
  </pc:docChgLst>
  <pc:docChgLst>
    <pc:chgData name="板野 精之" userId="16f987b9-9da5-480d-884b-590c15f73381" providerId="ADAL" clId="{5325BB64-3CD0-48EC-ADD7-0ACD791B3E35}"/>
    <pc:docChg chg="undo redo custSel addSld modSld">
      <pc:chgData name="板野 精之" userId="16f987b9-9da5-480d-884b-590c15f73381" providerId="ADAL" clId="{5325BB64-3CD0-48EC-ADD7-0ACD791B3E35}" dt="2022-09-16T01:27:47.309" v="2802" actId="6549"/>
      <pc:docMkLst>
        <pc:docMk/>
      </pc:docMkLst>
      <pc:sldChg chg="addSp delSp modSp mod">
        <pc:chgData name="板野 精之" userId="16f987b9-9da5-480d-884b-590c15f73381" providerId="ADAL" clId="{5325BB64-3CD0-48EC-ADD7-0ACD791B3E35}" dt="2022-09-16T01:27:47.309" v="2802" actId="6549"/>
        <pc:sldMkLst>
          <pc:docMk/>
          <pc:sldMk cId="2006302855" sldId="256"/>
        </pc:sldMkLst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" creationId="{DF5DE08D-2C10-7187-F3F4-8CCCD7B9DE47}"/>
          </ac:spMkLst>
        </pc:spChg>
        <pc:spChg chg="add mod">
          <ac:chgData name="板野 精之" userId="16f987b9-9da5-480d-884b-590c15f73381" providerId="ADAL" clId="{5325BB64-3CD0-48EC-ADD7-0ACD791B3E35}" dt="2022-09-16T01:27:47.309" v="2802" actId="6549"/>
          <ac:spMkLst>
            <pc:docMk/>
            <pc:sldMk cId="2006302855" sldId="256"/>
            <ac:spMk id="4" creationId="{9A61A6A7-9D44-173A-CE81-E8A2C380BA1F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5" creationId="{261682A1-65E3-3C27-942B-967B08F8D0DA}"/>
          </ac:spMkLst>
        </pc:spChg>
        <pc:spChg chg="add mod">
          <ac:chgData name="板野 精之" userId="16f987b9-9da5-480d-884b-590c15f73381" providerId="ADAL" clId="{5325BB64-3CD0-48EC-ADD7-0ACD791B3E35}" dt="2022-09-15T02:23:17.635" v="2435" actId="20577"/>
          <ac:spMkLst>
            <pc:docMk/>
            <pc:sldMk cId="2006302855" sldId="256"/>
            <ac:spMk id="6" creationId="{F10482DA-4034-A6C5-EF2C-5983A512CF48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7" creationId="{54CFF207-1693-EBA3-B840-F3F635A0897E}"/>
          </ac:spMkLst>
        </pc:spChg>
        <pc:spChg chg="add ord">
          <ac:chgData name="板野 精之" userId="16f987b9-9da5-480d-884b-590c15f73381" providerId="ADAL" clId="{5325BB64-3CD0-48EC-ADD7-0ACD791B3E35}" dt="2022-09-16T01:20:23.416" v="2623" actId="166"/>
          <ac:spMkLst>
            <pc:docMk/>
            <pc:sldMk cId="2006302855" sldId="256"/>
            <ac:spMk id="8" creationId="{665BF0CC-9744-2A4D-F325-D7210216AD98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9" creationId="{1A5B3472-D08A-9E8E-BF2A-9A9AF51438DA}"/>
          </ac:spMkLst>
        </pc:spChg>
        <pc:spChg chg="add mod">
          <ac:chgData name="板野 精之" userId="16f987b9-9da5-480d-884b-590c15f73381" providerId="ADAL" clId="{5325BB64-3CD0-48EC-ADD7-0ACD791B3E35}" dt="2022-09-09T03:12:32.750" v="1739" actId="1036"/>
          <ac:spMkLst>
            <pc:docMk/>
            <pc:sldMk cId="2006302855" sldId="256"/>
            <ac:spMk id="10" creationId="{F5752CD3-FDA7-B111-56D7-09676327FA7E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1" creationId="{84196AF8-409E-3F41-7220-34EB9F057776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" creationId="{7197534B-C8E8-3C34-12C4-1BAE2748DD0B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5" creationId="{312B6B05-97DC-7CCE-F981-C4BBC8C49002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7" creationId="{6DFCEFAD-9AD9-CCE8-E98B-49CD701C0DFD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9" creationId="{91304808-5A36-1FB3-FB7A-9E7BEEEBE3F5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24" creationId="{922809A6-06A0-5CD3-4AD4-3910CD658BBC}"/>
          </ac:spMkLst>
        </pc:spChg>
        <pc:spChg chg="add mod ord">
          <ac:chgData name="板野 精之" userId="16f987b9-9da5-480d-884b-590c15f73381" providerId="ADAL" clId="{5325BB64-3CD0-48EC-ADD7-0ACD791B3E35}" dt="2022-09-16T01:21:54.939" v="2662" actId="1035"/>
          <ac:spMkLst>
            <pc:docMk/>
            <pc:sldMk cId="2006302855" sldId="256"/>
            <ac:spMk id="25" creationId="{CD5B3E25-298B-211D-0F4B-5E318121E216}"/>
          </ac:spMkLst>
        </pc:spChg>
        <pc:spChg chg="del">
          <ac:chgData name="板野 精之" userId="16f987b9-9da5-480d-884b-590c15f73381" providerId="ADAL" clId="{5325BB64-3CD0-48EC-ADD7-0ACD791B3E35}" dt="2022-09-08T03:00:20.890" v="1031" actId="478"/>
          <ac:spMkLst>
            <pc:docMk/>
            <pc:sldMk cId="2006302855" sldId="256"/>
            <ac:spMk id="26" creationId="{00000000-0000-0000-0000-000000000000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27" creationId="{0FB3B172-A46A-BD32-379D-10A121FDCE80}"/>
          </ac:spMkLst>
        </pc:spChg>
        <pc:spChg chg="add del">
          <ac:chgData name="板野 精之" userId="16f987b9-9da5-480d-884b-590c15f73381" providerId="ADAL" clId="{5325BB64-3CD0-48EC-ADD7-0ACD791B3E35}" dt="2022-09-08T02:44:58.025" v="621" actId="478"/>
          <ac:spMkLst>
            <pc:docMk/>
            <pc:sldMk cId="2006302855" sldId="256"/>
            <ac:spMk id="29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3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7" creationId="{00000000-0000-0000-0000-000000000000}"/>
          </ac:spMkLst>
        </pc:spChg>
        <pc:spChg chg="add del 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3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48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49:08.294" v="699" actId="478"/>
          <ac:spMkLst>
            <pc:docMk/>
            <pc:sldMk cId="2006302855" sldId="256"/>
            <ac:spMk id="49" creationId="{00000000-0000-0000-0000-000000000000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50" creationId="{F8CDFC9D-4E3B-5328-CF6A-11243A12EBBD}"/>
          </ac:spMkLst>
        </pc:spChg>
        <pc:spChg chg="del mod">
          <ac:chgData name="板野 精之" userId="16f987b9-9da5-480d-884b-590c15f73381" providerId="ADAL" clId="{5325BB64-3CD0-48EC-ADD7-0ACD791B3E35}" dt="2022-09-08T02:49:20.570" v="701" actId="478"/>
          <ac:spMkLst>
            <pc:docMk/>
            <pc:sldMk cId="2006302855" sldId="256"/>
            <ac:spMk id="51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0:08.953" v="747" actId="478"/>
          <ac:spMkLst>
            <pc:docMk/>
            <pc:sldMk cId="2006302855" sldId="256"/>
            <ac:spMk id="53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6:43.465" v="647" actId="478"/>
          <ac:spMkLst>
            <pc:docMk/>
            <pc:sldMk cId="2006302855" sldId="256"/>
            <ac:spMk id="54" creationId="{9D4CC0A7-7154-C788-08F8-B5D7AF42EDAB}"/>
          </ac:spMkLst>
        </pc:spChg>
        <pc:spChg chg="del mod">
          <ac:chgData name="板野 精之" userId="16f987b9-9da5-480d-884b-590c15f73381" providerId="ADAL" clId="{5325BB64-3CD0-48EC-ADD7-0ACD791B3E35}" dt="2022-09-08T02:50:41.788" v="770" actId="478"/>
          <ac:spMkLst>
            <pc:docMk/>
            <pc:sldMk cId="2006302855" sldId="256"/>
            <ac:spMk id="55" creationId="{00000000-0000-0000-0000-000000000000}"/>
          </ac:spMkLst>
        </pc:spChg>
        <pc:spChg chg="add del mod topLvl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56" creationId="{4A99A513-2870-2C9E-3042-C5E737CD2011}"/>
          </ac:spMkLst>
        </pc:spChg>
        <pc:spChg chg="add del mod">
          <ac:chgData name="板野 精之" userId="16f987b9-9da5-480d-884b-590c15f73381" providerId="ADAL" clId="{5325BB64-3CD0-48EC-ADD7-0ACD791B3E35}" dt="2022-09-08T02:50:41.788" v="770" actId="478"/>
          <ac:spMkLst>
            <pc:docMk/>
            <pc:sldMk cId="2006302855" sldId="256"/>
            <ac:spMk id="57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1:00.718" v="774" actId="478"/>
          <ac:spMkLst>
            <pc:docMk/>
            <pc:sldMk cId="2006302855" sldId="256"/>
            <ac:spMk id="5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60" creationId="{4415A826-DA17-1E81-078C-882B726FD636}"/>
          </ac:spMkLst>
        </pc:spChg>
        <pc:spChg chg="del mod">
          <ac:chgData name="板野 精之" userId="16f987b9-9da5-480d-884b-590c15f73381" providerId="ADAL" clId="{5325BB64-3CD0-48EC-ADD7-0ACD791B3E35}" dt="2022-09-08T02:54:04.875" v="912" actId="478"/>
          <ac:spMkLst>
            <pc:docMk/>
            <pc:sldMk cId="2006302855" sldId="256"/>
            <ac:spMk id="6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62" creationId="{68B1E038-FA73-C01C-23C6-0673CECA1FD8}"/>
          </ac:spMkLst>
        </pc:spChg>
        <pc:spChg chg="del mod">
          <ac:chgData name="板野 精之" userId="16f987b9-9da5-480d-884b-590c15f73381" providerId="ADAL" clId="{5325BB64-3CD0-48EC-ADD7-0ACD791B3E35}" dt="2022-09-08T02:53:53.244" v="885" actId="478"/>
          <ac:spMkLst>
            <pc:docMk/>
            <pc:sldMk cId="2006302855" sldId="256"/>
            <ac:spMk id="6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64" creationId="{A245A53C-85AC-0258-8502-68EA87007AD9}"/>
          </ac:spMkLst>
        </pc:spChg>
        <pc:spChg chg="del mod">
          <ac:chgData name="板野 精之" userId="16f987b9-9da5-480d-884b-590c15f73381" providerId="ADAL" clId="{5325BB64-3CD0-48EC-ADD7-0ACD791B3E35}" dt="2022-09-08T02:53:50.928" v="884" actId="478"/>
          <ac:spMkLst>
            <pc:docMk/>
            <pc:sldMk cId="2006302855" sldId="256"/>
            <ac:spMk id="6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66" creationId="{BBE72BD2-C0AE-2DD9-A5CE-A6840898D8E7}"/>
          </ac:spMkLst>
        </pc:spChg>
        <pc:spChg chg="del mod">
          <ac:chgData name="板野 精之" userId="16f987b9-9da5-480d-884b-590c15f73381" providerId="ADAL" clId="{5325BB64-3CD0-48EC-ADD7-0ACD791B3E35}" dt="2022-09-08T02:53:26.761" v="838" actId="478"/>
          <ac:spMkLst>
            <pc:docMk/>
            <pc:sldMk cId="2006302855" sldId="256"/>
            <ac:spMk id="6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68" creationId="{8231A80A-BBFE-6BAD-4D91-91BA9D97C387}"/>
          </ac:spMkLst>
        </pc:spChg>
        <pc:spChg chg="del mod">
          <ac:chgData name="板野 精之" userId="16f987b9-9da5-480d-884b-590c15f73381" providerId="ADAL" clId="{5325BB64-3CD0-48EC-ADD7-0ACD791B3E35}" dt="2022-09-08T02:53:29.693" v="839" actId="478"/>
          <ac:spMkLst>
            <pc:docMk/>
            <pc:sldMk cId="2006302855" sldId="256"/>
            <ac:spMk id="6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70" creationId="{90AA1A3C-7F65-82BD-EF15-49B4ACED1197}"/>
          </ac:spMkLst>
        </pc:spChg>
        <pc:spChg chg="del mod">
          <ac:chgData name="板野 精之" userId="16f987b9-9da5-480d-884b-590c15f73381" providerId="ADAL" clId="{5325BB64-3CD0-48EC-ADD7-0ACD791B3E35}" dt="2022-09-08T02:52:07.361" v="787" actId="478"/>
          <ac:spMkLst>
            <pc:docMk/>
            <pc:sldMk cId="2006302855" sldId="256"/>
            <ac:spMk id="71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2:03.912" v="786" actId="478"/>
          <ac:spMkLst>
            <pc:docMk/>
            <pc:sldMk cId="2006302855" sldId="256"/>
            <ac:spMk id="72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8:51.649" v="955" actId="478"/>
          <ac:spMkLst>
            <pc:docMk/>
            <pc:sldMk cId="2006302855" sldId="256"/>
            <ac:spMk id="73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6:47.801" v="926" actId="478"/>
          <ac:spMkLst>
            <pc:docMk/>
            <pc:sldMk cId="2006302855" sldId="256"/>
            <ac:spMk id="74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8:54.634" v="956" actId="478"/>
          <ac:spMkLst>
            <pc:docMk/>
            <pc:sldMk cId="2006302855" sldId="256"/>
            <ac:spMk id="7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76" creationId="{E9987302-19FE-5AB3-F1E7-B8238316870F}"/>
          </ac:spMkLst>
        </pc:spChg>
        <pc:spChg chg="del mod">
          <ac:chgData name="板野 精之" userId="16f987b9-9da5-480d-884b-590c15f73381" providerId="ADAL" clId="{5325BB64-3CD0-48EC-ADD7-0ACD791B3E35}" dt="2022-09-08T02:58:58.489" v="957" actId="478"/>
          <ac:spMkLst>
            <pc:docMk/>
            <pc:sldMk cId="2006302855" sldId="256"/>
            <ac:spMk id="7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05.776" v="2671" actId="1035"/>
          <ac:spMkLst>
            <pc:docMk/>
            <pc:sldMk cId="2006302855" sldId="256"/>
            <ac:spMk id="78" creationId="{BF6FDDBA-4AA6-11A2-7F4C-F8B3175C40E0}"/>
          </ac:spMkLst>
        </pc:spChg>
        <pc:spChg chg="del mod">
          <ac:chgData name="板野 精之" userId="16f987b9-9da5-480d-884b-590c15f73381" providerId="ADAL" clId="{5325BB64-3CD0-48EC-ADD7-0ACD791B3E35}" dt="2022-09-08T02:59:14.978" v="991" actId="478"/>
          <ac:spMkLst>
            <pc:docMk/>
            <pc:sldMk cId="2006302855" sldId="256"/>
            <ac:spMk id="79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9:25.314" v="1009" actId="478"/>
          <ac:spMkLst>
            <pc:docMk/>
            <pc:sldMk cId="2006302855" sldId="256"/>
            <ac:spMk id="81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9:33.634" v="1024" actId="478"/>
          <ac:spMkLst>
            <pc:docMk/>
            <pc:sldMk cId="2006302855" sldId="256"/>
            <ac:spMk id="83" creationId="{00000000-0000-0000-0000-000000000000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84" creationId="{E74E5502-4EC1-F401-242B-FDD67FE43AFD}"/>
          </ac:spMkLst>
        </pc:spChg>
        <pc:spChg chg="del mod">
          <ac:chgData name="板野 精之" userId="16f987b9-9da5-480d-884b-590c15f73381" providerId="ADAL" clId="{5325BB64-3CD0-48EC-ADD7-0ACD791B3E35}" dt="2022-09-08T02:54:36.412" v="923" actId="478"/>
          <ac:spMkLst>
            <pc:docMk/>
            <pc:sldMk cId="2006302855" sldId="256"/>
            <ac:spMk id="92" creationId="{525B4E57-CB76-21E0-7E84-6DB6104A7AD2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93" creationId="{949AE8E2-9782-456F-20C9-D17E9FDEAC42}"/>
          </ac:spMkLst>
        </pc:spChg>
        <pc:spChg chg="del mod">
          <ac:chgData name="板野 精之" userId="16f987b9-9da5-480d-884b-590c15f73381" providerId="ADAL" clId="{5325BB64-3CD0-48EC-ADD7-0ACD791B3E35}" dt="2022-09-08T02:54:34.586" v="922" actId="478"/>
          <ac:spMkLst>
            <pc:docMk/>
            <pc:sldMk cId="2006302855" sldId="256"/>
            <ac:spMk id="94" creationId="{029DE854-DC12-6C35-073C-60FCCC3C120B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95" creationId="{F6ED617E-118F-24B9-2629-92BFD171A0E7}"/>
          </ac:spMkLst>
        </pc:spChg>
        <pc:spChg chg="add del">
          <ac:chgData name="板野 精之" userId="16f987b9-9da5-480d-884b-590c15f73381" providerId="ADAL" clId="{5325BB64-3CD0-48EC-ADD7-0ACD791B3E35}" dt="2022-09-08T02:44:58.025" v="621" actId="478"/>
          <ac:spMkLst>
            <pc:docMk/>
            <pc:sldMk cId="2006302855" sldId="256"/>
            <ac:spMk id="96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97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98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99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100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101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102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45:29.355" v="626" actId="478"/>
          <ac:spMkLst>
            <pc:docMk/>
            <pc:sldMk cId="2006302855" sldId="256"/>
            <ac:spMk id="103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15T02:18:27.669" v="2367" actId="478"/>
          <ac:spMkLst>
            <pc:docMk/>
            <pc:sldMk cId="2006302855" sldId="256"/>
            <ac:spMk id="104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54:33.107" v="921" actId="478"/>
          <ac:spMkLst>
            <pc:docMk/>
            <pc:sldMk cId="2006302855" sldId="256"/>
            <ac:spMk id="105" creationId="{A2F14E47-D4A9-AACD-E36E-A7FDA0B59E0F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06" creationId="{8A750E44-B705-1CDF-CEDC-A2E20E5CFA68}"/>
          </ac:spMkLst>
        </pc:spChg>
        <pc:spChg chg="del mod">
          <ac:chgData name="板野 精之" userId="16f987b9-9da5-480d-884b-590c15f73381" providerId="ADAL" clId="{5325BB64-3CD0-48EC-ADD7-0ACD791B3E35}" dt="2022-09-08T02:54:23.049" v="915" actId="478"/>
          <ac:spMkLst>
            <pc:docMk/>
            <pc:sldMk cId="2006302855" sldId="256"/>
            <ac:spMk id="107" creationId="{B4A87050-B943-770B-014C-D4B7D1A54B97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08" creationId="{4C2CD8AD-0631-8CDA-C8E5-77FA10607138}"/>
          </ac:spMkLst>
        </pc:spChg>
        <pc:spChg chg="del mod">
          <ac:chgData name="板野 精之" userId="16f987b9-9da5-480d-884b-590c15f73381" providerId="ADAL" clId="{5325BB64-3CD0-48EC-ADD7-0ACD791B3E35}" dt="2022-09-08T02:54:27.842" v="918" actId="478"/>
          <ac:spMkLst>
            <pc:docMk/>
            <pc:sldMk cId="2006302855" sldId="256"/>
            <ac:spMk id="109" creationId="{4B125FAF-E691-63AE-E576-3088F926971B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10" creationId="{B0976ED5-039C-4A9C-CCE9-88AA8C82B191}"/>
          </ac:spMkLst>
        </pc:spChg>
        <pc:spChg chg="del mod">
          <ac:chgData name="板野 精之" userId="16f987b9-9da5-480d-884b-590c15f73381" providerId="ADAL" clId="{5325BB64-3CD0-48EC-ADD7-0ACD791B3E35}" dt="2022-09-08T02:54:20.472" v="914" actId="478"/>
          <ac:spMkLst>
            <pc:docMk/>
            <pc:sldMk cId="2006302855" sldId="256"/>
            <ac:spMk id="111" creationId="{559B65F2-9CDC-1499-C9C3-94F188CC2938}"/>
          </ac:spMkLst>
        </pc:spChg>
        <pc:spChg chg="mod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12" creationId="{002ACE40-ED01-8168-DEF6-31301D72B6E1}"/>
          </ac:spMkLst>
        </pc:spChg>
        <pc:spChg chg="del mod topLvl">
          <ac:chgData name="板野 精之" userId="16f987b9-9da5-480d-884b-590c15f73381" providerId="ADAL" clId="{5325BB64-3CD0-48EC-ADD7-0ACD791B3E35}" dt="2022-09-08T02:53:17.435" v="822" actId="478"/>
          <ac:spMkLst>
            <pc:docMk/>
            <pc:sldMk cId="2006302855" sldId="256"/>
            <ac:spMk id="120" creationId="{2E6CB1C8-0057-F86E-AE94-23BC4436F1DD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21" creationId="{5D940463-A728-2B88-FC86-8E47ED7DF4CE}"/>
          </ac:spMkLst>
        </pc:spChg>
        <pc:spChg chg="del mod topLvl">
          <ac:chgData name="板野 精之" userId="16f987b9-9da5-480d-884b-590c15f73381" providerId="ADAL" clId="{5325BB64-3CD0-48EC-ADD7-0ACD791B3E35}" dt="2022-09-08T02:53:14.611" v="821" actId="478"/>
          <ac:spMkLst>
            <pc:docMk/>
            <pc:sldMk cId="2006302855" sldId="256"/>
            <ac:spMk id="122" creationId="{55887660-41EC-DAF3-084D-E8CA2A8EC815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23" creationId="{4230F059-FAB2-0ABD-451D-674BF7D952E1}"/>
          </ac:spMkLst>
        </pc:spChg>
        <pc:spChg chg="del mod topLvl">
          <ac:chgData name="板野 精之" userId="16f987b9-9da5-480d-884b-590c15f73381" providerId="ADAL" clId="{5325BB64-3CD0-48EC-ADD7-0ACD791B3E35}" dt="2022-09-08T02:53:12.986" v="820" actId="478"/>
          <ac:spMkLst>
            <pc:docMk/>
            <pc:sldMk cId="2006302855" sldId="256"/>
            <ac:spMk id="124" creationId="{4F1C6D11-6000-43E4-DF85-D78D1E2CBB01}"/>
          </ac:spMkLst>
        </pc:spChg>
        <pc:spChg chg="del mod">
          <ac:chgData name="板野 精之" userId="16f987b9-9da5-480d-884b-590c15f73381" providerId="ADAL" clId="{5325BB64-3CD0-48EC-ADD7-0ACD791B3E35}" dt="2022-09-08T03:00:17.803" v="1030" actId="478"/>
          <ac:spMkLst>
            <pc:docMk/>
            <pc:sldMk cId="2006302855" sldId="256"/>
            <ac:spMk id="125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26" creationId="{1A6BA960-9429-0079-D10B-87366CE237D0}"/>
          </ac:spMkLst>
        </pc:spChg>
        <pc:spChg chg="del mod topLvl">
          <ac:chgData name="板野 精之" userId="16f987b9-9da5-480d-884b-590c15f73381" providerId="ADAL" clId="{5325BB64-3CD0-48EC-ADD7-0ACD791B3E35}" dt="2022-09-08T02:53:11.196" v="819" actId="478"/>
          <ac:spMkLst>
            <pc:docMk/>
            <pc:sldMk cId="2006302855" sldId="256"/>
            <ac:spMk id="127" creationId="{A77EAB4F-5C83-BD43-9442-857981EAA52B}"/>
          </ac:spMkLst>
        </pc:spChg>
        <pc:spChg chg="add del">
          <ac:chgData name="板野 精之" userId="16f987b9-9da5-480d-884b-590c15f73381" providerId="ADAL" clId="{5325BB64-3CD0-48EC-ADD7-0ACD791B3E35}" dt="2022-09-08T02:44:58.025" v="621" actId="478"/>
          <ac:spMkLst>
            <pc:docMk/>
            <pc:sldMk cId="2006302855" sldId="256"/>
            <ac:spMk id="128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2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3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0" creationId="{00000000-0000-0000-0000-000000000000}"/>
          </ac:spMkLst>
        </pc:spChg>
        <pc:spChg chg="add del 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147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04:17.859" v="1122" actId="478"/>
          <ac:spMkLst>
            <pc:docMk/>
            <pc:sldMk cId="2006302855" sldId="256"/>
            <ac:spMk id="148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49" creationId="{150BF04B-EB7C-EE7F-F582-8A429DC61816}"/>
          </ac:spMkLst>
        </pc:spChg>
        <pc:spChg chg="del mod">
          <ac:chgData name="板野 精之" userId="16f987b9-9da5-480d-884b-590c15f73381" providerId="ADAL" clId="{5325BB64-3CD0-48EC-ADD7-0ACD791B3E35}" dt="2022-09-08T03:04:19.114" v="1123" actId="478"/>
          <ac:spMkLst>
            <pc:docMk/>
            <pc:sldMk cId="2006302855" sldId="256"/>
            <ac:spMk id="150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3:07.092" v="817" actId="478"/>
          <ac:spMkLst>
            <pc:docMk/>
            <pc:sldMk cId="2006302855" sldId="256"/>
            <ac:spMk id="151" creationId="{51BD7CB8-7F0A-2BA6-974B-3204C16047DE}"/>
          </ac:spMkLst>
        </pc:spChg>
        <pc:spChg chg="del mod">
          <ac:chgData name="板野 精之" userId="16f987b9-9da5-480d-884b-590c15f73381" providerId="ADAL" clId="{5325BB64-3CD0-48EC-ADD7-0ACD791B3E35}" dt="2022-09-08T03:04:20.635" v="1124" actId="478"/>
          <ac:spMkLst>
            <pc:docMk/>
            <pc:sldMk cId="2006302855" sldId="256"/>
            <ac:spMk id="152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53" creationId="{7DD7A3D9-8961-4A0D-5349-0FF7FEBE9FC9}"/>
          </ac:spMkLst>
        </pc:spChg>
        <pc:spChg chg="del mod">
          <ac:chgData name="板野 精之" userId="16f987b9-9da5-480d-884b-590c15f73381" providerId="ADAL" clId="{5325BB64-3CD0-48EC-ADD7-0ACD791B3E35}" dt="2022-09-08T03:04:21.323" v="1125" actId="478"/>
          <ac:spMkLst>
            <pc:docMk/>
            <pc:sldMk cId="2006302855" sldId="256"/>
            <ac:spMk id="154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3:08.516" v="818" actId="478"/>
          <ac:spMkLst>
            <pc:docMk/>
            <pc:sldMk cId="2006302855" sldId="256"/>
            <ac:spMk id="155" creationId="{36B44D60-FAA0-FAD3-E028-F523C224159F}"/>
          </ac:spMkLst>
        </pc:spChg>
        <pc:spChg chg="del mod">
          <ac:chgData name="板野 精之" userId="16f987b9-9da5-480d-884b-590c15f73381" providerId="ADAL" clId="{5325BB64-3CD0-48EC-ADD7-0ACD791B3E35}" dt="2022-09-08T03:04:22.523" v="1126" actId="478"/>
          <ac:spMkLst>
            <pc:docMk/>
            <pc:sldMk cId="2006302855" sldId="256"/>
            <ac:spMk id="156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57" creationId="{0380351B-3BF2-172E-500A-B3ADF6C3CEE5}"/>
          </ac:spMkLst>
        </pc:spChg>
        <pc:spChg chg="del mod">
          <ac:chgData name="板野 精之" userId="16f987b9-9da5-480d-884b-590c15f73381" providerId="ADAL" clId="{5325BB64-3CD0-48EC-ADD7-0ACD791B3E35}" dt="2022-09-08T03:04:23.613" v="1127" actId="478"/>
          <ac:spMkLst>
            <pc:docMk/>
            <pc:sldMk cId="2006302855" sldId="256"/>
            <ac:spMk id="158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06:44.539" v="1225" actId="478"/>
          <ac:spMkLst>
            <pc:docMk/>
            <pc:sldMk cId="2006302855" sldId="256"/>
            <ac:spMk id="160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9:49.043" v="1026" actId="478"/>
          <ac:spMkLst>
            <pc:docMk/>
            <pc:sldMk cId="2006302855" sldId="256"/>
            <ac:spMk id="161" creationId="{ED3A5F05-4958-47F7-A974-3923A374FACF}"/>
          </ac:spMkLst>
        </pc:spChg>
        <pc:spChg chg="del mod">
          <ac:chgData name="板野 精之" userId="16f987b9-9da5-480d-884b-590c15f73381" providerId="ADAL" clId="{5325BB64-3CD0-48EC-ADD7-0ACD791B3E35}" dt="2022-09-08T03:06:46.314" v="1226" actId="478"/>
          <ac:spMkLst>
            <pc:docMk/>
            <pc:sldMk cId="2006302855" sldId="256"/>
            <ac:spMk id="162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63" creationId="{E8E9BE25-569C-4104-42FD-658889FF0C59}"/>
          </ac:spMkLst>
        </pc:spChg>
        <pc:spChg chg="del mod">
          <ac:chgData name="板野 精之" userId="16f987b9-9da5-480d-884b-590c15f73381" providerId="ADAL" clId="{5325BB64-3CD0-48EC-ADD7-0ACD791B3E35}" dt="2022-09-08T03:06:47.506" v="1227" actId="478"/>
          <ac:spMkLst>
            <pc:docMk/>
            <pc:sldMk cId="2006302855" sldId="256"/>
            <ac:spMk id="164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06:48.674" v="1228" actId="478"/>
          <ac:spMkLst>
            <pc:docMk/>
            <pc:sldMk cId="2006302855" sldId="256"/>
            <ac:spMk id="166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9:49.043" v="1026" actId="478"/>
          <ac:spMkLst>
            <pc:docMk/>
            <pc:sldMk cId="2006302855" sldId="256"/>
            <ac:spMk id="167" creationId="{3502E9EF-9EB4-5B95-CD6B-A3496D4CD01D}"/>
          </ac:spMkLst>
        </pc:spChg>
        <pc:spChg chg="del mod">
          <ac:chgData name="板野 精之" userId="16f987b9-9da5-480d-884b-590c15f73381" providerId="ADAL" clId="{5325BB64-3CD0-48EC-ADD7-0ACD791B3E35}" dt="2022-09-08T03:06:50.035" v="1229" actId="478"/>
          <ac:spMkLst>
            <pc:docMk/>
            <pc:sldMk cId="2006302855" sldId="256"/>
            <ac:spMk id="168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69" creationId="{A63F23F2-5976-F83E-CEF8-35BDF223B2D5}"/>
          </ac:spMkLst>
        </pc:spChg>
        <pc:spChg chg="del mod">
          <ac:chgData name="板野 精之" userId="16f987b9-9da5-480d-884b-590c15f73381" providerId="ADAL" clId="{5325BB64-3CD0-48EC-ADD7-0ACD791B3E35}" dt="2022-09-08T03:06:51.675" v="1230" actId="478"/>
          <ac:spMkLst>
            <pc:docMk/>
            <pc:sldMk cId="2006302855" sldId="256"/>
            <ac:spMk id="170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09:58.554" v="1339" actId="478"/>
          <ac:spMkLst>
            <pc:docMk/>
            <pc:sldMk cId="2006302855" sldId="256"/>
            <ac:spMk id="172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9:49.043" v="1026" actId="478"/>
          <ac:spMkLst>
            <pc:docMk/>
            <pc:sldMk cId="2006302855" sldId="256"/>
            <ac:spMk id="173" creationId="{B2E7E5D3-9BDC-7469-16CD-EA6301FD1980}"/>
          </ac:spMkLst>
        </pc:spChg>
        <pc:spChg chg="del mod">
          <ac:chgData name="板野 精之" userId="16f987b9-9da5-480d-884b-590c15f73381" providerId="ADAL" clId="{5325BB64-3CD0-48EC-ADD7-0ACD791B3E35}" dt="2022-09-08T03:09:42.737" v="1321" actId="478"/>
          <ac:spMkLst>
            <pc:docMk/>
            <pc:sldMk cId="2006302855" sldId="256"/>
            <ac:spMk id="174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75" creationId="{B32E9932-705A-B27D-2DF5-ED678011064F}"/>
          </ac:spMkLst>
        </pc:spChg>
        <pc:spChg chg="del mod">
          <ac:chgData name="板野 精之" userId="16f987b9-9da5-480d-884b-590c15f73381" providerId="ADAL" clId="{5325BB64-3CD0-48EC-ADD7-0ACD791B3E35}" dt="2022-09-08T03:10:15.074" v="1364" actId="478"/>
          <ac:spMkLst>
            <pc:docMk/>
            <pc:sldMk cId="2006302855" sldId="256"/>
            <ac:spMk id="176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0:51.594" v="1402" actId="478"/>
          <ac:spMkLst>
            <pc:docMk/>
            <pc:sldMk cId="2006302855" sldId="256"/>
            <ac:spMk id="178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9:49.043" v="1026" actId="478"/>
          <ac:spMkLst>
            <pc:docMk/>
            <pc:sldMk cId="2006302855" sldId="256"/>
            <ac:spMk id="179" creationId="{5C60E508-B409-A301-F6C1-E50DBA71183C}"/>
          </ac:spMkLst>
        </pc:spChg>
        <pc:spChg chg="del mod">
          <ac:chgData name="板野 精之" userId="16f987b9-9da5-480d-884b-590c15f73381" providerId="ADAL" clId="{5325BB64-3CD0-48EC-ADD7-0ACD791B3E35}" dt="2022-09-08T03:11:48.138" v="1416" actId="478"/>
          <ac:spMkLst>
            <pc:docMk/>
            <pc:sldMk cId="2006302855" sldId="256"/>
            <ac:spMk id="180" creationId="{00000000-0000-0000-0000-000000000000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81" creationId="{AC4B1ECB-6DA4-BC96-72AC-50E0994BDFB4}"/>
          </ac:spMkLst>
        </pc:spChg>
        <pc:spChg chg="del mod">
          <ac:chgData name="板野 精之" userId="16f987b9-9da5-480d-884b-590c15f73381" providerId="ADAL" clId="{5325BB64-3CD0-48EC-ADD7-0ACD791B3E35}" dt="2022-09-08T03:11:49.435" v="1417" actId="478"/>
          <ac:spMkLst>
            <pc:docMk/>
            <pc:sldMk cId="2006302855" sldId="256"/>
            <ac:spMk id="182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2:59:49.043" v="1026" actId="478"/>
          <ac:spMkLst>
            <pc:docMk/>
            <pc:sldMk cId="2006302855" sldId="256"/>
            <ac:spMk id="184" creationId="{9B202B37-4D85-D044-09F5-DC9DE25999E4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85" creationId="{1B69EA43-8E2A-5CF2-8D7B-71E803C9F27A}"/>
          </ac:spMkLst>
        </pc:spChg>
        <pc:spChg chg="del mod topLvl">
          <ac:chgData name="板野 精之" userId="16f987b9-9da5-480d-884b-590c15f73381" providerId="ADAL" clId="{5325BB64-3CD0-48EC-ADD7-0ACD791B3E35}" dt="2022-09-08T02:59:49.043" v="1026" actId="478"/>
          <ac:spMkLst>
            <pc:docMk/>
            <pc:sldMk cId="2006302855" sldId="256"/>
            <ac:spMk id="187" creationId="{930F2DBA-FEF7-DAF7-706E-C5912B77B485}"/>
          </ac:spMkLst>
        </pc:spChg>
        <pc:spChg chg="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188" creationId="{18D521D3-3F24-D9E0-0CDF-22C22D3F9D8B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89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0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1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2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3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4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5" creationId="{00000000-0000-0000-0000-000000000000}"/>
          </ac:spMkLst>
        </pc:spChg>
        <pc:spChg chg="add del">
          <ac:chgData name="板野 精之" userId="16f987b9-9da5-480d-884b-590c15f73381" providerId="ADAL" clId="{5325BB64-3CD0-48EC-ADD7-0ACD791B3E35}" dt="2022-09-08T02:44:57.233" v="620" actId="478"/>
          <ac:spMkLst>
            <pc:docMk/>
            <pc:sldMk cId="2006302855" sldId="256"/>
            <ac:spMk id="196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15T02:18:29.404" v="2368" actId="478"/>
          <ac:spMkLst>
            <pc:docMk/>
            <pc:sldMk cId="2006302855" sldId="256"/>
            <ac:spMk id="197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08T03:07:46.187" v="1272" actId="478"/>
          <ac:spMkLst>
            <pc:docMk/>
            <pc:sldMk cId="2006302855" sldId="256"/>
            <ac:spMk id="205" creationId="{855C9DE8-4A45-6448-FB18-3353C223E344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06" creationId="{940CF3C7-7C32-E07C-4F5B-950C04B9878F}"/>
          </ac:spMkLst>
        </pc:spChg>
        <pc:spChg chg="del mod topLvl">
          <ac:chgData name="板野 精之" userId="16f987b9-9da5-480d-884b-590c15f73381" providerId="ADAL" clId="{5325BB64-3CD0-48EC-ADD7-0ACD791B3E35}" dt="2022-09-08T03:07:45.587" v="1271" actId="478"/>
          <ac:spMkLst>
            <pc:docMk/>
            <pc:sldMk cId="2006302855" sldId="256"/>
            <ac:spMk id="207" creationId="{067FA46E-1C42-E05C-451E-DBA0277C546A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08" creationId="{A8B60085-3584-152B-8041-A64EE589F56E}"/>
          </ac:spMkLst>
        </pc:spChg>
        <pc:spChg chg="del mod topLvl">
          <ac:chgData name="板野 精之" userId="16f987b9-9da5-480d-884b-590c15f73381" providerId="ADAL" clId="{5325BB64-3CD0-48EC-ADD7-0ACD791B3E35}" dt="2022-09-08T03:07:44.907" v="1270" actId="478"/>
          <ac:spMkLst>
            <pc:docMk/>
            <pc:sldMk cId="2006302855" sldId="256"/>
            <ac:spMk id="209" creationId="{4C13E39D-6EF7-D7DB-CD72-F97D8A9198E3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10" creationId="{2B49559C-9944-BDA2-76B6-2FEF3AA48613}"/>
          </ac:spMkLst>
        </pc:spChg>
        <pc:spChg chg="del mod topLvl">
          <ac:chgData name="板野 精之" userId="16f987b9-9da5-480d-884b-590c15f73381" providerId="ADAL" clId="{5325BB64-3CD0-48EC-ADD7-0ACD791B3E35}" dt="2022-09-08T03:07:44.347" v="1269" actId="478"/>
          <ac:spMkLst>
            <pc:docMk/>
            <pc:sldMk cId="2006302855" sldId="256"/>
            <ac:spMk id="211" creationId="{7FC083B3-83B6-30FC-A8C2-857C6D3B327F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12" creationId="{466AC667-DAF4-B9A3-F58A-8906204DA6E8}"/>
          </ac:spMkLst>
        </pc:spChg>
        <pc:spChg chg="del mod topLvl">
          <ac:chgData name="板野 精之" userId="16f987b9-9da5-480d-884b-590c15f73381" providerId="ADAL" clId="{5325BB64-3CD0-48EC-ADD7-0ACD791B3E35}" dt="2022-09-08T03:07:43.754" v="1268" actId="478"/>
          <ac:spMkLst>
            <pc:docMk/>
            <pc:sldMk cId="2006302855" sldId="256"/>
            <ac:spMk id="213" creationId="{01404E64-646E-F818-FE06-4ACB533BE032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14" creationId="{4BD090C1-51D9-0438-15AD-C8D609364016}"/>
          </ac:spMkLst>
        </pc:spChg>
        <pc:spChg chg="del mod topLvl">
          <ac:chgData name="板野 精之" userId="16f987b9-9da5-480d-884b-590c15f73381" providerId="ADAL" clId="{5325BB64-3CD0-48EC-ADD7-0ACD791B3E35}" dt="2022-09-08T03:07:42.811" v="1267" actId="478"/>
          <ac:spMkLst>
            <pc:docMk/>
            <pc:sldMk cId="2006302855" sldId="256"/>
            <ac:spMk id="215" creationId="{64583DAC-0711-E3F7-D0AB-CEB76DFA867F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16" creationId="{9E0F1E04-7C68-E52A-70E4-DB2F60EA6024}"/>
          </ac:spMkLst>
        </pc:spChg>
        <pc:spChg chg="del mod topLvl">
          <ac:chgData name="板野 精之" userId="16f987b9-9da5-480d-884b-590c15f73381" providerId="ADAL" clId="{5325BB64-3CD0-48EC-ADD7-0ACD791B3E35}" dt="2022-09-08T03:05:28.556" v="1194" actId="478"/>
          <ac:spMkLst>
            <pc:docMk/>
            <pc:sldMk cId="2006302855" sldId="256"/>
            <ac:spMk id="218" creationId="{D94DB03E-1D95-BE93-3F71-F51A878180B0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19" creationId="{2073E597-FBE7-0F24-FC4D-4DDE5EEF386C}"/>
          </ac:spMkLst>
        </pc:spChg>
        <pc:spChg chg="del mod topLvl">
          <ac:chgData name="板野 精之" userId="16f987b9-9da5-480d-884b-590c15f73381" providerId="ADAL" clId="{5325BB64-3CD0-48EC-ADD7-0ACD791B3E35}" dt="2022-09-08T03:05:27.508" v="1193" actId="478"/>
          <ac:spMkLst>
            <pc:docMk/>
            <pc:sldMk cId="2006302855" sldId="256"/>
            <ac:spMk id="221" creationId="{1E7AD3C1-5349-9CCE-240B-4F94B5FA042C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22" creationId="{7BE23562-F486-9D99-A795-EA3632469665}"/>
          </ac:spMkLst>
        </pc:spChg>
        <pc:spChg chg="del mod topLvl">
          <ac:chgData name="板野 精之" userId="16f987b9-9da5-480d-884b-590c15f73381" providerId="ADAL" clId="{5325BB64-3CD0-48EC-ADD7-0ACD791B3E35}" dt="2022-09-08T03:05:26.835" v="1192" actId="478"/>
          <ac:spMkLst>
            <pc:docMk/>
            <pc:sldMk cId="2006302855" sldId="256"/>
            <ac:spMk id="224" creationId="{D530D187-3AEC-ED9C-C517-2A9747B8C074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25" creationId="{EFB36824-6F9C-ADA9-7384-D95BD7270D4B}"/>
          </ac:spMkLst>
        </pc:spChg>
        <pc:spChg chg="del mod topLvl">
          <ac:chgData name="板野 精之" userId="16f987b9-9da5-480d-884b-590c15f73381" providerId="ADAL" clId="{5325BB64-3CD0-48EC-ADD7-0ACD791B3E35}" dt="2022-09-08T03:05:26.035" v="1191" actId="478"/>
          <ac:spMkLst>
            <pc:docMk/>
            <pc:sldMk cId="2006302855" sldId="256"/>
            <ac:spMk id="227" creationId="{D50BF5A9-A096-B7AD-F65E-873999B0832B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28" creationId="{DF271C03-EEFD-7206-5BF4-CEEDDB26ECBB}"/>
          </ac:spMkLst>
        </pc:spChg>
        <pc:spChg chg="del mod topLvl">
          <ac:chgData name="板野 精之" userId="16f987b9-9da5-480d-884b-590c15f73381" providerId="ADAL" clId="{5325BB64-3CD0-48EC-ADD7-0ACD791B3E35}" dt="2022-09-08T03:05:25.305" v="1190" actId="478"/>
          <ac:spMkLst>
            <pc:docMk/>
            <pc:sldMk cId="2006302855" sldId="256"/>
            <ac:spMk id="230" creationId="{75032558-FEE3-4DCE-294F-7F0A35540590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31" creationId="{322DB717-2025-BF96-D5FC-2C80337C0EAB}"/>
          </ac:spMkLst>
        </pc:spChg>
        <pc:spChg chg="del mod topLvl">
          <ac:chgData name="板野 精之" userId="16f987b9-9da5-480d-884b-590c15f73381" providerId="ADAL" clId="{5325BB64-3CD0-48EC-ADD7-0ACD791B3E35}" dt="2022-09-08T03:05:24.218" v="1189" actId="478"/>
          <ac:spMkLst>
            <pc:docMk/>
            <pc:sldMk cId="2006302855" sldId="256"/>
            <ac:spMk id="233" creationId="{CBAC40EA-4839-3BCA-DB91-84EE36390487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34" creationId="{6D14BDE7-FD74-73AA-C026-ECD3CEB03183}"/>
          </ac:spMkLst>
        </pc:spChg>
        <pc:spChg chg="del mod topLvl">
          <ac:chgData name="板野 精之" userId="16f987b9-9da5-480d-884b-590c15f73381" providerId="ADAL" clId="{5325BB64-3CD0-48EC-ADD7-0ACD791B3E35}" dt="2022-09-08T03:05:05.874" v="1187" actId="478"/>
          <ac:spMkLst>
            <pc:docMk/>
            <pc:sldMk cId="2006302855" sldId="256"/>
            <ac:spMk id="236" creationId="{C6A9AFB0-11DF-40A7-DB05-ECD2DE66C3FF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37" creationId="{857D3637-8DC8-BB7C-DFD9-BB7B25A3B707}"/>
          </ac:spMkLst>
        </pc:spChg>
        <pc:spChg chg="del mod topLvl">
          <ac:chgData name="板野 精之" userId="16f987b9-9da5-480d-884b-590c15f73381" providerId="ADAL" clId="{5325BB64-3CD0-48EC-ADD7-0ACD791B3E35}" dt="2022-09-08T03:03:23.370" v="1110" actId="478"/>
          <ac:spMkLst>
            <pc:docMk/>
            <pc:sldMk cId="2006302855" sldId="256"/>
            <ac:spMk id="239" creationId="{23D3318F-6702-4CE3-75AC-FF7626189156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40" creationId="{208BA281-3C2E-C599-0144-8A01B06B6912}"/>
          </ac:spMkLst>
        </pc:spChg>
        <pc:spChg chg="del mod topLvl">
          <ac:chgData name="板野 精之" userId="16f987b9-9da5-480d-884b-590c15f73381" providerId="ADAL" clId="{5325BB64-3CD0-48EC-ADD7-0ACD791B3E35}" dt="2022-09-08T03:03:16.002" v="1106" actId="478"/>
          <ac:spMkLst>
            <pc:docMk/>
            <pc:sldMk cId="2006302855" sldId="256"/>
            <ac:spMk id="242" creationId="{684B91CE-7177-6332-A595-554B3CB21FD7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43" creationId="{AB1F5712-27DA-D17B-80D5-A99BD5538727}"/>
          </ac:spMkLst>
        </pc:spChg>
        <pc:spChg chg="del mod topLvl">
          <ac:chgData name="板野 精之" userId="16f987b9-9da5-480d-884b-590c15f73381" providerId="ADAL" clId="{5325BB64-3CD0-48EC-ADD7-0ACD791B3E35}" dt="2022-09-08T03:03:18.179" v="1107" actId="478"/>
          <ac:spMkLst>
            <pc:docMk/>
            <pc:sldMk cId="2006302855" sldId="256"/>
            <ac:spMk id="245" creationId="{B5D21D6C-0618-2186-85FB-0051CD14DAC6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46" creationId="{BA103975-9E4E-1214-FD44-D7A960DC5A3D}"/>
          </ac:spMkLst>
        </pc:spChg>
        <pc:spChg chg="del mod topLvl">
          <ac:chgData name="板野 精之" userId="16f987b9-9da5-480d-884b-590c15f73381" providerId="ADAL" clId="{5325BB64-3CD0-48EC-ADD7-0ACD791B3E35}" dt="2022-09-08T03:03:19.098" v="1108" actId="478"/>
          <ac:spMkLst>
            <pc:docMk/>
            <pc:sldMk cId="2006302855" sldId="256"/>
            <ac:spMk id="248" creationId="{D308C215-4BEE-2610-18B6-31003EEBAA2B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49" creationId="{BA946725-5406-BA52-745D-CCF276B9BDDA}"/>
          </ac:spMkLst>
        </pc:spChg>
        <pc:spChg chg="del mod topLvl">
          <ac:chgData name="板野 精之" userId="16f987b9-9da5-480d-884b-590c15f73381" providerId="ADAL" clId="{5325BB64-3CD0-48EC-ADD7-0ACD791B3E35}" dt="2022-09-08T03:03:19.603" v="1109" actId="478"/>
          <ac:spMkLst>
            <pc:docMk/>
            <pc:sldMk cId="2006302855" sldId="256"/>
            <ac:spMk id="251" creationId="{B7851D1C-F56D-5A0D-13E5-887FEFABB8D5}"/>
          </ac:spMkLst>
        </pc:spChg>
        <pc:spChg chg="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52" creationId="{7ADDF1AC-063A-C9A6-76EC-D38B79D9FB0C}"/>
          </ac:spMkLst>
        </pc:spChg>
        <pc:spChg chg="add del mod">
          <ac:chgData name="板野 精之" userId="16f987b9-9da5-480d-884b-590c15f73381" providerId="ADAL" clId="{5325BB64-3CD0-48EC-ADD7-0ACD791B3E35}" dt="2022-09-08T03:12:56.626" v="1430" actId="478"/>
          <ac:spMkLst>
            <pc:docMk/>
            <pc:sldMk cId="2006302855" sldId="256"/>
            <ac:spMk id="253" creationId="{3F9BAEB3-0694-E744-2DE0-892074F746AE}"/>
          </ac:spMkLst>
        </pc:spChg>
        <pc:spChg chg="add del mod">
          <ac:chgData name="板野 精之" userId="16f987b9-9da5-480d-884b-590c15f73381" providerId="ADAL" clId="{5325BB64-3CD0-48EC-ADD7-0ACD791B3E35}" dt="2022-09-08T03:12:56.626" v="1430" actId="478"/>
          <ac:spMkLst>
            <pc:docMk/>
            <pc:sldMk cId="2006302855" sldId="256"/>
            <ac:spMk id="254" creationId="{BF00B308-581A-14B6-F822-8B295EA2424C}"/>
          </ac:spMkLst>
        </pc:spChg>
        <pc:spChg chg="add del mod">
          <ac:chgData name="板野 精之" userId="16f987b9-9da5-480d-884b-590c15f73381" providerId="ADAL" clId="{5325BB64-3CD0-48EC-ADD7-0ACD791B3E35}" dt="2022-09-08T03:12:56.626" v="1430" actId="478"/>
          <ac:spMkLst>
            <pc:docMk/>
            <pc:sldMk cId="2006302855" sldId="256"/>
            <ac:spMk id="255" creationId="{7D202901-6C48-F815-0A18-343322C70734}"/>
          </ac:spMkLst>
        </pc:spChg>
        <pc:spChg chg="add del mod">
          <ac:chgData name="板野 精之" userId="16f987b9-9da5-480d-884b-590c15f73381" providerId="ADAL" clId="{5325BB64-3CD0-48EC-ADD7-0ACD791B3E35}" dt="2022-09-08T03:12:56.626" v="1430" actId="478"/>
          <ac:spMkLst>
            <pc:docMk/>
            <pc:sldMk cId="2006302855" sldId="256"/>
            <ac:spMk id="256" creationId="{C7129EFC-31EA-EBEC-BBD7-0B88C0099E78}"/>
          </ac:spMkLst>
        </pc:spChg>
        <pc:spChg chg="add del mod">
          <ac:chgData name="板野 精之" userId="16f987b9-9da5-480d-884b-590c15f73381" providerId="ADAL" clId="{5325BB64-3CD0-48EC-ADD7-0ACD791B3E35}" dt="2022-09-08T03:12:56.626" v="1430" actId="478"/>
          <ac:spMkLst>
            <pc:docMk/>
            <pc:sldMk cId="2006302855" sldId="256"/>
            <ac:spMk id="257" creationId="{61FC27D6-0C9A-BEDE-A829-F062B5B347EA}"/>
          </ac:spMkLst>
        </pc:spChg>
        <pc:spChg chg="add del mod">
          <ac:chgData name="板野 精之" userId="16f987b9-9da5-480d-884b-590c15f73381" providerId="ADAL" clId="{5325BB64-3CD0-48EC-ADD7-0ACD791B3E35}" dt="2022-09-08T03:12:56.626" v="1430" actId="478"/>
          <ac:spMkLst>
            <pc:docMk/>
            <pc:sldMk cId="2006302855" sldId="256"/>
            <ac:spMk id="258" creationId="{D1B5253D-6F8D-D068-CE7C-587F2E8F2B1D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260" creationId="{22115C42-6609-AB37-2AD2-9FD6C4B0A4B5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262" creationId="{50BD7C07-8047-5587-5276-973D878B000E}"/>
          </ac:spMkLst>
        </pc:spChg>
        <pc:spChg chg="add mod topLvl">
          <ac:chgData name="板野 精之" userId="16f987b9-9da5-480d-884b-590c15f73381" providerId="ADAL" clId="{5325BB64-3CD0-48EC-ADD7-0ACD791B3E35}" dt="2022-09-16T01:19:51.307" v="2605" actId="165"/>
          <ac:spMkLst>
            <pc:docMk/>
            <pc:sldMk cId="2006302855" sldId="256"/>
            <ac:spMk id="264" creationId="{864A04EE-1A36-EEA0-99FF-031823097EB0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66" creationId="{CCDA4E1C-ADD7-28E1-9BAD-F22245B38635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68" creationId="{7E74E2CD-03CF-BBCB-F832-5A088F27F6E8}"/>
          </ac:spMkLst>
        </pc:spChg>
        <pc:spChg chg="add mod topLvl">
          <ac:chgData name="板野 精之" userId="16f987b9-9da5-480d-884b-590c15f73381" providerId="ADAL" clId="{5325BB64-3CD0-48EC-ADD7-0ACD791B3E35}" dt="2022-09-16T01:21:49.866" v="2654" actId="1035"/>
          <ac:spMkLst>
            <pc:docMk/>
            <pc:sldMk cId="2006302855" sldId="256"/>
            <ac:spMk id="270" creationId="{6EF9C3F7-DC64-DBE2-C345-AAAE20D2B5B8}"/>
          </ac:spMkLst>
        </pc:spChg>
        <pc:spChg chg="add mod ord topLvl">
          <ac:chgData name="板野 精之" userId="16f987b9-9da5-480d-884b-590c15f73381" providerId="ADAL" clId="{5325BB64-3CD0-48EC-ADD7-0ACD791B3E35}" dt="2022-09-16T01:23:40.809" v="2689" actId="14100"/>
          <ac:spMkLst>
            <pc:docMk/>
            <pc:sldMk cId="2006302855" sldId="256"/>
            <ac:spMk id="272" creationId="{ED28669E-36A2-671D-D6BE-318D1B6D7AF5}"/>
          </ac:spMkLst>
        </pc:spChg>
        <pc:spChg chg="add 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79" creationId="{7C49FFA1-C2D7-54E2-74F0-A6F5155DC1DB}"/>
          </ac:spMkLst>
        </pc:spChg>
        <pc:spChg chg="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81" creationId="{C89AA3A1-1157-D829-C992-9321ECBB566B}"/>
          </ac:spMkLst>
        </pc:spChg>
        <pc:spChg chg="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82" creationId="{DC0C1AE2-CBFF-2645-BB5A-61EF1E598C58}"/>
          </ac:spMkLst>
        </pc:spChg>
        <pc:spChg chg="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83" creationId="{98896C4A-4EA1-CA6C-9498-AA2C18E4FAF1}"/>
          </ac:spMkLst>
        </pc:spChg>
        <pc:spChg chg="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84" creationId="{D72AC8FA-BA79-3040-B42D-0DB0F162A8DC}"/>
          </ac:spMkLst>
        </pc:spChg>
        <pc:spChg chg="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85" creationId="{511AAC8A-3CB1-EB9D-4B82-478B255AA6F4}"/>
          </ac:spMkLst>
        </pc:spChg>
        <pc:spChg chg="mod">
          <ac:chgData name="板野 精之" userId="16f987b9-9da5-480d-884b-590c15f73381" providerId="ADAL" clId="{5325BB64-3CD0-48EC-ADD7-0ACD791B3E35}" dt="2022-09-08T03:20:39.426" v="1530" actId="571"/>
          <ac:spMkLst>
            <pc:docMk/>
            <pc:sldMk cId="2006302855" sldId="256"/>
            <ac:spMk id="286" creationId="{9E1AB784-2541-B6D5-D362-DCDA2C5821CF}"/>
          </ac:spMkLst>
        </pc:spChg>
        <pc:spChg chg="mod">
          <ac:chgData name="板野 精之" userId="16f987b9-9da5-480d-884b-590c15f73381" providerId="ADAL" clId="{5325BB64-3CD0-48EC-ADD7-0ACD791B3E35}" dt="2022-09-08T03:20:54.898" v="1534" actId="571"/>
          <ac:spMkLst>
            <pc:docMk/>
            <pc:sldMk cId="2006302855" sldId="256"/>
            <ac:spMk id="288" creationId="{690F3058-2EE6-7EC7-75EB-B432C78953CE}"/>
          </ac:spMkLst>
        </pc:spChg>
        <pc:spChg chg="mod">
          <ac:chgData name="板野 精之" userId="16f987b9-9da5-480d-884b-590c15f73381" providerId="ADAL" clId="{5325BB64-3CD0-48EC-ADD7-0ACD791B3E35}" dt="2022-09-08T03:20:54.898" v="1534" actId="571"/>
          <ac:spMkLst>
            <pc:docMk/>
            <pc:sldMk cId="2006302855" sldId="256"/>
            <ac:spMk id="289" creationId="{402D18F6-7C67-E52D-3E29-A5C6C3AC6B42}"/>
          </ac:spMkLst>
        </pc:spChg>
        <pc:spChg chg="mod">
          <ac:chgData name="板野 精之" userId="16f987b9-9da5-480d-884b-590c15f73381" providerId="ADAL" clId="{5325BB64-3CD0-48EC-ADD7-0ACD791B3E35}" dt="2022-09-08T03:20:54.898" v="1534" actId="571"/>
          <ac:spMkLst>
            <pc:docMk/>
            <pc:sldMk cId="2006302855" sldId="256"/>
            <ac:spMk id="290" creationId="{A3D56E4C-E8D1-917D-C7EE-97C2A641A41F}"/>
          </ac:spMkLst>
        </pc:spChg>
        <pc:spChg chg="mod">
          <ac:chgData name="板野 精之" userId="16f987b9-9da5-480d-884b-590c15f73381" providerId="ADAL" clId="{5325BB64-3CD0-48EC-ADD7-0ACD791B3E35}" dt="2022-09-08T03:20:54.898" v="1534" actId="571"/>
          <ac:spMkLst>
            <pc:docMk/>
            <pc:sldMk cId="2006302855" sldId="256"/>
            <ac:spMk id="291" creationId="{509E09FF-025B-1BA8-B0BD-AB972651DD0F}"/>
          </ac:spMkLst>
        </pc:spChg>
        <pc:spChg chg="mod">
          <ac:chgData name="板野 精之" userId="16f987b9-9da5-480d-884b-590c15f73381" providerId="ADAL" clId="{5325BB64-3CD0-48EC-ADD7-0ACD791B3E35}" dt="2022-09-08T03:20:54.898" v="1534" actId="571"/>
          <ac:spMkLst>
            <pc:docMk/>
            <pc:sldMk cId="2006302855" sldId="256"/>
            <ac:spMk id="292" creationId="{4792641D-A1AF-E329-0E4D-4593A6D4E8A1}"/>
          </ac:spMkLst>
        </pc:spChg>
        <pc:spChg chg="mod">
          <ac:chgData name="板野 精之" userId="16f987b9-9da5-480d-884b-590c15f73381" providerId="ADAL" clId="{5325BB64-3CD0-48EC-ADD7-0ACD791B3E35}" dt="2022-09-08T03:20:54.898" v="1534" actId="571"/>
          <ac:spMkLst>
            <pc:docMk/>
            <pc:sldMk cId="2006302855" sldId="256"/>
            <ac:spMk id="293" creationId="{0C42AB65-241E-FC52-C829-7011F921B053}"/>
          </ac:spMkLst>
        </pc:spChg>
        <pc:spChg chg="mod">
          <ac:chgData name="板野 精之" userId="16f987b9-9da5-480d-884b-590c15f73381" providerId="ADAL" clId="{5325BB64-3CD0-48EC-ADD7-0ACD791B3E35}" dt="2022-09-08T03:21:05.698" v="1537" actId="571"/>
          <ac:spMkLst>
            <pc:docMk/>
            <pc:sldMk cId="2006302855" sldId="256"/>
            <ac:spMk id="295" creationId="{E65186E4-C08C-5509-0E0A-ECE3BF6DEB68}"/>
          </ac:spMkLst>
        </pc:spChg>
        <pc:spChg chg="mod">
          <ac:chgData name="板野 精之" userId="16f987b9-9da5-480d-884b-590c15f73381" providerId="ADAL" clId="{5325BB64-3CD0-48EC-ADD7-0ACD791B3E35}" dt="2022-09-08T03:21:05.698" v="1537" actId="571"/>
          <ac:spMkLst>
            <pc:docMk/>
            <pc:sldMk cId="2006302855" sldId="256"/>
            <ac:spMk id="296" creationId="{C684B7C8-4EF4-74D7-04F8-A55DB9F0734D}"/>
          </ac:spMkLst>
        </pc:spChg>
        <pc:spChg chg="mod">
          <ac:chgData name="板野 精之" userId="16f987b9-9da5-480d-884b-590c15f73381" providerId="ADAL" clId="{5325BB64-3CD0-48EC-ADD7-0ACD791B3E35}" dt="2022-09-08T03:21:05.698" v="1537" actId="571"/>
          <ac:spMkLst>
            <pc:docMk/>
            <pc:sldMk cId="2006302855" sldId="256"/>
            <ac:spMk id="297" creationId="{97964054-6B40-CAC7-A7D8-67851FD27834}"/>
          </ac:spMkLst>
        </pc:spChg>
        <pc:spChg chg="mod">
          <ac:chgData name="板野 精之" userId="16f987b9-9da5-480d-884b-590c15f73381" providerId="ADAL" clId="{5325BB64-3CD0-48EC-ADD7-0ACD791B3E35}" dt="2022-09-08T03:21:05.698" v="1537" actId="571"/>
          <ac:spMkLst>
            <pc:docMk/>
            <pc:sldMk cId="2006302855" sldId="256"/>
            <ac:spMk id="298" creationId="{278C72EA-4558-0FD7-9362-AE3BBAFD040B}"/>
          </ac:spMkLst>
        </pc:spChg>
        <pc:spChg chg="mod">
          <ac:chgData name="板野 精之" userId="16f987b9-9da5-480d-884b-590c15f73381" providerId="ADAL" clId="{5325BB64-3CD0-48EC-ADD7-0ACD791B3E35}" dt="2022-09-08T03:21:05.698" v="1537" actId="571"/>
          <ac:spMkLst>
            <pc:docMk/>
            <pc:sldMk cId="2006302855" sldId="256"/>
            <ac:spMk id="299" creationId="{1277D364-EB29-8E58-E859-7E1CFEF9D02F}"/>
          </ac:spMkLst>
        </pc:spChg>
        <pc:spChg chg="mod">
          <ac:chgData name="板野 精之" userId="16f987b9-9da5-480d-884b-590c15f73381" providerId="ADAL" clId="{5325BB64-3CD0-48EC-ADD7-0ACD791B3E35}" dt="2022-09-08T03:21:05.698" v="1537" actId="571"/>
          <ac:spMkLst>
            <pc:docMk/>
            <pc:sldMk cId="2006302855" sldId="256"/>
            <ac:spMk id="300" creationId="{341CA305-B5A3-D6C4-725B-E52CA9B3DFBE}"/>
          </ac:spMkLst>
        </pc:spChg>
        <pc:grpChg chg="add del mod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2" creationId="{1F2E6D7E-0EBF-67D3-4B45-087609E0CBB1}"/>
          </ac:grpSpMkLst>
        </pc:grpChg>
        <pc:grpChg chg="add del mod topLvl">
          <ac:chgData name="板野 精之" userId="16f987b9-9da5-480d-884b-590c15f73381" providerId="ADAL" clId="{5325BB64-3CD0-48EC-ADD7-0ACD791B3E35}" dt="2022-09-16T01:22:05.776" v="2671" actId="1035"/>
          <ac:grpSpMkLst>
            <pc:docMk/>
            <pc:sldMk cId="2006302855" sldId="256"/>
            <ac:grpSpMk id="58" creationId="{3153281E-5C24-BA20-49B1-5D37ED65D41A}"/>
          </ac:grpSpMkLst>
        </pc:grpChg>
        <pc:grpChg chg="add del mod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85" creationId="{12E831B6-D9D8-C60C-68A8-B1B19D47A6B1}"/>
          </ac:grpSpMkLst>
        </pc:grpChg>
        <pc:grpChg chg="del mod">
          <ac:chgData name="板野 精之" userId="16f987b9-9da5-480d-884b-590c15f73381" providerId="ADAL" clId="{5325BB64-3CD0-48EC-ADD7-0ACD791B3E35}" dt="2022-09-08T02:54:20.472" v="914" actId="478"/>
          <ac:grpSpMkLst>
            <pc:docMk/>
            <pc:sldMk cId="2006302855" sldId="256"/>
            <ac:grpSpMk id="86" creationId="{ACF11000-68F8-FC5C-7A3A-9D1DE8B3B363}"/>
          </ac:grpSpMkLst>
        </pc:grpChg>
        <pc:grpChg chg="del mod">
          <ac:chgData name="板野 精之" userId="16f987b9-9da5-480d-884b-590c15f73381" providerId="ADAL" clId="{5325BB64-3CD0-48EC-ADD7-0ACD791B3E35}" dt="2022-09-08T02:54:27.842" v="918" actId="478"/>
          <ac:grpSpMkLst>
            <pc:docMk/>
            <pc:sldMk cId="2006302855" sldId="256"/>
            <ac:grpSpMk id="87" creationId="{643A0A5F-185E-6AAC-4B6F-80C19AA1F1AA}"/>
          </ac:grpSpMkLst>
        </pc:grpChg>
        <pc:grpChg chg="del mod">
          <ac:chgData name="板野 精之" userId="16f987b9-9da5-480d-884b-590c15f73381" providerId="ADAL" clId="{5325BB64-3CD0-48EC-ADD7-0ACD791B3E35}" dt="2022-09-08T02:54:23.049" v="915" actId="478"/>
          <ac:grpSpMkLst>
            <pc:docMk/>
            <pc:sldMk cId="2006302855" sldId="256"/>
            <ac:grpSpMk id="88" creationId="{5FC74EDD-27DF-E725-8464-F1E564F4EA9A}"/>
          </ac:grpSpMkLst>
        </pc:grpChg>
        <pc:grpChg chg="del mod">
          <ac:chgData name="板野 精之" userId="16f987b9-9da5-480d-884b-590c15f73381" providerId="ADAL" clId="{5325BB64-3CD0-48EC-ADD7-0ACD791B3E35}" dt="2022-09-08T02:54:33.107" v="921" actId="478"/>
          <ac:grpSpMkLst>
            <pc:docMk/>
            <pc:sldMk cId="2006302855" sldId="256"/>
            <ac:grpSpMk id="89" creationId="{8B3745C4-D135-1CE2-04F0-8350C9E9EF4F}"/>
          </ac:grpSpMkLst>
        </pc:grpChg>
        <pc:grpChg chg="del mod">
          <ac:chgData name="板野 精之" userId="16f987b9-9da5-480d-884b-590c15f73381" providerId="ADAL" clId="{5325BB64-3CD0-48EC-ADD7-0ACD791B3E35}" dt="2022-09-08T02:54:34.586" v="922" actId="478"/>
          <ac:grpSpMkLst>
            <pc:docMk/>
            <pc:sldMk cId="2006302855" sldId="256"/>
            <ac:grpSpMk id="90" creationId="{769CFCC5-89CA-07BD-E924-7C61D7B43D01}"/>
          </ac:grpSpMkLst>
        </pc:grpChg>
        <pc:grpChg chg="del mod">
          <ac:chgData name="板野 精之" userId="16f987b9-9da5-480d-884b-590c15f73381" providerId="ADAL" clId="{5325BB64-3CD0-48EC-ADD7-0ACD791B3E35}" dt="2022-09-08T02:54:36.412" v="923" actId="478"/>
          <ac:grpSpMkLst>
            <pc:docMk/>
            <pc:sldMk cId="2006302855" sldId="256"/>
            <ac:grpSpMk id="91" creationId="{01DFEB59-91D0-1E06-D4EF-9730CAE6D303}"/>
          </ac:grpSpMkLst>
        </pc:grpChg>
        <pc:grpChg chg="add del mod">
          <ac:chgData name="板野 精之" userId="16f987b9-9da5-480d-884b-590c15f73381" providerId="ADAL" clId="{5325BB64-3CD0-48EC-ADD7-0ACD791B3E35}" dt="2022-09-08T02:51:41.653" v="781" actId="165"/>
          <ac:grpSpMkLst>
            <pc:docMk/>
            <pc:sldMk cId="2006302855" sldId="256"/>
            <ac:grpSpMk id="113" creationId="{2E220221-3C6E-8BB6-61FA-552F0A336079}"/>
          </ac:grpSpMkLst>
        </pc:grpChg>
        <pc:grpChg chg="del mod topLvl">
          <ac:chgData name="板野 精之" userId="16f987b9-9da5-480d-884b-590c15f73381" providerId="ADAL" clId="{5325BB64-3CD0-48EC-ADD7-0ACD791B3E35}" dt="2022-09-08T02:52:54.090" v="812" actId="165"/>
          <ac:grpSpMkLst>
            <pc:docMk/>
            <pc:sldMk cId="2006302855" sldId="256"/>
            <ac:grpSpMk id="114" creationId="{0E1CCFA3-2663-1C0E-9EC5-E2B04EE6CCC0}"/>
          </ac:grpSpMkLst>
        </pc:grpChg>
        <pc:grpChg chg="del mod topLvl">
          <ac:chgData name="板野 精之" userId="16f987b9-9da5-480d-884b-590c15f73381" providerId="ADAL" clId="{5325BB64-3CD0-48EC-ADD7-0ACD791B3E35}" dt="2022-09-08T02:53:07.092" v="817" actId="478"/>
          <ac:grpSpMkLst>
            <pc:docMk/>
            <pc:sldMk cId="2006302855" sldId="256"/>
            <ac:grpSpMk id="115" creationId="{4A716AFE-4E68-0C35-FA32-EF3EE3650F53}"/>
          </ac:grpSpMkLst>
        </pc:grpChg>
        <pc:grpChg chg="del mod topLvl">
          <ac:chgData name="板野 精之" userId="16f987b9-9da5-480d-884b-590c15f73381" providerId="ADAL" clId="{5325BB64-3CD0-48EC-ADD7-0ACD791B3E35}" dt="2022-09-08T02:53:11.196" v="819" actId="478"/>
          <ac:grpSpMkLst>
            <pc:docMk/>
            <pc:sldMk cId="2006302855" sldId="256"/>
            <ac:grpSpMk id="116" creationId="{A061C526-C067-828F-C860-5E6B80B4A3DF}"/>
          </ac:grpSpMkLst>
        </pc:grpChg>
        <pc:grpChg chg="del mod topLvl">
          <ac:chgData name="板野 精之" userId="16f987b9-9da5-480d-884b-590c15f73381" providerId="ADAL" clId="{5325BB64-3CD0-48EC-ADD7-0ACD791B3E35}" dt="2022-09-08T02:53:12.986" v="820" actId="478"/>
          <ac:grpSpMkLst>
            <pc:docMk/>
            <pc:sldMk cId="2006302855" sldId="256"/>
            <ac:grpSpMk id="117" creationId="{8C6788D4-C1A5-B9F2-FF67-B8FE2C8C6504}"/>
          </ac:grpSpMkLst>
        </pc:grpChg>
        <pc:grpChg chg="del mod topLvl">
          <ac:chgData name="板野 精之" userId="16f987b9-9da5-480d-884b-590c15f73381" providerId="ADAL" clId="{5325BB64-3CD0-48EC-ADD7-0ACD791B3E35}" dt="2022-09-08T02:53:14.611" v="821" actId="478"/>
          <ac:grpSpMkLst>
            <pc:docMk/>
            <pc:sldMk cId="2006302855" sldId="256"/>
            <ac:grpSpMk id="118" creationId="{1F278530-BCC6-770D-BF25-0D52953A140E}"/>
          </ac:grpSpMkLst>
        </pc:grpChg>
        <pc:grpChg chg="del mod topLvl">
          <ac:chgData name="板野 精之" userId="16f987b9-9da5-480d-884b-590c15f73381" providerId="ADAL" clId="{5325BB64-3CD0-48EC-ADD7-0ACD791B3E35}" dt="2022-09-08T02:51:47.987" v="782" actId="165"/>
          <ac:grpSpMkLst>
            <pc:docMk/>
            <pc:sldMk cId="2006302855" sldId="256"/>
            <ac:grpSpMk id="119" creationId="{3BD7023F-F127-958C-5224-6190EC1CBC22}"/>
          </ac:grpSpMkLst>
        </pc:grpChg>
        <pc:grpChg chg="add del mod ord">
          <ac:chgData name="板野 精之" userId="16f987b9-9da5-480d-884b-590c15f73381" providerId="ADAL" clId="{5325BB64-3CD0-48EC-ADD7-0ACD791B3E35}" dt="2022-09-08T02:57:34.204" v="934" actId="165"/>
          <ac:grpSpMkLst>
            <pc:docMk/>
            <pc:sldMk cId="2006302855" sldId="256"/>
            <ac:grpSpMk id="159" creationId="{3066F250-8198-31BB-DDE1-EA8C3D506EC2}"/>
          </ac:grpSpMkLst>
        </pc:grpChg>
        <pc:grpChg chg="add del mod">
          <ac:chgData name="板野 精之" userId="16f987b9-9da5-480d-884b-590c15f73381" providerId="ADAL" clId="{5325BB64-3CD0-48EC-ADD7-0ACD791B3E35}" dt="2022-09-08T02:57:46.789" v="937" actId="165"/>
          <ac:grpSpMkLst>
            <pc:docMk/>
            <pc:sldMk cId="2006302855" sldId="256"/>
            <ac:grpSpMk id="165" creationId="{B5BC3BC3-F4C1-C7FC-9D0C-507CF3804D22}"/>
          </ac:grpSpMkLst>
        </pc:grpChg>
        <pc:grpChg chg="add del mod">
          <ac:chgData name="板野 精之" userId="16f987b9-9da5-480d-884b-590c15f73381" providerId="ADAL" clId="{5325BB64-3CD0-48EC-ADD7-0ACD791B3E35}" dt="2022-09-08T02:57:57.382" v="940" actId="165"/>
          <ac:grpSpMkLst>
            <pc:docMk/>
            <pc:sldMk cId="2006302855" sldId="256"/>
            <ac:grpSpMk id="171" creationId="{B371C348-AAE9-9608-51E1-EBF6DE2F5CC4}"/>
          </ac:grpSpMkLst>
        </pc:grpChg>
        <pc:grpChg chg="add del mod">
          <ac:chgData name="板野 精之" userId="16f987b9-9da5-480d-884b-590c15f73381" providerId="ADAL" clId="{5325BB64-3CD0-48EC-ADD7-0ACD791B3E35}" dt="2022-09-08T02:58:08.365" v="942" actId="165"/>
          <ac:grpSpMkLst>
            <pc:docMk/>
            <pc:sldMk cId="2006302855" sldId="256"/>
            <ac:grpSpMk id="177" creationId="{50467709-9455-E7F7-4C93-A062AC62B2BA}"/>
          </ac:grpSpMkLst>
        </pc:grpChg>
        <pc:grpChg chg="add del mod">
          <ac:chgData name="板野 精之" userId="16f987b9-9da5-480d-884b-590c15f73381" providerId="ADAL" clId="{5325BB64-3CD0-48EC-ADD7-0ACD791B3E35}" dt="2022-09-08T02:58:20.214" v="945" actId="165"/>
          <ac:grpSpMkLst>
            <pc:docMk/>
            <pc:sldMk cId="2006302855" sldId="256"/>
            <ac:grpSpMk id="183" creationId="{D5E47C74-FD79-A46C-5902-411F92DE7B5A}"/>
          </ac:grpSpMkLst>
        </pc:grpChg>
        <pc:grpChg chg="add del mod">
          <ac:chgData name="板野 精之" userId="16f987b9-9da5-480d-884b-590c15f73381" providerId="ADAL" clId="{5325BB64-3CD0-48EC-ADD7-0ACD791B3E35}" dt="2022-09-08T02:58:33.180" v="947" actId="165"/>
          <ac:grpSpMkLst>
            <pc:docMk/>
            <pc:sldMk cId="2006302855" sldId="256"/>
            <ac:grpSpMk id="186" creationId="{D90CB402-1DF0-256F-2A32-430CBE9152F1}"/>
          </ac:grpSpMkLst>
        </pc:grpChg>
        <pc:grpChg chg="add del mod">
          <ac:chgData name="板野 精之" userId="16f987b9-9da5-480d-884b-590c15f73381" providerId="ADAL" clId="{5325BB64-3CD0-48EC-ADD7-0ACD791B3E35}" dt="2022-09-08T03:07:26.357" v="1264" actId="165"/>
          <ac:grpSpMkLst>
            <pc:docMk/>
            <pc:sldMk cId="2006302855" sldId="256"/>
            <ac:grpSpMk id="198" creationId="{FAEF8E7B-8CCD-0D69-2C2D-A548B54387E8}"/>
          </ac:grpSpMkLst>
        </pc:grpChg>
        <pc:grpChg chg="del mod topLvl">
          <ac:chgData name="板野 精之" userId="16f987b9-9da5-480d-884b-590c15f73381" providerId="ADAL" clId="{5325BB64-3CD0-48EC-ADD7-0ACD791B3E35}" dt="2022-09-08T03:07:40.669" v="1266" actId="165"/>
          <ac:grpSpMkLst>
            <pc:docMk/>
            <pc:sldMk cId="2006302855" sldId="256"/>
            <ac:grpSpMk id="199" creationId="{A7892A76-B61B-9310-117B-EA3DBA575F01}"/>
          </ac:grpSpMkLst>
        </pc:grpChg>
        <pc:grpChg chg="del mod topLvl">
          <ac:chgData name="板野 精之" userId="16f987b9-9da5-480d-884b-590c15f73381" providerId="ADAL" clId="{5325BB64-3CD0-48EC-ADD7-0ACD791B3E35}" dt="2022-09-08T03:07:40.669" v="1266" actId="165"/>
          <ac:grpSpMkLst>
            <pc:docMk/>
            <pc:sldMk cId="2006302855" sldId="256"/>
            <ac:grpSpMk id="200" creationId="{C63F585D-A298-93AE-5A7F-E7067D4D0AE7}"/>
          </ac:grpSpMkLst>
        </pc:grpChg>
        <pc:grpChg chg="del mod topLvl">
          <ac:chgData name="板野 精之" userId="16f987b9-9da5-480d-884b-590c15f73381" providerId="ADAL" clId="{5325BB64-3CD0-48EC-ADD7-0ACD791B3E35}" dt="2022-09-08T03:07:40.669" v="1266" actId="165"/>
          <ac:grpSpMkLst>
            <pc:docMk/>
            <pc:sldMk cId="2006302855" sldId="256"/>
            <ac:grpSpMk id="201" creationId="{2695B465-9A2F-61FC-5506-2D91C9F906C9}"/>
          </ac:grpSpMkLst>
        </pc:grpChg>
        <pc:grpChg chg="del mod topLvl">
          <ac:chgData name="板野 精之" userId="16f987b9-9da5-480d-884b-590c15f73381" providerId="ADAL" clId="{5325BB64-3CD0-48EC-ADD7-0ACD791B3E35}" dt="2022-09-08T03:07:40.669" v="1266" actId="165"/>
          <ac:grpSpMkLst>
            <pc:docMk/>
            <pc:sldMk cId="2006302855" sldId="256"/>
            <ac:grpSpMk id="202" creationId="{BBF72A8E-C7E6-88F4-9A5F-19CC3C71CC7D}"/>
          </ac:grpSpMkLst>
        </pc:grpChg>
        <pc:grpChg chg="del mod topLvl">
          <ac:chgData name="板野 精之" userId="16f987b9-9da5-480d-884b-590c15f73381" providerId="ADAL" clId="{5325BB64-3CD0-48EC-ADD7-0ACD791B3E35}" dt="2022-09-08T03:07:40.669" v="1266" actId="165"/>
          <ac:grpSpMkLst>
            <pc:docMk/>
            <pc:sldMk cId="2006302855" sldId="256"/>
            <ac:grpSpMk id="203" creationId="{23CEA06A-04CF-E0A4-BEB5-07272EF0C45F}"/>
          </ac:grpSpMkLst>
        </pc:grpChg>
        <pc:grpChg chg="del mod topLvl">
          <ac:chgData name="板野 精之" userId="16f987b9-9da5-480d-884b-590c15f73381" providerId="ADAL" clId="{5325BB64-3CD0-48EC-ADD7-0ACD791B3E35}" dt="2022-09-08T03:07:40.669" v="1266" actId="165"/>
          <ac:grpSpMkLst>
            <pc:docMk/>
            <pc:sldMk cId="2006302855" sldId="256"/>
            <ac:grpSpMk id="204" creationId="{2822EAB5-247A-0FA9-B728-D7D5E24D8950}"/>
          </ac:grpSpMkLst>
        </pc:grpChg>
        <pc:grpChg chg="add del mod">
          <ac:chgData name="板野 精之" userId="16f987b9-9da5-480d-884b-590c15f73381" providerId="ADAL" clId="{5325BB64-3CD0-48EC-ADD7-0ACD791B3E35}" dt="2022-09-08T03:05:21.399" v="1188" actId="165"/>
          <ac:grpSpMkLst>
            <pc:docMk/>
            <pc:sldMk cId="2006302855" sldId="256"/>
            <ac:grpSpMk id="217" creationId="{260679FE-5F93-1EEC-9647-3037BD594D62}"/>
          </ac:grpSpMkLst>
        </pc:grpChg>
        <pc:grpChg chg="add del mod">
          <ac:chgData name="板野 精之" userId="16f987b9-9da5-480d-884b-590c15f73381" providerId="ADAL" clId="{5325BB64-3CD0-48EC-ADD7-0ACD791B3E35}" dt="2022-09-08T03:05:21.399" v="1188" actId="165"/>
          <ac:grpSpMkLst>
            <pc:docMk/>
            <pc:sldMk cId="2006302855" sldId="256"/>
            <ac:grpSpMk id="220" creationId="{72E07265-0CC2-0EE0-1CCD-B57596FAC27F}"/>
          </ac:grpSpMkLst>
        </pc:grpChg>
        <pc:grpChg chg="add del mod">
          <ac:chgData name="板野 精之" userId="16f987b9-9da5-480d-884b-590c15f73381" providerId="ADAL" clId="{5325BB64-3CD0-48EC-ADD7-0ACD791B3E35}" dt="2022-09-08T03:05:21.399" v="1188" actId="165"/>
          <ac:grpSpMkLst>
            <pc:docMk/>
            <pc:sldMk cId="2006302855" sldId="256"/>
            <ac:grpSpMk id="223" creationId="{B1F616B6-7D7B-1A14-73D5-6BA4F672710F}"/>
          </ac:grpSpMkLst>
        </pc:grpChg>
        <pc:grpChg chg="add del mod">
          <ac:chgData name="板野 精之" userId="16f987b9-9da5-480d-884b-590c15f73381" providerId="ADAL" clId="{5325BB64-3CD0-48EC-ADD7-0ACD791B3E35}" dt="2022-09-08T03:05:21.399" v="1188" actId="165"/>
          <ac:grpSpMkLst>
            <pc:docMk/>
            <pc:sldMk cId="2006302855" sldId="256"/>
            <ac:grpSpMk id="226" creationId="{B00986B5-24D4-718D-AC7B-874C604AF5C9}"/>
          </ac:grpSpMkLst>
        </pc:grpChg>
        <pc:grpChg chg="add del mod">
          <ac:chgData name="板野 精之" userId="16f987b9-9da5-480d-884b-590c15f73381" providerId="ADAL" clId="{5325BB64-3CD0-48EC-ADD7-0ACD791B3E35}" dt="2022-09-08T03:05:21.399" v="1188" actId="165"/>
          <ac:grpSpMkLst>
            <pc:docMk/>
            <pc:sldMk cId="2006302855" sldId="256"/>
            <ac:grpSpMk id="229" creationId="{97140E14-8565-2EC6-AF73-91F97BB9DB16}"/>
          </ac:grpSpMkLst>
        </pc:grpChg>
        <pc:grpChg chg="add del mod">
          <ac:chgData name="板野 精之" userId="16f987b9-9da5-480d-884b-590c15f73381" providerId="ADAL" clId="{5325BB64-3CD0-48EC-ADD7-0ACD791B3E35}" dt="2022-09-08T03:05:21.399" v="1188" actId="165"/>
          <ac:grpSpMkLst>
            <pc:docMk/>
            <pc:sldMk cId="2006302855" sldId="256"/>
            <ac:grpSpMk id="232" creationId="{29F50BDD-133D-F109-C5B9-B7650E7B27E5}"/>
          </ac:grpSpMkLst>
        </pc:grpChg>
        <pc:grpChg chg="add del mod">
          <ac:chgData name="板野 精之" userId="16f987b9-9da5-480d-884b-590c15f73381" providerId="ADAL" clId="{5325BB64-3CD0-48EC-ADD7-0ACD791B3E35}" dt="2022-09-08T03:03:05.301" v="1103" actId="165"/>
          <ac:grpSpMkLst>
            <pc:docMk/>
            <pc:sldMk cId="2006302855" sldId="256"/>
            <ac:grpSpMk id="235" creationId="{7F721C99-2FD1-A095-4F23-AFF7D93DBE86}"/>
          </ac:grpSpMkLst>
        </pc:grpChg>
        <pc:grpChg chg="add del mod">
          <ac:chgData name="板野 精之" userId="16f987b9-9da5-480d-884b-590c15f73381" providerId="ADAL" clId="{5325BB64-3CD0-48EC-ADD7-0ACD791B3E35}" dt="2022-09-08T03:03:08.885" v="1104" actId="165"/>
          <ac:grpSpMkLst>
            <pc:docMk/>
            <pc:sldMk cId="2006302855" sldId="256"/>
            <ac:grpSpMk id="238" creationId="{442FA30B-6F4B-CB1B-AB6B-0196D675BA84}"/>
          </ac:grpSpMkLst>
        </pc:grpChg>
        <pc:grpChg chg="add del mod">
          <ac:chgData name="板野 精之" userId="16f987b9-9da5-480d-884b-590c15f73381" providerId="ADAL" clId="{5325BB64-3CD0-48EC-ADD7-0ACD791B3E35}" dt="2022-09-08T03:03:13.022" v="1105" actId="165"/>
          <ac:grpSpMkLst>
            <pc:docMk/>
            <pc:sldMk cId="2006302855" sldId="256"/>
            <ac:grpSpMk id="241" creationId="{09E4AAFE-6D8B-6F78-F700-41C5EB5E4A4B}"/>
          </ac:grpSpMkLst>
        </pc:grpChg>
        <pc:grpChg chg="add del mod">
          <ac:chgData name="板野 精之" userId="16f987b9-9da5-480d-884b-590c15f73381" providerId="ADAL" clId="{5325BB64-3CD0-48EC-ADD7-0ACD791B3E35}" dt="2022-09-08T03:03:13.022" v="1105" actId="165"/>
          <ac:grpSpMkLst>
            <pc:docMk/>
            <pc:sldMk cId="2006302855" sldId="256"/>
            <ac:grpSpMk id="244" creationId="{4BA4AD8E-17F7-0914-0FE2-A5AE3006EEEA}"/>
          </ac:grpSpMkLst>
        </pc:grpChg>
        <pc:grpChg chg="add del mod">
          <ac:chgData name="板野 精之" userId="16f987b9-9da5-480d-884b-590c15f73381" providerId="ADAL" clId="{5325BB64-3CD0-48EC-ADD7-0ACD791B3E35}" dt="2022-09-08T03:03:13.022" v="1105" actId="165"/>
          <ac:grpSpMkLst>
            <pc:docMk/>
            <pc:sldMk cId="2006302855" sldId="256"/>
            <ac:grpSpMk id="247" creationId="{4798A5DE-F078-5663-E350-9BD9C0E34C00}"/>
          </ac:grpSpMkLst>
        </pc:grpChg>
        <pc:grpChg chg="add del mod">
          <ac:chgData name="板野 精之" userId="16f987b9-9da5-480d-884b-590c15f73381" providerId="ADAL" clId="{5325BB64-3CD0-48EC-ADD7-0ACD791B3E35}" dt="2022-09-08T03:03:13.022" v="1105" actId="165"/>
          <ac:grpSpMkLst>
            <pc:docMk/>
            <pc:sldMk cId="2006302855" sldId="256"/>
            <ac:grpSpMk id="250" creationId="{12DEA9EE-11F3-58BE-2AC6-CA650C941DCC}"/>
          </ac:grpSpMkLst>
        </pc:grpChg>
        <pc:grpChg chg="add mod">
          <ac:chgData name="板野 精之" userId="16f987b9-9da5-480d-884b-590c15f73381" providerId="ADAL" clId="{5325BB64-3CD0-48EC-ADD7-0ACD791B3E35}" dt="2022-09-16T01:21:49.866" v="2654" actId="1035"/>
          <ac:grpSpMkLst>
            <pc:docMk/>
            <pc:sldMk cId="2006302855" sldId="256"/>
            <ac:grpSpMk id="273" creationId="{CA973896-DBFE-AD85-1B3F-99262FE89B5F}"/>
          </ac:grpSpMkLst>
        </pc:grpChg>
        <pc:grpChg chg="add mod">
          <ac:chgData name="板野 精之" userId="16f987b9-9da5-480d-884b-590c15f73381" providerId="ADAL" clId="{5325BB64-3CD0-48EC-ADD7-0ACD791B3E35}" dt="2022-09-16T01:21:49.866" v="2654" actId="1035"/>
          <ac:grpSpMkLst>
            <pc:docMk/>
            <pc:sldMk cId="2006302855" sldId="256"/>
            <ac:grpSpMk id="274" creationId="{872C2FAA-916E-0260-D66C-4C8B3B3B6E5F}"/>
          </ac:grpSpMkLst>
        </pc:grpChg>
        <pc:grpChg chg="add mod">
          <ac:chgData name="板野 精之" userId="16f987b9-9da5-480d-884b-590c15f73381" providerId="ADAL" clId="{5325BB64-3CD0-48EC-ADD7-0ACD791B3E35}" dt="2022-09-16T01:21:49.866" v="2654" actId="1035"/>
          <ac:grpSpMkLst>
            <pc:docMk/>
            <pc:sldMk cId="2006302855" sldId="256"/>
            <ac:grpSpMk id="275" creationId="{BABA9753-7E46-A053-E296-D4AE78D7CD5D}"/>
          </ac:grpSpMkLst>
        </pc:grpChg>
        <pc:grpChg chg="add mod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276" creationId="{48E85DBB-2D94-46A5-6BC8-8BA636B879FE}"/>
          </ac:grpSpMkLst>
        </pc:grpChg>
        <pc:grpChg chg="add mod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277" creationId="{EC6888E7-456A-9108-7674-4D7E79E8BF2E}"/>
          </ac:grpSpMkLst>
        </pc:grpChg>
        <pc:grpChg chg="add mod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278" creationId="{513327E0-F838-F105-CED0-833DB58582EA}"/>
          </ac:grpSpMkLst>
        </pc:grpChg>
        <pc:grpChg chg="add mod">
          <ac:chgData name="板野 精之" userId="16f987b9-9da5-480d-884b-590c15f73381" providerId="ADAL" clId="{5325BB64-3CD0-48EC-ADD7-0ACD791B3E35}" dt="2022-09-08T03:20:39.426" v="1530" actId="571"/>
          <ac:grpSpMkLst>
            <pc:docMk/>
            <pc:sldMk cId="2006302855" sldId="256"/>
            <ac:grpSpMk id="280" creationId="{E9EBB62E-F628-5A0D-1B6A-32EBB84D7AA9}"/>
          </ac:grpSpMkLst>
        </pc:grpChg>
        <pc:grpChg chg="add mod">
          <ac:chgData name="板野 精之" userId="16f987b9-9da5-480d-884b-590c15f73381" providerId="ADAL" clId="{5325BB64-3CD0-48EC-ADD7-0ACD791B3E35}" dt="2022-09-08T03:20:54.898" v="1534" actId="571"/>
          <ac:grpSpMkLst>
            <pc:docMk/>
            <pc:sldMk cId="2006302855" sldId="256"/>
            <ac:grpSpMk id="287" creationId="{02E19CFB-52AB-4CFB-8550-095D50D3DE30}"/>
          </ac:grpSpMkLst>
        </pc:grpChg>
        <pc:grpChg chg="add del mod">
          <ac:chgData name="板野 精之" userId="16f987b9-9da5-480d-884b-590c15f73381" providerId="ADAL" clId="{5325BB64-3CD0-48EC-ADD7-0ACD791B3E35}" dt="2022-09-08T03:21:06.745" v="1538" actId="478"/>
          <ac:grpSpMkLst>
            <pc:docMk/>
            <pc:sldMk cId="2006302855" sldId="256"/>
            <ac:grpSpMk id="294" creationId="{EF54906B-9AA1-58A7-80FD-2689042ED350}"/>
          </ac:grpSpMkLst>
        </pc:grpChg>
        <pc:grpChg chg="add mod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301" creationId="{A4972AB9-9311-FD55-8EBF-74C81223665C}"/>
          </ac:grpSpMkLst>
        </pc:grpChg>
        <pc:grpChg chg="add mod topLvl">
          <ac:chgData name="板野 精之" userId="16f987b9-9da5-480d-884b-590c15f73381" providerId="ADAL" clId="{5325BB64-3CD0-48EC-ADD7-0ACD791B3E35}" dt="2022-09-16T01:21:49.866" v="2654" actId="1035"/>
          <ac:grpSpMkLst>
            <pc:docMk/>
            <pc:sldMk cId="2006302855" sldId="256"/>
            <ac:grpSpMk id="302" creationId="{EC2DA641-EE1E-B92C-F62C-2D24CB9D2D91}"/>
          </ac:grpSpMkLst>
        </pc:grpChg>
        <pc:grpChg chg="add mod topLvl">
          <ac:chgData name="板野 精之" userId="16f987b9-9da5-480d-884b-590c15f73381" providerId="ADAL" clId="{5325BB64-3CD0-48EC-ADD7-0ACD791B3E35}" dt="2022-09-16T01:19:51.307" v="2605" actId="165"/>
          <ac:grpSpMkLst>
            <pc:docMk/>
            <pc:sldMk cId="2006302855" sldId="256"/>
            <ac:grpSpMk id="303" creationId="{A03DDE05-E719-8D41-FDB0-FA11C079186A}"/>
          </ac:grpSpMkLst>
        </pc:grpChg>
        <pc:graphicFrameChg chg="add del mod">
          <ac:chgData name="板野 精之" userId="16f987b9-9da5-480d-884b-590c15f73381" providerId="ADAL" clId="{5325BB64-3CD0-48EC-ADD7-0ACD791B3E35}" dt="2022-09-08T02:42:28.729" v="586"/>
          <ac:graphicFrameMkLst>
            <pc:docMk/>
            <pc:sldMk cId="2006302855" sldId="256"/>
            <ac:graphicFrameMk id="20" creationId="{4E27DE75-5EEF-339B-3425-1AE64676B8CF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42:51.043" v="593"/>
          <ac:graphicFrameMkLst>
            <pc:docMk/>
            <pc:sldMk cId="2006302855" sldId="256"/>
            <ac:graphicFrameMk id="21" creationId="{805FC168-E8FC-D35B-7D2F-0185CB04C07C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43:18.827" v="602"/>
          <ac:graphicFrameMkLst>
            <pc:docMk/>
            <pc:sldMk cId="2006302855" sldId="256"/>
            <ac:graphicFrameMk id="22" creationId="{A5EF706D-449C-F60F-8C4C-E2DEB42EB785}"/>
          </ac:graphicFrameMkLst>
        </pc:graphicFrame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12" creationId="{E93161CD-7FE6-2F7A-2D82-BC13E0C8C206}"/>
          </ac:cxnSpMkLst>
        </pc:cxn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14" creationId="{3312100E-E3F7-2DDF-5C0D-61918084F8E1}"/>
          </ac:cxnSpMkLst>
        </pc:cxn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16" creationId="{B0E79934-FA2A-BED2-EB90-3BD81C4D76F1}"/>
          </ac:cxnSpMkLst>
        </pc:cxn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18" creationId="{2D192F7B-3401-4227-C382-87F5993E2E87}"/>
          </ac:cxnSpMkLst>
        </pc:cxn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20" creationId="{BE4B8213-DDEA-5E79-02F1-7E07BE91523E}"/>
          </ac:cxnSpMkLst>
        </pc:cxn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21" creationId="{AC9D4243-D3F9-2817-96AE-6EA6B5B64978}"/>
          </ac:cxnSpMkLst>
        </pc:cxnChg>
        <pc:cxnChg chg="add mod">
          <ac:chgData name="板野 精之" userId="16f987b9-9da5-480d-884b-590c15f73381" providerId="ADAL" clId="{5325BB64-3CD0-48EC-ADD7-0ACD791B3E35}" dt="2022-09-16T01:22:05.776" v="2671" actId="1035"/>
          <ac:cxnSpMkLst>
            <pc:docMk/>
            <pc:sldMk cId="2006302855" sldId="256"/>
            <ac:cxnSpMk id="22" creationId="{2A78B822-7C0B-D641-09B6-A2AC5D55D901}"/>
          </ac:cxnSpMkLst>
        </pc:cxnChg>
        <pc:cxnChg chg="add del mod ord topLvl">
          <ac:chgData name="板野 精之" userId="16f987b9-9da5-480d-884b-590c15f73381" providerId="ADAL" clId="{5325BB64-3CD0-48EC-ADD7-0ACD791B3E35}" dt="2022-09-16T01:20:33.465" v="2625" actId="14100"/>
          <ac:cxnSpMkLst>
            <pc:docMk/>
            <pc:sldMk cId="2006302855" sldId="256"/>
            <ac:cxnSpMk id="80" creationId="{EF0AB75F-8A88-26B6-E54A-81E1F413F355}"/>
          </ac:cxnSpMkLst>
        </pc:cxnChg>
      </pc:sldChg>
      <pc:sldChg chg="addSp delSp modSp mod">
        <pc:chgData name="板野 精之" userId="16f987b9-9da5-480d-884b-590c15f73381" providerId="ADAL" clId="{5325BB64-3CD0-48EC-ADD7-0ACD791B3E35}" dt="2022-09-16T01:27:34.990" v="2778"/>
        <pc:sldMkLst>
          <pc:docMk/>
          <pc:sldMk cId="1840233059" sldId="257"/>
        </pc:sldMkLst>
        <pc:spChg chg="add del mod">
          <ac:chgData name="板野 精之" userId="16f987b9-9da5-480d-884b-590c15f73381" providerId="ADAL" clId="{5325BB64-3CD0-48EC-ADD7-0ACD791B3E35}" dt="2022-09-15T02:47:55.155" v="2499"/>
          <ac:spMkLst>
            <pc:docMk/>
            <pc:sldMk cId="1840233059" sldId="257"/>
            <ac:spMk id="3" creationId="{DA8D3248-DF19-3500-089B-BE3BDF319206}"/>
          </ac:spMkLst>
        </pc:spChg>
        <pc:spChg chg="add del mod">
          <ac:chgData name="板野 精之" userId="16f987b9-9da5-480d-884b-590c15f73381" providerId="ADAL" clId="{5325BB64-3CD0-48EC-ADD7-0ACD791B3E35}" dt="2022-09-09T02:24:27.685" v="1645" actId="478"/>
          <ac:spMkLst>
            <pc:docMk/>
            <pc:sldMk cId="1840233059" sldId="257"/>
            <ac:spMk id="4" creationId="{0E14C7E9-F32F-589F-719B-DA702F0E5942}"/>
          </ac:spMkLst>
        </pc:spChg>
        <pc:spChg chg="add del mod">
          <ac:chgData name="板野 精之" userId="16f987b9-9da5-480d-884b-590c15f73381" providerId="ADAL" clId="{5325BB64-3CD0-48EC-ADD7-0ACD791B3E35}" dt="2022-09-16T01:26:45.792" v="2731" actId="478"/>
          <ac:spMkLst>
            <pc:docMk/>
            <pc:sldMk cId="1840233059" sldId="257"/>
            <ac:spMk id="4" creationId="{6D14F625-E589-E080-DFAD-2D8DADED3E38}"/>
          </ac:spMkLst>
        </pc:spChg>
        <pc:spChg chg="add mod">
          <ac:chgData name="板野 精之" userId="16f987b9-9da5-480d-884b-590c15f73381" providerId="ADAL" clId="{5325BB64-3CD0-48EC-ADD7-0ACD791B3E35}" dt="2022-09-09T03:10:12.728" v="1737" actId="1036"/>
          <ac:spMkLst>
            <pc:docMk/>
            <pc:sldMk cId="1840233059" sldId="257"/>
            <ac:spMk id="5" creationId="{ACE57591-480D-A2EB-97A9-8B715C3FED4A}"/>
          </ac:spMkLst>
        </pc:spChg>
        <pc:spChg chg="add mod">
          <ac:chgData name="板野 精之" userId="16f987b9-9da5-480d-884b-590c15f73381" providerId="ADAL" clId="{5325BB64-3CD0-48EC-ADD7-0ACD791B3E35}" dt="2022-09-09T02:24:55.097" v="1657" actId="1076"/>
          <ac:spMkLst>
            <pc:docMk/>
            <pc:sldMk cId="1840233059" sldId="257"/>
            <ac:spMk id="6" creationId="{DBC009C5-7650-5540-4A28-142066D85863}"/>
          </ac:spMkLst>
        </pc:spChg>
        <pc:spChg chg="add del 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1" creationId="{F33A15B1-E2E2-FFFA-4955-41F5540F05AB}"/>
          </ac:spMkLst>
        </pc:spChg>
        <pc:spChg chg="add 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3" creationId="{B06BFBB6-8C91-D187-7DBC-84307267E58B}"/>
          </ac:spMkLst>
        </pc:spChg>
        <pc:spChg chg="add mod">
          <ac:chgData name="板野 精之" userId="16f987b9-9da5-480d-884b-590c15f73381" providerId="ADAL" clId="{5325BB64-3CD0-48EC-ADD7-0ACD791B3E35}" dt="2022-09-16T01:27:34.990" v="2778"/>
          <ac:spMkLst>
            <pc:docMk/>
            <pc:sldMk cId="1840233059" sldId="257"/>
            <ac:spMk id="24" creationId="{0C021420-5FA4-10B5-007D-0B2349AADB9F}"/>
          </ac:spMkLst>
        </pc:spChg>
        <pc:spChg chg="add 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" creationId="{651593F3-9C14-AF60-6F72-2AF59EBC364C}"/>
          </ac:spMkLst>
        </pc:spChg>
        <pc:spChg chg="add 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26" creationId="{E2464B40-0D81-A4E2-7217-7CBDAE4A6C97}"/>
          </ac:spMkLst>
        </pc:spChg>
        <pc:spChg chg="add 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7" creationId="{BECCB792-7881-2F4A-CFA7-08941F38E9E7}"/>
          </ac:spMkLst>
        </pc:spChg>
        <pc:spChg chg="add 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9" creationId="{BD990A78-908D-78C0-5897-5E1412FE087E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30" creationId="{30D7D3FC-5116-AA05-8156-FE2769A35282}"/>
          </ac:spMkLst>
        </pc:spChg>
        <pc:spChg chg="add 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31" creationId="{67E4CF6C-EBA4-8F22-F662-CEFB8EE0DE66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38" creationId="{0BA7E8B2-45DA-0F1C-EB85-1738304821E7}"/>
          </ac:spMkLst>
        </pc:spChg>
        <pc:spChg chg="add del mod topLvl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39" creationId="{5E1FDB3A-078D-94E3-2665-52D76CA2FD05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40" creationId="{072D6AAB-0238-8AE5-B39A-D5B0542B19B1}"/>
          </ac:spMkLst>
        </pc:spChg>
        <pc:spChg chg="add mod topLvl">
          <ac:chgData name="板野 精之" userId="16f987b9-9da5-480d-884b-590c15f73381" providerId="ADAL" clId="{5325BB64-3CD0-48EC-ADD7-0ACD791B3E35}" dt="2022-09-16T01:22:26.501" v="2680" actId="1035"/>
          <ac:spMkLst>
            <pc:docMk/>
            <pc:sldMk cId="1840233059" sldId="257"/>
            <ac:spMk id="41" creationId="{FFFA9C9B-F071-F431-7668-421CBFDFED37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42" creationId="{D57F0AFF-0AD0-7AC8-2BCB-A6F9C9E34793}"/>
          </ac:spMkLst>
        </pc:spChg>
        <pc:spChg chg="add mod topLvl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43" creationId="{18384BB5-CEE5-BC2A-BF38-050E23033199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44" creationId="{FFE251A1-A7B0-992A-3A9F-9EEC362A977E}"/>
          </ac:spMkLst>
        </pc:spChg>
        <pc:spChg chg="add mod topLvl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45" creationId="{77E7F0E5-A3A4-9A8D-96A2-5E3A3BA1CB4A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46" creationId="{440E99C3-532A-BBC9-2781-78E42515972B}"/>
          </ac:spMkLst>
        </pc:spChg>
        <pc:spChg chg="add mod topLvl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47" creationId="{85B9BF24-FF4A-F21E-8E20-419E72806C41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4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4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5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6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6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6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6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6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65" creationId="{F395A6BD-46C9-BCA2-A454-B0F320BE58CF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66" creationId="{00000000-0000-0000-0000-000000000000}"/>
          </ac:spMkLst>
        </pc:spChg>
        <pc:spChg chg="add 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67" creationId="{EAC5493F-8E19-167B-411F-9C43F3CDBBA6}"/>
          </ac:spMkLst>
        </pc:spChg>
        <pc:spChg chg="mod">
          <ac:chgData name="板野 精之" userId="16f987b9-9da5-480d-884b-590c15f73381" providerId="ADAL" clId="{5325BB64-3CD0-48EC-ADD7-0ACD791B3E35}" dt="2022-09-16T01:23:11.673" v="2684"/>
          <ac:spMkLst>
            <pc:docMk/>
            <pc:sldMk cId="1840233059" sldId="257"/>
            <ac:spMk id="68" creationId="{4E359445-1B43-6636-9AF8-3BE55C81F9FA}"/>
          </ac:spMkLst>
        </pc:spChg>
        <pc:spChg chg="add 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69" creationId="{E1C8FBC8-16F8-9571-A5FE-2FC0737E06AB}"/>
          </ac:spMkLst>
        </pc:spChg>
        <pc:spChg chg="add 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71" creationId="{B7A1B9C8-C862-1EDC-2370-45981E68C3D7}"/>
          </ac:spMkLst>
        </pc:spChg>
        <pc:spChg chg="add del mod">
          <ac:chgData name="板野 精之" userId="16f987b9-9da5-480d-884b-590c15f73381" providerId="ADAL" clId="{5325BB64-3CD0-48EC-ADD7-0ACD791B3E35}" dt="2022-09-09T03:06:45.305" v="1701" actId="478"/>
          <ac:spMkLst>
            <pc:docMk/>
            <pc:sldMk cId="1840233059" sldId="257"/>
            <ac:spMk id="73" creationId="{DEAB8066-2880-BEDE-98A4-C17A83515EE5}"/>
          </ac:spMkLst>
        </pc:spChg>
        <pc:spChg chg="del mod">
          <ac:chgData name="板野 精之" userId="16f987b9-9da5-480d-884b-590c15f73381" providerId="ADAL" clId="{5325BB64-3CD0-48EC-ADD7-0ACD791B3E35}" dt="2022-09-08T03:25:34.865" v="1571" actId="478"/>
          <ac:spMkLst>
            <pc:docMk/>
            <pc:sldMk cId="1840233059" sldId="257"/>
            <ac:spMk id="120" creationId="{00000000-0000-0000-0000-000000000000}"/>
          </ac:spMkLst>
        </pc:spChg>
        <pc:spChg chg="mod ord topLvl">
          <ac:chgData name="板野 精之" userId="16f987b9-9da5-480d-884b-590c15f73381" providerId="ADAL" clId="{5325BB64-3CD0-48EC-ADD7-0ACD791B3E35}" dt="2022-09-16T01:23:31.608" v="2688" actId="14100"/>
          <ac:spMkLst>
            <pc:docMk/>
            <pc:sldMk cId="1840233059" sldId="257"/>
            <ac:spMk id="144" creationId="{47D3D483-104A-0882-E68A-8C1E40222E0C}"/>
          </ac:spMkLst>
        </pc:spChg>
        <pc:spChg chg="del">
          <ac:chgData name="板野 精之" userId="16f987b9-9da5-480d-884b-590c15f73381" providerId="ADAL" clId="{5325BB64-3CD0-48EC-ADD7-0ACD791B3E35}" dt="2022-09-08T03:00:35.570" v="1033" actId="478"/>
          <ac:spMkLst>
            <pc:docMk/>
            <pc:sldMk cId="1840233059" sldId="257"/>
            <ac:spMk id="147" creationId="{00000000-0000-0000-0000-000000000000}"/>
          </ac:spMkLst>
        </pc:spChg>
        <pc:spChg chg="del mod topLvl">
          <ac:chgData name="板野 精之" userId="16f987b9-9da5-480d-884b-590c15f73381" providerId="ADAL" clId="{5325BB64-3CD0-48EC-ADD7-0ACD791B3E35}" dt="2022-09-16T01:23:11.139" v="2683" actId="478"/>
          <ac:spMkLst>
            <pc:docMk/>
            <pc:sldMk cId="1840233059" sldId="257"/>
            <ac:spMk id="16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7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188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11:08.987" v="10" actId="478"/>
          <ac:spMkLst>
            <pc:docMk/>
            <pc:sldMk cId="1840233059" sldId="257"/>
            <ac:spMk id="215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11:31.890" v="15" actId="478"/>
          <ac:spMkLst>
            <pc:docMk/>
            <pc:sldMk cId="1840233059" sldId="257"/>
            <ac:spMk id="217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12:11.212" v="53" actId="478"/>
          <ac:spMkLst>
            <pc:docMk/>
            <pc:sldMk cId="1840233059" sldId="257"/>
            <ac:spMk id="219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2:12:33.258" v="82" actId="478"/>
          <ac:spMkLst>
            <pc:docMk/>
            <pc:sldMk cId="1840233059" sldId="257"/>
            <ac:spMk id="221" creationId="{00000000-0000-0000-0000-000000000000}"/>
          </ac:spMkLst>
        </pc:spChg>
        <pc:spChg chg="del">
          <ac:chgData name="板野 精之" userId="16f987b9-9da5-480d-884b-590c15f73381" providerId="ADAL" clId="{5325BB64-3CD0-48EC-ADD7-0ACD791B3E35}" dt="2022-09-08T02:12:52.404" v="105" actId="478"/>
          <ac:spMkLst>
            <pc:docMk/>
            <pc:sldMk cId="1840233059" sldId="257"/>
            <ac:spMk id="22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3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3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3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3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4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4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4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43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25:34.865" v="1571" actId="478"/>
          <ac:spMkLst>
            <pc:docMk/>
            <pc:sldMk cId="1840233059" sldId="257"/>
            <ac:spMk id="24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5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6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7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71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7:17.131" v="1509" actId="478"/>
          <ac:spMkLst>
            <pc:docMk/>
            <pc:sldMk cId="1840233059" sldId="257"/>
            <ac:spMk id="272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7:04.482" v="1502" actId="478"/>
          <ac:spMkLst>
            <pc:docMk/>
            <pc:sldMk cId="1840233059" sldId="257"/>
            <ac:spMk id="273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7:02.442" v="1501" actId="478"/>
          <ac:spMkLst>
            <pc:docMk/>
            <pc:sldMk cId="1840233059" sldId="257"/>
            <ac:spMk id="274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6:05.738" v="1467" actId="478"/>
          <ac:spMkLst>
            <pc:docMk/>
            <pc:sldMk cId="1840233059" sldId="257"/>
            <ac:spMk id="275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6:56.856" v="1496" actId="478"/>
          <ac:spMkLst>
            <pc:docMk/>
            <pc:sldMk cId="1840233059" sldId="257"/>
            <ac:spMk id="276" creationId="{00000000-0000-0000-0000-000000000000}"/>
          </ac:spMkLst>
        </pc:spChg>
        <pc:spChg chg="del mod">
          <ac:chgData name="板野 精之" userId="16f987b9-9da5-480d-884b-590c15f73381" providerId="ADAL" clId="{5325BB64-3CD0-48EC-ADD7-0ACD791B3E35}" dt="2022-09-08T03:16:48.159" v="1491" actId="478"/>
          <ac:spMkLst>
            <pc:docMk/>
            <pc:sldMk cId="1840233059" sldId="257"/>
            <ac:spMk id="27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7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7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0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1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2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3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4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5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6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7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8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89" creationId="{00000000-0000-0000-0000-0000000000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90" creationId="{18157406-2A95-6C60-5356-DBE445B53200}"/>
          </ac:spMkLst>
        </pc:spChg>
        <pc:spChg chg="del mod">
          <ac:chgData name="板野 精之" userId="16f987b9-9da5-480d-884b-590c15f73381" providerId="ADAL" clId="{5325BB64-3CD0-48EC-ADD7-0ACD791B3E35}" dt="2022-09-08T03:25:45.530" v="1573" actId="478"/>
          <ac:spMkLst>
            <pc:docMk/>
            <pc:sldMk cId="1840233059" sldId="257"/>
            <ac:spMk id="293" creationId="{7CB00C5F-FB08-5D1D-0F6B-0D46AC82ED9E}"/>
          </ac:spMkLst>
        </pc:spChg>
        <pc:spChg chg="del mod">
          <ac:chgData name="板野 精之" userId="16f987b9-9da5-480d-884b-590c15f73381" providerId="ADAL" clId="{5325BB64-3CD0-48EC-ADD7-0ACD791B3E35}" dt="2022-09-08T03:25:45.530" v="1573" actId="478"/>
          <ac:spMkLst>
            <pc:docMk/>
            <pc:sldMk cId="1840233059" sldId="257"/>
            <ac:spMk id="294" creationId="{67D6F9B8-8AB8-3C7F-E1ED-C7496EF384A1}"/>
          </ac:spMkLst>
        </pc:spChg>
        <pc:spChg chg="del mod">
          <ac:chgData name="板野 精之" userId="16f987b9-9da5-480d-884b-590c15f73381" providerId="ADAL" clId="{5325BB64-3CD0-48EC-ADD7-0ACD791B3E35}" dt="2022-09-08T03:25:45.530" v="1573" actId="478"/>
          <ac:spMkLst>
            <pc:docMk/>
            <pc:sldMk cId="1840233059" sldId="257"/>
            <ac:spMk id="295" creationId="{27541724-5E01-4C72-420F-0D5462F75A55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98" creationId="{A3C52AB5-0A4B-FE1F-E0DC-09440F3D5DC3}"/>
          </ac:spMkLst>
        </pc:spChg>
        <pc:spChg chg="mod topLvl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299" creationId="{86953137-9A11-CAE7-D8E0-5062E2E561F6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307" creationId="{18157406-2A95-6C60-5356-DBE445B532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308" creationId="{A3C52AB5-0A4B-FE1F-E0DC-09440F3D5DC3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340" creationId="{18157406-2A95-6C60-5356-DBE445B53200}"/>
          </ac:spMkLst>
        </pc:spChg>
        <pc:spChg chg="mod">
          <ac:chgData name="板野 精之" userId="16f987b9-9da5-480d-884b-590c15f73381" providerId="ADAL" clId="{5325BB64-3CD0-48EC-ADD7-0ACD791B3E35}" dt="2022-09-16T01:22:16.675" v="2672" actId="165"/>
          <ac:spMkLst>
            <pc:docMk/>
            <pc:sldMk cId="1840233059" sldId="257"/>
            <ac:spMk id="341" creationId="{A3C52AB5-0A4B-FE1F-E0DC-09440F3D5DC3}"/>
          </ac:spMkLst>
        </pc:spChg>
        <pc:spChg chg="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345" creationId="{18157406-2A95-6C60-5356-DBE445B53200}"/>
          </ac:spMkLst>
        </pc:spChg>
        <pc:spChg chg="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346" creationId="{A3C52AB5-0A4B-FE1F-E0DC-09440F3D5DC3}"/>
          </ac:spMkLst>
        </pc:spChg>
        <pc:spChg chg="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347" creationId="{18157406-2A95-6C60-5356-DBE445B53200}"/>
          </ac:spMkLst>
        </pc:spChg>
        <pc:spChg chg="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348" creationId="{A3C52AB5-0A4B-FE1F-E0DC-09440F3D5DC3}"/>
          </ac:spMkLst>
        </pc:spChg>
        <pc:spChg chg="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349" creationId="{18157406-2A95-6C60-5356-DBE445B53200}"/>
          </ac:spMkLst>
        </pc:spChg>
        <pc:spChg chg="mod topLvl">
          <ac:chgData name="板野 精之" userId="16f987b9-9da5-480d-884b-590c15f73381" providerId="ADAL" clId="{5325BB64-3CD0-48EC-ADD7-0ACD791B3E35}" dt="2022-09-16T01:22:52.488" v="2682" actId="1035"/>
          <ac:spMkLst>
            <pc:docMk/>
            <pc:sldMk cId="1840233059" sldId="257"/>
            <ac:spMk id="350" creationId="{A3C52AB5-0A4B-FE1F-E0DC-09440F3D5DC3}"/>
          </ac:spMkLst>
        </pc:spChg>
        <pc:spChg chg="del mod">
          <ac:chgData name="板野 精之" userId="16f987b9-9da5-480d-884b-590c15f73381" providerId="ADAL" clId="{5325BB64-3CD0-48EC-ADD7-0ACD791B3E35}" dt="2022-09-08T03:25:45.530" v="1573" actId="478"/>
          <ac:spMkLst>
            <pc:docMk/>
            <pc:sldMk cId="1840233059" sldId="257"/>
            <ac:spMk id="353" creationId="{7CB00C5F-FB08-5D1D-0F6B-0D46AC82ED9E}"/>
          </ac:spMkLst>
        </pc:spChg>
        <pc:spChg chg="del mod">
          <ac:chgData name="板野 精之" userId="16f987b9-9da5-480d-884b-590c15f73381" providerId="ADAL" clId="{5325BB64-3CD0-48EC-ADD7-0ACD791B3E35}" dt="2022-09-08T03:25:45.530" v="1573" actId="478"/>
          <ac:spMkLst>
            <pc:docMk/>
            <pc:sldMk cId="1840233059" sldId="257"/>
            <ac:spMk id="354" creationId="{67D6F9B8-8AB8-3C7F-E1ED-C7496EF384A1}"/>
          </ac:spMkLst>
        </pc:spChg>
        <pc:spChg chg="del mod">
          <ac:chgData name="板野 精之" userId="16f987b9-9da5-480d-884b-590c15f73381" providerId="ADAL" clId="{5325BB64-3CD0-48EC-ADD7-0ACD791B3E35}" dt="2022-09-08T03:25:45.530" v="1573" actId="478"/>
          <ac:spMkLst>
            <pc:docMk/>
            <pc:sldMk cId="1840233059" sldId="257"/>
            <ac:spMk id="355" creationId="{27541724-5E01-4C72-420F-0D5462F75A55}"/>
          </ac:spMkLst>
        </pc:spChg>
        <pc:grpChg chg="add del 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2" creationId="{4AE9D714-6CDC-737A-4C53-4C48F77BF1D3}"/>
          </ac:grpSpMkLst>
        </pc:grpChg>
        <pc:grpChg chg="add del mod">
          <ac:chgData name="板野 精之" userId="16f987b9-9da5-480d-884b-590c15f73381" providerId="ADAL" clId="{5325BB64-3CD0-48EC-ADD7-0ACD791B3E35}" dt="2022-09-08T03:17:04.482" v="1502" actId="478"/>
          <ac:grpSpMkLst>
            <pc:docMk/>
            <pc:sldMk cId="1840233059" sldId="257"/>
            <ac:grpSpMk id="2" creationId="{6CFA79D8-ACDE-357C-9833-E42E4D44155A}"/>
          </ac:grpSpMkLst>
        </pc:grpChg>
        <pc:grpChg chg="add del mod">
          <ac:chgData name="板野 精之" userId="16f987b9-9da5-480d-884b-590c15f73381" providerId="ADAL" clId="{5325BB64-3CD0-48EC-ADD7-0ACD791B3E35}" dt="2022-09-08T03:17:02.442" v="1501" actId="478"/>
          <ac:grpSpMkLst>
            <pc:docMk/>
            <pc:sldMk cId="1840233059" sldId="257"/>
            <ac:grpSpMk id="3" creationId="{A21D400F-3DBE-83D5-6CD3-0FC6EAE707C0}"/>
          </ac:grpSpMkLst>
        </pc:grpChg>
        <pc:grpChg chg="add del mod">
          <ac:chgData name="板野 精之" userId="16f987b9-9da5-480d-884b-590c15f73381" providerId="ADAL" clId="{5325BB64-3CD0-48EC-ADD7-0ACD791B3E35}" dt="2022-09-08T03:16:05.738" v="1467" actId="478"/>
          <ac:grpSpMkLst>
            <pc:docMk/>
            <pc:sldMk cId="1840233059" sldId="257"/>
            <ac:grpSpMk id="4" creationId="{FA3AE4B1-95A6-FDA1-C213-D11B9FBB3149}"/>
          </ac:grpSpMkLst>
        </pc:grpChg>
        <pc:grpChg chg="add del mod">
          <ac:chgData name="板野 精之" userId="16f987b9-9da5-480d-884b-590c15f73381" providerId="ADAL" clId="{5325BB64-3CD0-48EC-ADD7-0ACD791B3E35}" dt="2022-09-08T03:16:48.159" v="1491" actId="478"/>
          <ac:grpSpMkLst>
            <pc:docMk/>
            <pc:sldMk cId="1840233059" sldId="257"/>
            <ac:grpSpMk id="5" creationId="{18736001-16D0-C9E5-867B-219F63FEDA7B}"/>
          </ac:grpSpMkLst>
        </pc:grpChg>
        <pc:grpChg chg="add del mod">
          <ac:chgData name="板野 精之" userId="16f987b9-9da5-480d-884b-590c15f73381" providerId="ADAL" clId="{5325BB64-3CD0-48EC-ADD7-0ACD791B3E35}" dt="2022-09-08T03:16:56.856" v="1496" actId="478"/>
          <ac:grpSpMkLst>
            <pc:docMk/>
            <pc:sldMk cId="1840233059" sldId="257"/>
            <ac:grpSpMk id="6" creationId="{7B35451D-A8F6-CD3E-383B-8B4461BCD2CF}"/>
          </ac:grpSpMkLst>
        </pc:grpChg>
        <pc:grpChg chg="add del mod">
          <ac:chgData name="板野 精之" userId="16f987b9-9da5-480d-884b-590c15f73381" providerId="ADAL" clId="{5325BB64-3CD0-48EC-ADD7-0ACD791B3E35}" dt="2022-09-08T03:17:17.131" v="1509" actId="478"/>
          <ac:grpSpMkLst>
            <pc:docMk/>
            <pc:sldMk cId="1840233059" sldId="257"/>
            <ac:grpSpMk id="7" creationId="{DDCCE634-AA1E-CF58-4918-D3CFAD128630}"/>
          </ac:grpSpMkLst>
        </pc:grpChg>
        <pc:grpChg chg="add 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8" creationId="{5013C80D-0361-01FE-709B-A7251E196917}"/>
          </ac:grpSpMkLst>
        </pc:grpChg>
        <pc:grpChg chg="add mod topLvl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9" creationId="{238B73A2-4293-AE14-D370-766F77520C16}"/>
          </ac:grpSpMkLst>
        </pc:grpChg>
        <pc:grpChg chg="add mod">
          <ac:chgData name="板野 精之" userId="16f987b9-9da5-480d-884b-590c15f73381" providerId="ADAL" clId="{5325BB64-3CD0-48EC-ADD7-0ACD791B3E35}" dt="2022-09-16T01:23:11.673" v="2684"/>
          <ac:grpSpMkLst>
            <pc:docMk/>
            <pc:sldMk cId="1840233059" sldId="257"/>
            <ac:grpSpMk id="28" creationId="{BE3B0837-6E40-BB92-EB38-DB0E0A5BB24A}"/>
          </ac:grpSpMkLst>
        </pc:grpChg>
        <pc:grpChg chg="add 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2" creationId="{3DEB80BE-A815-0584-9ABA-EAA4009DBAA3}"/>
          </ac:grpSpMkLst>
        </pc:grpChg>
        <pc:grpChg chg="add 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" creationId="{B50663DB-C7B4-3B6B-710D-1750691B1944}"/>
          </ac:grpSpMkLst>
        </pc:grpChg>
        <pc:grpChg chg="add 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4" creationId="{0C19F746-D1B6-260C-8A1E-FEA168AB4801}"/>
          </ac:grpSpMkLst>
        </pc:grpChg>
        <pc:grpChg chg="add 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5" creationId="{18C64BD2-E93D-513C-9B56-CBDB4B6D821F}"/>
          </ac:grpSpMkLst>
        </pc:grpChg>
        <pc:grpChg chg="add mod topLvl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" creationId="{8819C7AE-B1FC-0B65-456F-ABB2D239B003}"/>
          </ac:grpSpMkLst>
        </pc:grpChg>
        <pc:grpChg chg="add mod topLvl">
          <ac:chgData name="板野 精之" userId="16f987b9-9da5-480d-884b-590c15f73381" providerId="ADAL" clId="{5325BB64-3CD0-48EC-ADD7-0ACD791B3E35}" dt="2022-09-16T01:22:52.488" v="2682" actId="1035"/>
          <ac:grpSpMkLst>
            <pc:docMk/>
            <pc:sldMk cId="1840233059" sldId="257"/>
            <ac:grpSpMk id="37" creationId="{239C07EE-8773-9B2A-E103-3882D14E0FFB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0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1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2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3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4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5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6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09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10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11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12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13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14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4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5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6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7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8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39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42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56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57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58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59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0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1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2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3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4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5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6" creationId="{00000000-0000-0000-0000-000000000000}"/>
          </ac:grpSpMkLst>
        </pc:grpChg>
        <pc:grpChg chg="mod">
          <ac:chgData name="板野 精之" userId="16f987b9-9da5-480d-884b-590c15f73381" providerId="ADAL" clId="{5325BB64-3CD0-48EC-ADD7-0ACD791B3E35}" dt="2022-09-16T01:22:16.675" v="2672" actId="165"/>
          <ac:grpSpMkLst>
            <pc:docMk/>
            <pc:sldMk cId="1840233059" sldId="257"/>
            <ac:grpSpMk id="367" creationId="{00000000-0000-0000-0000-000000000000}"/>
          </ac:grpSpMkLst>
        </pc:grpChg>
        <pc:grpChg chg="del mod topLvl">
          <ac:chgData name="板野 精之" userId="16f987b9-9da5-480d-884b-590c15f73381" providerId="ADAL" clId="{5325BB64-3CD0-48EC-ADD7-0ACD791B3E35}" dt="2022-09-16T01:23:11.139" v="2683" actId="478"/>
          <ac:grpSpMkLst>
            <pc:docMk/>
            <pc:sldMk cId="1840233059" sldId="257"/>
            <ac:grpSpMk id="368" creationId="{00000000-0000-0000-0000-000000000000}"/>
          </ac:grpSpMkLst>
        </pc:grpChg>
        <pc:graphicFrameChg chg="add del mod">
          <ac:chgData name="板野 精之" userId="16f987b9-9da5-480d-884b-590c15f73381" providerId="ADAL" clId="{5325BB64-3CD0-48EC-ADD7-0ACD791B3E35}" dt="2022-09-08T02:23:52.495" v="490"/>
          <ac:graphicFrameMkLst>
            <pc:docMk/>
            <pc:sldMk cId="1840233059" sldId="257"/>
            <ac:graphicFrameMk id="10" creationId="{EBEE6807-9575-DAB5-21ED-8801B91FD9C5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24:00.963" v="496"/>
          <ac:graphicFrameMkLst>
            <pc:docMk/>
            <pc:sldMk cId="1840233059" sldId="257"/>
            <ac:graphicFrameMk id="11" creationId="{AF229F8C-8661-5998-8A24-3BD0A0833BAA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28:16.212" v="509"/>
          <ac:graphicFrameMkLst>
            <pc:docMk/>
            <pc:sldMk cId="1840233059" sldId="257"/>
            <ac:graphicFrameMk id="12" creationId="{11CBD766-D8FF-4D38-E6E3-AA2084E1E4CD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28:28.576" v="514"/>
          <ac:graphicFrameMkLst>
            <pc:docMk/>
            <pc:sldMk cId="1840233059" sldId="257"/>
            <ac:graphicFrameMk id="13" creationId="{9E8CA6EF-F156-50A6-CB33-5C08FD5A22E6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28:59.091" v="525"/>
          <ac:graphicFrameMkLst>
            <pc:docMk/>
            <pc:sldMk cId="1840233059" sldId="257"/>
            <ac:graphicFrameMk id="14" creationId="{DEFC8ED6-AEC6-504F-773D-4BB32CE3EDC5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29:10.888" v="531"/>
          <ac:graphicFrameMkLst>
            <pc:docMk/>
            <pc:sldMk cId="1840233059" sldId="257"/>
            <ac:graphicFrameMk id="15" creationId="{16166764-4BB2-3F9D-3CF2-B47691063892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36:38.272" v="538"/>
          <ac:graphicFrameMkLst>
            <pc:docMk/>
            <pc:sldMk cId="1840233059" sldId="257"/>
            <ac:graphicFrameMk id="16" creationId="{428E3736-6F13-197A-9DC2-22FAE3216204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36:50.035" v="543"/>
          <ac:graphicFrameMkLst>
            <pc:docMk/>
            <pc:sldMk cId="1840233059" sldId="257"/>
            <ac:graphicFrameMk id="17" creationId="{15045FF2-FA43-720C-5322-5F4C32578653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37:08.748" v="549"/>
          <ac:graphicFrameMkLst>
            <pc:docMk/>
            <pc:sldMk cId="1840233059" sldId="257"/>
            <ac:graphicFrameMk id="18" creationId="{CC1010D9-73CB-18BD-6397-7C551B8116BB}"/>
          </ac:graphicFrameMkLst>
        </pc:graphicFrameChg>
        <pc:graphicFrameChg chg="add del mod">
          <ac:chgData name="板野 精之" userId="16f987b9-9da5-480d-884b-590c15f73381" providerId="ADAL" clId="{5325BB64-3CD0-48EC-ADD7-0ACD791B3E35}" dt="2022-09-08T02:41:51.843" v="578"/>
          <ac:graphicFrameMkLst>
            <pc:docMk/>
            <pc:sldMk cId="1840233059" sldId="257"/>
            <ac:graphicFrameMk id="19" creationId="{68BBCEA9-8B69-B958-6A9D-11BBC393FA7A}"/>
          </ac:graphicFrameMkLst>
        </pc:graphicFrame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3" creationId="{95288F55-75C9-732F-5DB7-CEC9BC7C037F}"/>
          </ac:cxnSpMkLst>
        </pc:cxn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7" creationId="{CED2A3B3-2631-C918-962C-6721A13EE02F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0" creationId="{3EDE6EA2-E95F-8BC3-143F-06B3A2C7F428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1" creationId="{3A9FD166-6176-08D6-36DF-3BE66205A6CA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2" creationId="{16B7989A-E487-6508-B3A7-4C3345ECCA78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3" creationId="{C49C170B-79BF-8AD9-0855-52A8DA0E5F15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4" creationId="{9415075F-A8AC-AD31-36C5-0354D552E93D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5" creationId="{CAFB506A-6CB6-EA13-12A1-2DE74A180897}"/>
          </ac:cxnSpMkLst>
        </pc:cxnChg>
        <pc:cxnChg chg="add del mod">
          <ac:chgData name="板野 精之" userId="16f987b9-9da5-480d-884b-590c15f73381" providerId="ADAL" clId="{5325BB64-3CD0-48EC-ADD7-0ACD791B3E35}" dt="2022-09-16T01:23:11.139" v="2683" actId="478"/>
          <ac:cxnSpMkLst>
            <pc:docMk/>
            <pc:sldMk cId="1840233059" sldId="257"/>
            <ac:cxnSpMk id="16" creationId="{05405F73-B925-DEA6-12DA-535B1B168021}"/>
          </ac:cxnSpMkLst>
        </pc:cxn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17" creationId="{170B4461-AF88-299E-D32F-919F5FFDE4DD}"/>
          </ac:cxnSpMkLst>
        </pc:cxn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18" creationId="{4F972C5D-1471-E2A8-D0C5-52CB1F703067}"/>
          </ac:cxnSpMkLst>
        </pc:cxn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19" creationId="{42A22334-F6B1-7CB7-84B1-CA3ADA1D57DD}"/>
          </ac:cxnSpMkLst>
        </pc:cxn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20" creationId="{DB7ED10B-CD0B-7DAA-63EB-3126881163FD}"/>
          </ac:cxnSpMkLst>
        </pc:cxnChg>
        <pc:cxnChg chg="add mod">
          <ac:chgData name="板野 精之" userId="16f987b9-9da5-480d-884b-590c15f73381" providerId="ADAL" clId="{5325BB64-3CD0-48EC-ADD7-0ACD791B3E35}" dt="2022-09-16T01:23:11.673" v="2684"/>
          <ac:cxnSpMkLst>
            <pc:docMk/>
            <pc:sldMk cId="1840233059" sldId="257"/>
            <ac:cxnSpMk id="22" creationId="{86ACBD18-056B-19A9-B4A7-38A505E206D4}"/>
          </ac:cxnSpMkLst>
        </pc:cxnChg>
        <pc:cxnChg chg="mod ord topLvl">
          <ac:chgData name="板野 精之" userId="16f987b9-9da5-480d-884b-590c15f73381" providerId="ADAL" clId="{5325BB64-3CD0-48EC-ADD7-0ACD791B3E35}" dt="2022-09-16T01:23:21.937" v="2686" actId="14100"/>
          <ac:cxnSpMkLst>
            <pc:docMk/>
            <pc:sldMk cId="1840233059" sldId="257"/>
            <ac:cxnSpMk id="344" creationId="{00000000-0000-0000-0000-000000000000}"/>
          </ac:cxnSpMkLst>
        </pc:cxnChg>
      </pc:sldChg>
      <pc:sldChg chg="addSp delSp modSp new mod">
        <pc:chgData name="板野 精之" userId="16f987b9-9da5-480d-884b-590c15f73381" providerId="ADAL" clId="{5325BB64-3CD0-48EC-ADD7-0ACD791B3E35}" dt="2022-09-16T01:27:21.156" v="2776" actId="20577"/>
        <pc:sldMkLst>
          <pc:docMk/>
          <pc:sldMk cId="2089187721" sldId="258"/>
        </pc:sldMkLst>
        <pc:spChg chg="del">
          <ac:chgData name="板野 精之" userId="16f987b9-9da5-480d-884b-590c15f73381" providerId="ADAL" clId="{5325BB64-3CD0-48EC-ADD7-0ACD791B3E35}" dt="2022-09-13T09:14:14.367" v="1745" actId="478"/>
          <ac:spMkLst>
            <pc:docMk/>
            <pc:sldMk cId="2089187721" sldId="258"/>
            <ac:spMk id="2" creationId="{6C8BFF1C-54C2-DADF-8E8C-1E6E39681D99}"/>
          </ac:spMkLst>
        </pc:spChg>
        <pc:spChg chg="del">
          <ac:chgData name="板野 精之" userId="16f987b9-9da5-480d-884b-590c15f73381" providerId="ADAL" clId="{5325BB64-3CD0-48EC-ADD7-0ACD791B3E35}" dt="2022-09-13T09:14:14.367" v="1745" actId="478"/>
          <ac:spMkLst>
            <pc:docMk/>
            <pc:sldMk cId="2089187721" sldId="258"/>
            <ac:spMk id="3" creationId="{547A1A8A-6E0A-F981-072E-18DE491F7100}"/>
          </ac:spMkLst>
        </pc:spChg>
        <pc:spChg chg="add mod">
          <ac:chgData name="板野 精之" userId="16f987b9-9da5-480d-884b-590c15f73381" providerId="ADAL" clId="{5325BB64-3CD0-48EC-ADD7-0ACD791B3E35}" dt="2022-09-13T09:41:35.736" v="2156" actId="20577"/>
          <ac:spMkLst>
            <pc:docMk/>
            <pc:sldMk cId="2089187721" sldId="258"/>
            <ac:spMk id="5" creationId="{1D342F44-2B97-2DB3-88AC-C1C680222DD3}"/>
          </ac:spMkLst>
        </pc:spChg>
        <pc:graphicFrameChg chg="add mod modGraphic">
          <ac:chgData name="板野 精之" userId="16f987b9-9da5-480d-884b-590c15f73381" providerId="ADAL" clId="{5325BB64-3CD0-48EC-ADD7-0ACD791B3E35}" dt="2022-09-16T01:27:21.156" v="2776" actId="20577"/>
          <ac:graphicFrameMkLst>
            <pc:docMk/>
            <pc:sldMk cId="2089187721" sldId="258"/>
            <ac:graphicFrameMk id="6" creationId="{647F7E30-80FD-4CFC-B3EA-6FA0814B7B06}"/>
          </ac:graphicFrameMkLst>
        </pc:graphicFrameChg>
      </pc:sldChg>
    </pc:docChg>
  </pc:docChgLst>
  <pc:docChgLst>
    <pc:chgData name="SEIJI ITANO" userId="d14abaad31e2099c" providerId="LiveId" clId="{E65C1499-9051-4DCE-8995-C0AE10CD6F54}"/>
    <pc:docChg chg="undo custSel modSld">
      <pc:chgData name="SEIJI ITANO" userId="d14abaad31e2099c" providerId="LiveId" clId="{E65C1499-9051-4DCE-8995-C0AE10CD6F54}" dt="2023-06-26T06:56:51.977" v="160" actId="1076"/>
      <pc:docMkLst>
        <pc:docMk/>
      </pc:docMkLst>
      <pc:sldChg chg="addSp delSp modSp mod">
        <pc:chgData name="SEIJI ITANO" userId="d14abaad31e2099c" providerId="LiveId" clId="{E65C1499-9051-4DCE-8995-C0AE10CD6F54}" dt="2023-06-26T06:56:51.977" v="160" actId="1076"/>
        <pc:sldMkLst>
          <pc:docMk/>
          <pc:sldMk cId="2089187721" sldId="258"/>
        </pc:sldMkLst>
        <pc:spChg chg="mod">
          <ac:chgData name="SEIJI ITANO" userId="d14abaad31e2099c" providerId="LiveId" clId="{E65C1499-9051-4DCE-8995-C0AE10CD6F54}" dt="2023-06-26T06:56:46.185" v="159" actId="1076"/>
          <ac:spMkLst>
            <pc:docMk/>
            <pc:sldMk cId="2089187721" sldId="258"/>
            <ac:spMk id="2" creationId="{DF8F86F5-966F-9513-9EAC-FE79545C43C9}"/>
          </ac:spMkLst>
        </pc:spChg>
        <pc:graphicFrameChg chg="add del mod">
          <ac:chgData name="SEIJI ITANO" userId="d14abaad31e2099c" providerId="LiveId" clId="{E65C1499-9051-4DCE-8995-C0AE10CD6F54}" dt="2023-06-26T05:59:42.231" v="11"/>
          <ac:graphicFrameMkLst>
            <pc:docMk/>
            <pc:sldMk cId="2089187721" sldId="258"/>
            <ac:graphicFrameMk id="3" creationId="{A3C21F1E-2E9E-0792-ABC0-712D4457C4DD}"/>
          </ac:graphicFrameMkLst>
        </pc:graphicFrameChg>
        <pc:graphicFrameChg chg="del mod modGraphic">
          <ac:chgData name="SEIJI ITANO" userId="d14abaad31e2099c" providerId="LiveId" clId="{E65C1499-9051-4DCE-8995-C0AE10CD6F54}" dt="2023-06-26T06:13:40.434" v="116" actId="478"/>
          <ac:graphicFrameMkLst>
            <pc:docMk/>
            <pc:sldMk cId="2089187721" sldId="258"/>
            <ac:graphicFrameMk id="6" creationId="{647F7E30-80FD-4CFC-B3EA-6FA0814B7B06}"/>
          </ac:graphicFrameMkLst>
        </pc:graphicFrameChg>
        <pc:graphicFrameChg chg="add del">
          <ac:chgData name="SEIJI ITANO" userId="d14abaad31e2099c" providerId="LiveId" clId="{E65C1499-9051-4DCE-8995-C0AE10CD6F54}" dt="2023-06-26T06:13:56.251" v="118"/>
          <ac:graphicFrameMkLst>
            <pc:docMk/>
            <pc:sldMk cId="2089187721" sldId="258"/>
            <ac:graphicFrameMk id="7" creationId="{654F8A00-55C4-89A7-B3AB-64AE9EF69130}"/>
          </ac:graphicFrameMkLst>
        </pc:graphicFrameChg>
        <pc:graphicFrameChg chg="add del modGraphic">
          <ac:chgData name="SEIJI ITANO" userId="d14abaad31e2099c" providerId="LiveId" clId="{E65C1499-9051-4DCE-8995-C0AE10CD6F54}" dt="2023-06-26T06:14:14.448" v="122"/>
          <ac:graphicFrameMkLst>
            <pc:docMk/>
            <pc:sldMk cId="2089187721" sldId="258"/>
            <ac:graphicFrameMk id="8" creationId="{19BA2485-9780-13B7-6CDB-1AB631565C7D}"/>
          </ac:graphicFrameMkLst>
        </pc:graphicFrameChg>
        <pc:graphicFrameChg chg="add del mod">
          <ac:chgData name="SEIJI ITANO" userId="d14abaad31e2099c" providerId="LiveId" clId="{E65C1499-9051-4DCE-8995-C0AE10CD6F54}" dt="2023-06-26T06:14:28.337" v="126"/>
          <ac:graphicFrameMkLst>
            <pc:docMk/>
            <pc:sldMk cId="2089187721" sldId="258"/>
            <ac:graphicFrameMk id="9" creationId="{F4697DCC-9944-3C8F-5C78-83B9FE5DC152}"/>
          </ac:graphicFrameMkLst>
        </pc:graphicFrameChg>
        <pc:graphicFrameChg chg="add del mod">
          <ac:chgData name="SEIJI ITANO" userId="d14abaad31e2099c" providerId="LiveId" clId="{E65C1499-9051-4DCE-8995-C0AE10CD6F54}" dt="2023-06-26T06:14:31.423" v="130"/>
          <ac:graphicFrameMkLst>
            <pc:docMk/>
            <pc:sldMk cId="2089187721" sldId="258"/>
            <ac:graphicFrameMk id="10" creationId="{60AADC12-6584-4BF1-542C-141EA26232F4}"/>
          </ac:graphicFrameMkLst>
        </pc:graphicFrameChg>
        <pc:graphicFrameChg chg="add mod">
          <ac:chgData name="SEIJI ITANO" userId="d14abaad31e2099c" providerId="LiveId" clId="{E65C1499-9051-4DCE-8995-C0AE10CD6F54}" dt="2023-06-26T06:56:51.977" v="160" actId="1076"/>
          <ac:graphicFrameMkLst>
            <pc:docMk/>
            <pc:sldMk cId="2089187721" sldId="258"/>
            <ac:graphicFrameMk id="11" creationId="{9114C31B-B77C-1CDD-1FF7-79D13507905F}"/>
          </ac:graphicFrameMkLst>
        </pc:graphicFrameChg>
        <pc:picChg chg="add del mod">
          <ac:chgData name="SEIJI ITANO" userId="d14abaad31e2099c" providerId="LiveId" clId="{E65C1499-9051-4DCE-8995-C0AE10CD6F54}" dt="2023-06-26T06:12:12.521" v="115" actId="478"/>
          <ac:picMkLst>
            <pc:docMk/>
            <pc:sldMk cId="2089187721" sldId="258"/>
            <ac:picMk id="5" creationId="{AAC19D22-49A7-C332-D677-9910A8E93792}"/>
          </ac:picMkLst>
        </pc:picChg>
      </pc:sldChg>
    </pc:docChg>
  </pc:docChgLst>
  <pc:docChgLst>
    <pc:chgData name="板野 精之" userId="d14abaad31e2099c" providerId="LiveId" clId="{8B0FF174-BFE3-4A8C-A981-8712ABF9DEC3}"/>
    <pc:docChg chg="undo custSel modSld">
      <pc:chgData name="板野 精之" userId="d14abaad31e2099c" providerId="LiveId" clId="{8B0FF174-BFE3-4A8C-A981-8712ABF9DEC3}" dt="2023-03-15T09:48:10.993" v="48" actId="20577"/>
      <pc:docMkLst>
        <pc:docMk/>
      </pc:docMkLst>
      <pc:sldChg chg="modSp mod">
        <pc:chgData name="板野 精之" userId="d14abaad31e2099c" providerId="LiveId" clId="{8B0FF174-BFE3-4A8C-A981-8712ABF9DEC3}" dt="2023-03-15T09:48:10.993" v="48" actId="20577"/>
        <pc:sldMkLst>
          <pc:docMk/>
          <pc:sldMk cId="2006302855" sldId="256"/>
        </pc:sldMkLst>
        <pc:spChg chg="mod">
          <ac:chgData name="板野 精之" userId="d14abaad31e2099c" providerId="LiveId" clId="{8B0FF174-BFE3-4A8C-A981-8712ABF9DEC3}" dt="2023-03-15T05:14:02.865" v="28" actId="20577"/>
          <ac:spMkLst>
            <pc:docMk/>
            <pc:sldMk cId="2006302855" sldId="256"/>
            <ac:spMk id="4" creationId="{9A61A6A7-9D44-173A-CE81-E8A2C380BA1F}"/>
          </ac:spMkLst>
        </pc:spChg>
        <pc:spChg chg="mod">
          <ac:chgData name="板野 精之" userId="d14abaad31e2099c" providerId="LiveId" clId="{8B0FF174-BFE3-4A8C-A981-8712ABF9DEC3}" dt="2023-03-15T05:13:35.548" v="5"/>
          <ac:spMkLst>
            <pc:docMk/>
            <pc:sldMk cId="2006302855" sldId="256"/>
            <ac:spMk id="8" creationId="{665BF0CC-9744-2A4D-F325-D7210216AD98}"/>
          </ac:spMkLst>
        </pc:spChg>
        <pc:spChg chg="mod">
          <ac:chgData name="板野 精之" userId="d14abaad31e2099c" providerId="LiveId" clId="{8B0FF174-BFE3-4A8C-A981-8712ABF9DEC3}" dt="2023-03-15T09:48:10.993" v="48" actId="20577"/>
          <ac:spMkLst>
            <pc:docMk/>
            <pc:sldMk cId="2006302855" sldId="256"/>
            <ac:spMk id="23" creationId="{56BE33CE-F2BF-EA91-44D9-8E72ECFDC65C}"/>
          </ac:spMkLst>
        </pc:spChg>
      </pc:sldChg>
      <pc:sldChg chg="modSp mod">
        <pc:chgData name="板野 精之" userId="d14abaad31e2099c" providerId="LiveId" clId="{8B0FF174-BFE3-4A8C-A981-8712ABF9DEC3}" dt="2023-03-15T09:48:06.139" v="44" actId="20577"/>
        <pc:sldMkLst>
          <pc:docMk/>
          <pc:sldMk cId="1840233059" sldId="257"/>
        </pc:sldMkLst>
        <pc:spChg chg="mod">
          <ac:chgData name="板野 精之" userId="d14abaad31e2099c" providerId="LiveId" clId="{8B0FF174-BFE3-4A8C-A981-8712ABF9DEC3}" dt="2023-03-15T05:13:43.342" v="7" actId="20577"/>
          <ac:spMkLst>
            <pc:docMk/>
            <pc:sldMk cId="1840233059" sldId="257"/>
            <ac:spMk id="70" creationId="{45952E7A-BB87-9EB7-CCBB-B9FD15742604}"/>
          </ac:spMkLst>
        </pc:spChg>
        <pc:spChg chg="mod">
          <ac:chgData name="板野 精之" userId="d14abaad31e2099c" providerId="LiveId" clId="{8B0FF174-BFE3-4A8C-A981-8712ABF9DEC3}" dt="2023-03-15T09:48:06.139" v="44" actId="20577"/>
          <ac:spMkLst>
            <pc:docMk/>
            <pc:sldMk cId="1840233059" sldId="257"/>
            <ac:spMk id="74" creationId="{05CA9071-7FFD-6AE6-6D1E-286988F05D42}"/>
          </ac:spMkLst>
        </pc:spChg>
      </pc:sldChg>
      <pc:sldChg chg="modSp mod">
        <pc:chgData name="板野 精之" userId="d14abaad31e2099c" providerId="LiveId" clId="{8B0FF174-BFE3-4A8C-A981-8712ABF9DEC3}" dt="2023-03-15T09:47:56.265" v="40" actId="6549"/>
        <pc:sldMkLst>
          <pc:docMk/>
          <pc:sldMk cId="2089187721" sldId="258"/>
        </pc:sldMkLst>
        <pc:graphicFrameChg chg="mod modGraphic">
          <ac:chgData name="板野 精之" userId="d14abaad31e2099c" providerId="LiveId" clId="{8B0FF174-BFE3-4A8C-A981-8712ABF9DEC3}" dt="2023-03-15T09:47:56.265" v="40" actId="6549"/>
          <ac:graphicFrameMkLst>
            <pc:docMk/>
            <pc:sldMk cId="2089187721" sldId="258"/>
            <ac:graphicFrameMk id="6" creationId="{647F7E30-80FD-4CFC-B3EA-6FA0814B7B06}"/>
          </ac:graphicFrameMkLst>
        </pc:graphicFrameChg>
      </pc:sldChg>
    </pc:docChg>
  </pc:docChgLst>
  <pc:docChgLst>
    <pc:chgData name="板野 精之" userId="d14abaad31e2099c" providerId="LiveId" clId="{5117EBF9-BC1A-4141-ACF3-7868CA0F338E}"/>
    <pc:docChg chg="undo redo custSel delSld modSld">
      <pc:chgData name="板野 精之" userId="d14abaad31e2099c" providerId="LiveId" clId="{5117EBF9-BC1A-4141-ACF3-7868CA0F338E}" dt="2023-03-28T06:16:49.660" v="234" actId="47"/>
      <pc:docMkLst>
        <pc:docMk/>
      </pc:docMkLst>
      <pc:sldChg chg="addSp modSp del mod">
        <pc:chgData name="板野 精之" userId="d14abaad31e2099c" providerId="LiveId" clId="{5117EBF9-BC1A-4141-ACF3-7868CA0F338E}" dt="2023-03-28T06:16:48.885" v="233" actId="47"/>
        <pc:sldMkLst>
          <pc:docMk/>
          <pc:sldMk cId="2006302855" sldId="256"/>
        </pc:sldMkLst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" creationId="{DF5DE08D-2C10-7187-F3F4-8CCCD7B9DE47}"/>
          </ac:spMkLst>
        </pc:spChg>
        <pc:spChg chg="mod">
          <ac:chgData name="板野 精之" userId="d14abaad31e2099c" providerId="LiveId" clId="{5117EBF9-BC1A-4141-ACF3-7868CA0F338E}" dt="2023-03-10T02:22:54.461" v="232" actId="14100"/>
          <ac:spMkLst>
            <pc:docMk/>
            <pc:sldMk cId="2006302855" sldId="256"/>
            <ac:spMk id="4" creationId="{9A61A6A7-9D44-173A-CE81-E8A2C380BA1F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5" creationId="{261682A1-65E3-3C27-942B-967B08F8D0DA}"/>
          </ac:spMkLst>
        </pc:spChg>
        <pc:spChg chg="mod">
          <ac:chgData name="板野 精之" userId="d14abaad31e2099c" providerId="LiveId" clId="{5117EBF9-BC1A-4141-ACF3-7868CA0F338E}" dt="2023-03-07T07:03:12.497" v="210" actId="2711"/>
          <ac:spMkLst>
            <pc:docMk/>
            <pc:sldMk cId="2006302855" sldId="256"/>
            <ac:spMk id="6" creationId="{E7B0B3AC-E0C8-B797-5539-BC8CF792274E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7" creationId="{54CFF207-1693-EBA3-B840-F3F635A0897E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8" creationId="{665BF0CC-9744-2A4D-F325-D7210216AD9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9" creationId="{1A5B3472-D08A-9E8E-BF2A-9A9AF51438DA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1" creationId="{84196AF8-409E-3F41-7220-34EB9F057776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" creationId="{7197534B-C8E8-3C34-12C4-1BAE2748DD0B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5" creationId="{312B6B05-97DC-7CCE-F981-C4BBC8C49002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7" creationId="{6DFCEFAD-9AD9-CCE8-E98B-49CD701C0DFD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9" creationId="{91304808-5A36-1FB3-FB7A-9E7BEEEBE3F5}"/>
          </ac:spMkLst>
        </pc:spChg>
        <pc:spChg chg="mod">
          <ac:chgData name="板野 精之" userId="d14abaad31e2099c" providerId="LiveId" clId="{5117EBF9-BC1A-4141-ACF3-7868CA0F338E}" dt="2023-03-07T07:03:12.497" v="210" actId="2711"/>
          <ac:spMkLst>
            <pc:docMk/>
            <pc:sldMk cId="2006302855" sldId="256"/>
            <ac:spMk id="23" creationId="{56BE33CE-F2BF-EA91-44D9-8E72ECFDC65C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4" creationId="{922809A6-06A0-5CD3-4AD4-3910CD658BBC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5" creationId="{CD5B3E25-298B-211D-0F4B-5E318121E216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7" creationId="{0FB3B172-A46A-BD32-379D-10A121FDCE80}"/>
          </ac:spMkLst>
        </pc:spChg>
        <pc:spChg chg="add mod">
          <ac:chgData name="板野 精之" userId="d14abaad31e2099c" providerId="LiveId" clId="{5117EBF9-BC1A-4141-ACF3-7868CA0F338E}" dt="2023-03-07T06:07:29.736" v="140" actId="404"/>
          <ac:spMkLst>
            <pc:docMk/>
            <pc:sldMk cId="2006302855" sldId="256"/>
            <ac:spMk id="28" creationId="{124FAE53-D30A-C362-5373-1D486E191ACC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3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4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50" creationId="{F8CDFC9D-4E3B-5328-CF6A-11243A12EBBD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56" creationId="{4A99A513-2870-2C9E-3042-C5E737CD2011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60" creationId="{4415A826-DA17-1E81-078C-882B726FD636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62" creationId="{68B1E038-FA73-C01C-23C6-0673CECA1FD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64" creationId="{A245A53C-85AC-0258-8502-68EA87007AD9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66" creationId="{BBE72BD2-C0AE-2DD9-A5CE-A6840898D8E7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68" creationId="{8231A80A-BBFE-6BAD-4D91-91BA9D97C387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70" creationId="{90AA1A3C-7F65-82BD-EF15-49B4ACED1197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76" creationId="{E9987302-19FE-5AB3-F1E7-B8238316870F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78" creationId="{BF6FDDBA-4AA6-11A2-7F4C-F8B3175C40E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93" creationId="{949AE8E2-9782-456F-20C9-D17E9FDEAC42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95" creationId="{F6ED617E-118F-24B9-2629-92BFD171A0E7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06" creationId="{8A750E44-B705-1CDF-CEDC-A2E20E5CFA6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08" creationId="{4C2CD8AD-0631-8CDA-C8E5-77FA1060713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10" creationId="{B0976ED5-039C-4A9C-CCE9-88AA8C82B191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12" creationId="{002ACE40-ED01-8168-DEF6-31301D72B6E1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21" creationId="{5D940463-A728-2B88-FC86-8E47ED7DF4CE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23" creationId="{4230F059-FAB2-0ABD-451D-674BF7D952E1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26" creationId="{1A6BA960-9429-0079-D10B-87366CE237D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27" creationId="{DBC009C5-7650-5540-4A28-142066D85863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3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49" creationId="{150BF04B-EB7C-EE7F-F582-8A429DC61816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53" creationId="{7DD7A3D9-8961-4A0D-5349-0FF7FEBE9FC9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57" creationId="{0380351B-3BF2-172E-500A-B3ADF6C3CEE5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63" creationId="{E8E9BE25-569C-4104-42FD-658889FF0C59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69" creationId="{A63F23F2-5976-F83E-CEF8-35BDF223B2D5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75" creationId="{B32E9932-705A-B27D-2DF5-ED678011064F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81" creationId="{AC4B1ECB-6DA4-BC96-72AC-50E0994BDFB4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85" creationId="{1B69EA43-8E2A-5CF2-8D7B-71E803C9F27A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188" creationId="{18D521D3-3F24-D9E0-0CDF-22C22D3F9D8B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06" creationId="{940CF3C7-7C32-E07C-4F5B-950C04B9878F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08" creationId="{A8B60085-3584-152B-8041-A64EE589F56E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10" creationId="{2B49559C-9944-BDA2-76B6-2FEF3AA48613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12" creationId="{466AC667-DAF4-B9A3-F58A-8906204DA6E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14" creationId="{4BD090C1-51D9-0438-15AD-C8D609364016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16" creationId="{9E0F1E04-7C68-E52A-70E4-DB2F60EA6024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19" creationId="{2073E597-FBE7-0F24-FC4D-4DDE5EEF386C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22" creationId="{7BE23562-F486-9D99-A795-EA3632469665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25" creationId="{EFB36824-6F9C-ADA9-7384-D95BD7270D4B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28" creationId="{DF271C03-EEFD-7206-5BF4-CEEDDB26ECBB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31" creationId="{322DB717-2025-BF96-D5FC-2C80337C0EAB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34" creationId="{6D14BDE7-FD74-73AA-C026-ECD3CEB03183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37" creationId="{857D3637-8DC8-BB7C-DFD9-BB7B25A3B707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40" creationId="{208BA281-3C2E-C599-0144-8A01B06B6912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43" creationId="{AB1F5712-27DA-D17B-80D5-A99BD5538727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46" creationId="{BA103975-9E4E-1214-FD44-D7A960DC5A3D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49" creationId="{BA946725-5406-BA52-745D-CCF276B9BDDA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52" creationId="{7ADDF1AC-063A-C9A6-76EC-D38B79D9FB0C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60" creationId="{22115C42-6609-AB37-2AD2-9FD6C4B0A4B5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62" creationId="{50BD7C07-8047-5587-5276-973D878B000E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64" creationId="{864A04EE-1A36-EEA0-99FF-031823097EB0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66" creationId="{CCDA4E1C-ADD7-28E1-9BAD-F22245B38635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68" creationId="{7E74E2CD-03CF-BBCB-F832-5A088F27F6E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70" creationId="{6EF9C3F7-DC64-DBE2-C345-AAAE20D2B5B8}"/>
          </ac:spMkLst>
        </pc:spChg>
        <pc:spChg chg="mod">
          <ac:chgData name="板野 精之" userId="d14abaad31e2099c" providerId="LiveId" clId="{5117EBF9-BC1A-4141-ACF3-7868CA0F338E}" dt="2023-03-07T06:09:17.854" v="160" actId="2711"/>
          <ac:spMkLst>
            <pc:docMk/>
            <pc:sldMk cId="2006302855" sldId="256"/>
            <ac:spMk id="272" creationId="{ED28669E-36A2-671D-D6BE-318D1B6D7AF5}"/>
          </ac:spMkLst>
        </pc:s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6" creationId="{6A120EE0-7A08-5CA9-B04B-E4DB38A18185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58" creationId="{3153281E-5C24-BA20-49B1-5D37ED65D41A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85" creationId="{12E831B6-D9D8-C60C-68A8-B1B19D47A6B1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73" creationId="{CA973896-DBFE-AD85-1B3F-99262FE89B5F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74" creationId="{872C2FAA-916E-0260-D66C-4C8B3B3B6E5F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75" creationId="{BABA9753-7E46-A053-E296-D4AE78D7CD5D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76" creationId="{48E85DBB-2D94-46A5-6BC8-8BA636B879FE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77" creationId="{EC6888E7-456A-9108-7674-4D7E79E8BF2E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278" creationId="{513327E0-F838-F105-CED0-833DB58582EA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301" creationId="{A4972AB9-9311-FD55-8EBF-74C81223665C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302" creationId="{EC2DA641-EE1E-B92C-F62C-2D24CB9D2D91}"/>
          </ac:grpSpMkLst>
        </pc:grpChg>
        <pc:grpChg chg="mod">
          <ac:chgData name="板野 精之" userId="d14abaad31e2099c" providerId="LiveId" clId="{5117EBF9-BC1A-4141-ACF3-7868CA0F338E}" dt="2023-03-07T06:09:17.854" v="160" actId="2711"/>
          <ac:grpSpMkLst>
            <pc:docMk/>
            <pc:sldMk cId="2006302855" sldId="256"/>
            <ac:grpSpMk id="303" creationId="{A03DDE05-E719-8D41-FDB0-FA11C079186A}"/>
          </ac:grpSpMkLst>
        </pc:grp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12" creationId="{E93161CD-7FE6-2F7A-2D82-BC13E0C8C206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14" creationId="{3312100E-E3F7-2DDF-5C0D-61918084F8E1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16" creationId="{B0E79934-FA2A-BED2-EB90-3BD81C4D76F1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18" creationId="{2D192F7B-3401-4227-C382-87F5993E2E87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20" creationId="{BE4B8213-DDEA-5E79-02F1-7E07BE91523E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21" creationId="{AC9D4243-D3F9-2817-96AE-6EA6B5B64978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22" creationId="{2A78B822-7C0B-D641-09B6-A2AC5D55D901}"/>
          </ac:cxnSpMkLst>
        </pc:cxnChg>
        <pc:cxnChg chg="mod">
          <ac:chgData name="板野 精之" userId="d14abaad31e2099c" providerId="LiveId" clId="{5117EBF9-BC1A-4141-ACF3-7868CA0F338E}" dt="2023-03-07T06:09:17.854" v="160" actId="2711"/>
          <ac:cxnSpMkLst>
            <pc:docMk/>
            <pc:sldMk cId="2006302855" sldId="256"/>
            <ac:cxnSpMk id="80" creationId="{EF0AB75F-8A88-26B6-E54A-81E1F413F355}"/>
          </ac:cxnSpMkLst>
        </pc:cxnChg>
      </pc:sldChg>
      <pc:sldChg chg="addSp delSp modSp del mod">
        <pc:chgData name="板野 精之" userId="d14abaad31e2099c" providerId="LiveId" clId="{5117EBF9-BC1A-4141-ACF3-7868CA0F338E}" dt="2023-03-28T06:16:49.660" v="234" actId="47"/>
        <pc:sldMkLst>
          <pc:docMk/>
          <pc:sldMk cId="1840233059" sldId="257"/>
        </pc:sldMkLst>
        <pc:spChg chg="add mod">
          <ac:chgData name="板野 精之" userId="d14abaad31e2099c" providerId="LiveId" clId="{5117EBF9-BC1A-4141-ACF3-7868CA0F338E}" dt="2023-03-07T06:07:42.829" v="143"/>
          <ac:spMkLst>
            <pc:docMk/>
            <pc:sldMk cId="1840233059" sldId="257"/>
            <ac:spMk id="4" creationId="{1BE5F442-4C1C-56BE-D19B-1A06BC20C6AE}"/>
          </ac:spMkLst>
        </pc:spChg>
        <pc:spChg chg="del">
          <ac:chgData name="板野 精之" userId="d14abaad31e2099c" providerId="LiveId" clId="{5117EBF9-BC1A-4141-ACF3-7868CA0F338E}" dt="2023-03-07T06:08:36.273" v="156" actId="478"/>
          <ac:spMkLst>
            <pc:docMk/>
            <pc:sldMk cId="1840233059" sldId="257"/>
            <ac:spMk id="5" creationId="{ACE57591-480D-A2EB-97A9-8B715C3FED4A}"/>
          </ac:spMkLst>
        </pc:spChg>
        <pc:spChg chg="del">
          <ac:chgData name="板野 精之" userId="d14abaad31e2099c" providerId="LiveId" clId="{5117EBF9-BC1A-4141-ACF3-7868CA0F338E}" dt="2023-03-07T06:07:42.041" v="142" actId="478"/>
          <ac:spMkLst>
            <pc:docMk/>
            <pc:sldMk cId="1840233059" sldId="257"/>
            <ac:spMk id="6" creationId="{DBC009C5-7650-5540-4A28-142066D85863}"/>
          </ac:spMkLst>
        </pc:spChg>
        <pc:spChg chg="add mod">
          <ac:chgData name="板野 精之" userId="d14abaad31e2099c" providerId="LiveId" clId="{5117EBF9-BC1A-4141-ACF3-7868CA0F338E}" dt="2023-03-07T06:07:50.729" v="146" actId="20577"/>
          <ac:spMkLst>
            <pc:docMk/>
            <pc:sldMk cId="1840233059" sldId="257"/>
            <ac:spMk id="10" creationId="{A333ED3D-ECBF-7A99-5656-81BFF3372F49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11" creationId="{3D45A446-8E7E-B512-C67D-E3F8EEE41631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12" creationId="{3624960D-FDFA-8D6F-0857-6281D8506E0B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13" creationId="{7F54CFBC-EEBB-96B6-2F5C-C5DAB949A85B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14" creationId="{8DB4B6D2-F886-D755-900F-83A07FBDE44E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15" creationId="{0EDE821A-A299-95BC-2255-1D7017DD30BB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16" creationId="{0E42E1A6-4E26-234C-7068-9E4BAAC32F93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1" creationId="{F33A15B1-E2E2-FFFA-4955-41F5540F05AB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3" creationId="{B06BFBB6-8C91-D187-7DBC-84307267E58B}"/>
          </ac:spMkLst>
        </pc:spChg>
        <pc:spChg chg="mod topLvl">
          <ac:chgData name="板野 精之" userId="d14abaad31e2099c" providerId="LiveId" clId="{5117EBF9-BC1A-4141-ACF3-7868CA0F338E}" dt="2023-03-10T02:22:49.363" v="231" actId="14100"/>
          <ac:spMkLst>
            <pc:docMk/>
            <pc:sldMk cId="1840233059" sldId="257"/>
            <ac:spMk id="24" creationId="{0C021420-5FA4-10B5-007D-0B2349AADB9F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" creationId="{651593F3-9C14-AF60-6F72-2AF59EBC364C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" creationId="{E2464B40-0D81-A4E2-7217-7CBDAE4A6C97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7" creationId="{BECCB792-7881-2F4A-CFA7-08941F38E9E7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9" creationId="{BD990A78-908D-78C0-5897-5E1412FE087E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30" creationId="{30D7D3FC-5116-AA05-8156-FE2769A35282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1" creationId="{67E4CF6C-EBA4-8F22-F662-CEFB8EE0DE66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38" creationId="{0BA7E8B2-45DA-0F1C-EB85-1738304821E7}"/>
          </ac:spMkLst>
        </pc:spChg>
        <pc:spChg chg="del">
          <ac:chgData name="板野 精之" userId="d14abaad31e2099c" providerId="LiveId" clId="{5117EBF9-BC1A-4141-ACF3-7868CA0F338E}" dt="2023-03-07T06:08:13.418" v="147" actId="478"/>
          <ac:spMkLst>
            <pc:docMk/>
            <pc:sldMk cId="1840233059" sldId="257"/>
            <ac:spMk id="39" creationId="{5E1FDB3A-078D-94E3-2665-52D76CA2FD05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40" creationId="{072D6AAB-0238-8AE5-B39A-D5B0542B19B1}"/>
          </ac:spMkLst>
        </pc:spChg>
        <pc:spChg chg="del">
          <ac:chgData name="板野 精之" userId="d14abaad31e2099c" providerId="LiveId" clId="{5117EBF9-BC1A-4141-ACF3-7868CA0F338E}" dt="2023-03-07T06:08:19.218" v="151" actId="478"/>
          <ac:spMkLst>
            <pc:docMk/>
            <pc:sldMk cId="1840233059" sldId="257"/>
            <ac:spMk id="41" creationId="{FFFA9C9B-F071-F431-7668-421CBFDFED37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42" creationId="{D57F0AFF-0AD0-7AC8-2BCB-A6F9C9E34793}"/>
          </ac:spMkLst>
        </pc:spChg>
        <pc:spChg chg="del">
          <ac:chgData name="板野 精之" userId="d14abaad31e2099c" providerId="LiveId" clId="{5117EBF9-BC1A-4141-ACF3-7868CA0F338E}" dt="2023-03-07T06:08:16.187" v="149" actId="478"/>
          <ac:spMkLst>
            <pc:docMk/>
            <pc:sldMk cId="1840233059" sldId="257"/>
            <ac:spMk id="43" creationId="{18384BB5-CEE5-BC2A-BF38-050E23033199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44" creationId="{FFE251A1-A7B0-992A-3A9F-9EEC362A977E}"/>
          </ac:spMkLst>
        </pc:spChg>
        <pc:spChg chg="del">
          <ac:chgData name="板野 精之" userId="d14abaad31e2099c" providerId="LiveId" clId="{5117EBF9-BC1A-4141-ACF3-7868CA0F338E}" dt="2023-03-07T06:08:17.496" v="150" actId="478"/>
          <ac:spMkLst>
            <pc:docMk/>
            <pc:sldMk cId="1840233059" sldId="257"/>
            <ac:spMk id="45" creationId="{77E7F0E5-A3A4-9A8D-96A2-5E3A3BA1CB4A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46" creationId="{440E99C3-532A-BBC9-2781-78E42515972B}"/>
          </ac:spMkLst>
        </pc:spChg>
        <pc:spChg chg="del">
          <ac:chgData name="板野 精之" userId="d14abaad31e2099c" providerId="LiveId" clId="{5117EBF9-BC1A-4141-ACF3-7868CA0F338E}" dt="2023-03-07T06:08:14.786" v="148" actId="478"/>
          <ac:spMkLst>
            <pc:docMk/>
            <pc:sldMk cId="1840233059" sldId="257"/>
            <ac:spMk id="47" creationId="{85B9BF24-FF4A-F21E-8E20-419E72806C41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4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4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5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6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6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6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6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6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65" creationId="{F395A6BD-46C9-BCA2-A454-B0F320BE58CF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66" creationId="{00000000-0000-0000-0000-000000000000}"/>
          </ac:spMkLst>
        </pc:spChg>
        <pc:spChg chg="del">
          <ac:chgData name="板野 精之" userId="d14abaad31e2099c" providerId="LiveId" clId="{5117EBF9-BC1A-4141-ACF3-7868CA0F338E}" dt="2023-03-07T06:08:22.304" v="153" actId="478"/>
          <ac:spMkLst>
            <pc:docMk/>
            <pc:sldMk cId="1840233059" sldId="257"/>
            <ac:spMk id="67" creationId="{EAC5493F-8E19-167B-411F-9C43F3CDBBA6}"/>
          </ac:spMkLst>
        </pc:spChg>
        <pc:spChg chg="mod">
          <ac:chgData name="板野 精之" userId="d14abaad31e2099c" providerId="LiveId" clId="{5117EBF9-BC1A-4141-ACF3-7868CA0F338E}" dt="2023-03-07T06:57:37.456" v="162" actId="2711"/>
          <ac:spMkLst>
            <pc:docMk/>
            <pc:sldMk cId="1840233059" sldId="257"/>
            <ac:spMk id="68" creationId="{4E359445-1B43-6636-9AF8-3BE55C81F9FA}"/>
          </ac:spMkLst>
        </pc:spChg>
        <pc:spChg chg="del">
          <ac:chgData name="板野 精之" userId="d14abaad31e2099c" providerId="LiveId" clId="{5117EBF9-BC1A-4141-ACF3-7868CA0F338E}" dt="2023-03-07T06:08:23.673" v="154" actId="478"/>
          <ac:spMkLst>
            <pc:docMk/>
            <pc:sldMk cId="1840233059" sldId="257"/>
            <ac:spMk id="69" creationId="{E1C8FBC8-16F8-9571-A5FE-2FC0737E06AB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70" creationId="{45952E7A-BB87-9EB7-CCBB-B9FD15742604}"/>
          </ac:spMkLst>
        </pc:spChg>
        <pc:spChg chg="del">
          <ac:chgData name="板野 精之" userId="d14abaad31e2099c" providerId="LiveId" clId="{5117EBF9-BC1A-4141-ACF3-7868CA0F338E}" dt="2023-03-07T06:08:20.444" v="152" actId="478"/>
          <ac:spMkLst>
            <pc:docMk/>
            <pc:sldMk cId="1840233059" sldId="257"/>
            <ac:spMk id="71" creationId="{B7A1B9C8-C862-1EDC-2370-45981E68C3D7}"/>
          </ac:spMkLst>
        </pc:spChg>
        <pc:spChg chg="add mod">
          <ac:chgData name="板野 精之" userId="d14abaad31e2099c" providerId="LiveId" clId="{5117EBF9-BC1A-4141-ACF3-7868CA0F338E}" dt="2023-03-07T06:08:24.746" v="155"/>
          <ac:spMkLst>
            <pc:docMk/>
            <pc:sldMk cId="1840233059" sldId="257"/>
            <ac:spMk id="72" creationId="{F18D887F-6B13-75D8-AA22-AB1333AC836D}"/>
          </ac:spMkLst>
        </pc:spChg>
        <pc:spChg chg="add mod">
          <ac:chgData name="板野 精之" userId="d14abaad31e2099c" providerId="LiveId" clId="{5117EBF9-BC1A-4141-ACF3-7868CA0F338E}" dt="2023-03-07T07:03:03.628" v="209" actId="2711"/>
          <ac:spMkLst>
            <pc:docMk/>
            <pc:sldMk cId="1840233059" sldId="257"/>
            <ac:spMk id="73" creationId="{8481B0F2-3616-69CF-856C-4C7BCB0293B4}"/>
          </ac:spMkLst>
        </pc:spChg>
        <pc:spChg chg="add mod">
          <ac:chgData name="板野 精之" userId="d14abaad31e2099c" providerId="LiveId" clId="{5117EBF9-BC1A-4141-ACF3-7868CA0F338E}" dt="2023-03-07T07:03:03.628" v="209" actId="2711"/>
          <ac:spMkLst>
            <pc:docMk/>
            <pc:sldMk cId="1840233059" sldId="257"/>
            <ac:spMk id="74" creationId="{05CA9071-7FFD-6AE6-6D1E-286988F05D42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44" creationId="{47D3D483-104A-0882-E68A-8C1E40222E0C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7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18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5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6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7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7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7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7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0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1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2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3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4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5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6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7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8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89" creationId="{00000000-0000-0000-0000-0000000000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90" creationId="{18157406-2A95-6C60-5356-DBE445B532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298" creationId="{A3C52AB5-0A4B-FE1F-E0DC-09440F3D5DC3}"/>
          </ac:spMkLst>
        </pc:spChg>
        <pc:spChg chg="del">
          <ac:chgData name="板野 精之" userId="d14abaad31e2099c" providerId="LiveId" clId="{5117EBF9-BC1A-4141-ACF3-7868CA0F338E}" dt="2023-03-07T06:08:38.520" v="157" actId="478"/>
          <ac:spMkLst>
            <pc:docMk/>
            <pc:sldMk cId="1840233059" sldId="257"/>
            <ac:spMk id="299" creationId="{86953137-9A11-CAE7-D8E0-5062E2E561F6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07" creationId="{18157406-2A95-6C60-5356-DBE445B532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08" creationId="{A3C52AB5-0A4B-FE1F-E0DC-09440F3D5DC3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0" creationId="{18157406-2A95-6C60-5356-DBE445B53200}"/>
          </ac:spMkLst>
        </pc:spChg>
        <pc:spChg chg="mod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1" creationId="{A3C52AB5-0A4B-FE1F-E0DC-09440F3D5DC3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5" creationId="{18157406-2A95-6C60-5356-DBE445B53200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6" creationId="{A3C52AB5-0A4B-FE1F-E0DC-09440F3D5DC3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7" creationId="{18157406-2A95-6C60-5356-DBE445B53200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8" creationId="{A3C52AB5-0A4B-FE1F-E0DC-09440F3D5DC3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49" creationId="{18157406-2A95-6C60-5356-DBE445B53200}"/>
          </ac:spMkLst>
        </pc:spChg>
        <pc:spChg chg="mod topLvl">
          <ac:chgData name="板野 精之" userId="d14abaad31e2099c" providerId="LiveId" clId="{5117EBF9-BC1A-4141-ACF3-7868CA0F338E}" dt="2023-03-07T06:57:20.534" v="161" actId="165"/>
          <ac:spMkLst>
            <pc:docMk/>
            <pc:sldMk cId="1840233059" sldId="257"/>
            <ac:spMk id="350" creationId="{A3C52AB5-0A4B-FE1F-E0DC-09440F3D5DC3}"/>
          </ac:spMkLst>
        </pc:spChg>
        <pc:grpChg chg="del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2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8" creationId="{5013C80D-0361-01FE-709B-A7251E196917}"/>
          </ac:grpSpMkLst>
        </pc:grpChg>
        <pc:grpChg chg="mod topLvl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9" creationId="{238B73A2-4293-AE14-D370-766F77520C16}"/>
          </ac:grpSpMkLst>
        </pc:grpChg>
        <pc:grpChg chg="mod topLvl">
          <ac:chgData name="板野 精之" userId="d14abaad31e2099c" providerId="LiveId" clId="{5117EBF9-BC1A-4141-ACF3-7868CA0F338E}" dt="2023-03-07T06:57:37.456" v="162" actId="2711"/>
          <ac:grpSpMkLst>
            <pc:docMk/>
            <pc:sldMk cId="1840233059" sldId="257"/>
            <ac:grpSpMk id="28" creationId="{BE3B0837-6E40-BB92-EB38-DB0E0A5BB24A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2" creationId="{3DEB80BE-A815-0584-9ABA-EAA4009DBAA3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" creationId="{B50663DB-C7B4-3B6B-710D-1750691B1944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4" creationId="{0C19F746-D1B6-260C-8A1E-FEA168AB4801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5" creationId="{18C64BD2-E93D-513C-9B56-CBDB4B6D821F}"/>
          </ac:grpSpMkLst>
        </pc:grpChg>
        <pc:grpChg chg="mod topLvl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" creationId="{8819C7AE-B1FC-0B65-456F-ABB2D239B003}"/>
          </ac:grpSpMkLst>
        </pc:grpChg>
        <pc:grpChg chg="mod topLvl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7" creationId="{239C07EE-8773-9B2A-E103-3882D14E0FFB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0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1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2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3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4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5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6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09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10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11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12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13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14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4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5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6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7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8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39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42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56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57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58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59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0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1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2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3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4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5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6" creationId="{00000000-0000-0000-0000-000000000000}"/>
          </ac:grpSpMkLst>
        </pc:grpChg>
        <pc:grpChg chg="mod">
          <ac:chgData name="板野 精之" userId="d14abaad31e2099c" providerId="LiveId" clId="{5117EBF9-BC1A-4141-ACF3-7868CA0F338E}" dt="2023-03-07T06:57:20.534" v="161" actId="165"/>
          <ac:grpSpMkLst>
            <pc:docMk/>
            <pc:sldMk cId="1840233059" sldId="257"/>
            <ac:grpSpMk id="367" creationId="{00000000-0000-0000-0000-000000000000}"/>
          </ac:grpSpMkLst>
        </pc:grp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3" creationId="{95288F55-75C9-732F-5DB7-CEC9BC7C037F}"/>
          </ac:cxnSpMkLst>
        </pc:cxn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7" creationId="{CED2A3B3-2631-C918-962C-6721A13EE02F}"/>
          </ac:cxnSpMkLst>
        </pc:cxn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17" creationId="{170B4461-AF88-299E-D32F-919F5FFDE4DD}"/>
          </ac:cxnSpMkLst>
        </pc:cxn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18" creationId="{4F972C5D-1471-E2A8-D0C5-52CB1F703067}"/>
          </ac:cxnSpMkLst>
        </pc:cxn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19" creationId="{42A22334-F6B1-7CB7-84B1-CA3ADA1D57DD}"/>
          </ac:cxnSpMkLst>
        </pc:cxn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20" creationId="{DB7ED10B-CD0B-7DAA-63EB-3126881163FD}"/>
          </ac:cxnSpMkLst>
        </pc:cxnChg>
        <pc:cxnChg chg="mod topLvl">
          <ac:chgData name="板野 精之" userId="d14abaad31e2099c" providerId="LiveId" clId="{5117EBF9-BC1A-4141-ACF3-7868CA0F338E}" dt="2023-03-07T06:57:37.456" v="162" actId="2711"/>
          <ac:cxnSpMkLst>
            <pc:docMk/>
            <pc:sldMk cId="1840233059" sldId="257"/>
            <ac:cxnSpMk id="22" creationId="{86ACBD18-056B-19A9-B4A7-38A505E206D4}"/>
          </ac:cxnSpMkLst>
        </pc:cxnChg>
        <pc:cxnChg chg="mod topLvl">
          <ac:chgData name="板野 精之" userId="d14abaad31e2099c" providerId="LiveId" clId="{5117EBF9-BC1A-4141-ACF3-7868CA0F338E}" dt="2023-03-07T06:57:20.534" v="161" actId="165"/>
          <ac:cxnSpMkLst>
            <pc:docMk/>
            <pc:sldMk cId="1840233059" sldId="257"/>
            <ac:cxnSpMk id="344" creationId="{00000000-0000-0000-0000-000000000000}"/>
          </ac:cxnSpMkLst>
        </pc:cxnChg>
      </pc:sldChg>
      <pc:sldChg chg="addSp delSp modSp mod">
        <pc:chgData name="板野 精之" userId="d14abaad31e2099c" providerId="LiveId" clId="{5117EBF9-BC1A-4141-ACF3-7868CA0F338E}" dt="2023-03-10T02:20:32.668" v="212"/>
        <pc:sldMkLst>
          <pc:docMk/>
          <pc:sldMk cId="2089187721" sldId="258"/>
        </pc:sldMkLst>
        <pc:spChg chg="add mod">
          <ac:chgData name="板野 精之" userId="d14abaad31e2099c" providerId="LiveId" clId="{5117EBF9-BC1A-4141-ACF3-7868CA0F338E}" dt="2023-03-07T06:58:24.245" v="175" actId="1076"/>
          <ac:spMkLst>
            <pc:docMk/>
            <pc:sldMk cId="2089187721" sldId="258"/>
            <ac:spMk id="2" creationId="{DF8F86F5-966F-9513-9EAC-FE79545C43C9}"/>
          </ac:spMkLst>
        </pc:spChg>
        <pc:spChg chg="del mod">
          <ac:chgData name="板野 精之" userId="d14abaad31e2099c" providerId="LiveId" clId="{5117EBF9-BC1A-4141-ACF3-7868CA0F338E}" dt="2023-03-07T06:58:16.750" v="174" actId="478"/>
          <ac:spMkLst>
            <pc:docMk/>
            <pc:sldMk cId="2089187721" sldId="258"/>
            <ac:spMk id="5" creationId="{1D342F44-2B97-2DB3-88AC-C1C680222DD3}"/>
          </ac:spMkLst>
        </pc:spChg>
        <pc:graphicFrameChg chg="mod modGraphic">
          <ac:chgData name="板野 精之" userId="d14abaad31e2099c" providerId="LiveId" clId="{5117EBF9-BC1A-4141-ACF3-7868CA0F338E}" dt="2023-03-10T02:20:32.668" v="212"/>
          <ac:graphicFrameMkLst>
            <pc:docMk/>
            <pc:sldMk cId="2089187721" sldId="258"/>
            <ac:graphicFrameMk id="6" creationId="{647F7E30-80FD-4CFC-B3EA-6FA0814B7B06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7751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51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8213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086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0651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293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9391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07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184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132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459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2FB64E-DC0D-4E66-9F93-C68D51C76465}" type="datetimeFigureOut">
              <a:rPr kumimoji="1" lang="ja-JP" altLang="en-US" smtClean="0"/>
              <a:t>2023/6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CA48F-3187-4FB7-9ABD-E3BC3D3B7C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123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8F86F5-966F-9513-9EAC-FE79545C43C9}"/>
              </a:ext>
            </a:extLst>
          </p:cNvPr>
          <p:cNvSpPr txBox="1"/>
          <p:nvPr/>
        </p:nvSpPr>
        <p:spPr>
          <a:xfrm>
            <a:off x="154817" y="374568"/>
            <a:ext cx="30459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latin typeface="Times New Roman" panose="02020603050405020304" pitchFamily="18" charset="0"/>
                <a:ea typeface="Meiryo UI" panose="020B0604030504040204" pitchFamily="50" charset="-128"/>
              </a:rPr>
              <a:t>Supplementary Table S1</a:t>
            </a:r>
            <a:endParaRPr lang="en-US" altLang="ja-JP" sz="1100" b="1" dirty="0">
              <a:effectLst/>
              <a:latin typeface="Times New Roman" panose="02020603050405020304" pitchFamily="18" charset="0"/>
              <a:ea typeface="Meiryo UI" panose="020B0604030504040204" pitchFamily="50" charset="-128"/>
            </a:endParaRPr>
          </a:p>
        </p:txBody>
      </p:sp>
      <p:graphicFrame>
        <p:nvGraphicFramePr>
          <p:cNvPr id="11" name="表 6">
            <a:extLst>
              <a:ext uri="{FF2B5EF4-FFF2-40B4-BE49-F238E27FC236}">
                <a16:creationId xmlns:a16="http://schemas.microsoft.com/office/drawing/2014/main" id="{9114C31B-B77C-1CDD-1FF7-79D1350790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448886"/>
              </p:ext>
            </p:extLst>
          </p:nvPr>
        </p:nvGraphicFramePr>
        <p:xfrm>
          <a:off x="628341" y="841203"/>
          <a:ext cx="5144929" cy="470795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66740">
                  <a:extLst>
                    <a:ext uri="{9D8B030D-6E8A-4147-A177-3AD203B41FA5}">
                      <a16:colId xmlns:a16="http://schemas.microsoft.com/office/drawing/2014/main" val="2246049247"/>
                    </a:ext>
                  </a:extLst>
                </a:gridCol>
                <a:gridCol w="564777">
                  <a:extLst>
                    <a:ext uri="{9D8B030D-6E8A-4147-A177-3AD203B41FA5}">
                      <a16:colId xmlns:a16="http://schemas.microsoft.com/office/drawing/2014/main" val="3808162297"/>
                    </a:ext>
                  </a:extLst>
                </a:gridCol>
                <a:gridCol w="2097741">
                  <a:extLst>
                    <a:ext uri="{9D8B030D-6E8A-4147-A177-3AD203B41FA5}">
                      <a16:colId xmlns:a16="http://schemas.microsoft.com/office/drawing/2014/main" val="3219456723"/>
                    </a:ext>
                  </a:extLst>
                </a:gridCol>
                <a:gridCol w="2115671">
                  <a:extLst>
                    <a:ext uri="{9D8B030D-6E8A-4147-A177-3AD203B41FA5}">
                      <a16:colId xmlns:a16="http://schemas.microsoft.com/office/drawing/2014/main" val="209704439"/>
                    </a:ext>
                  </a:extLst>
                </a:gridCol>
              </a:tblGrid>
              <a:tr h="370100">
                <a:tc rowSpan="2" gridSpan="2">
                  <a:txBody>
                    <a:bodyPr/>
                    <a:lstStyle/>
                    <a:p>
                      <a:pPr algn="ctr"/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djusted sub-distribution hazard ratios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 incidence of CKD stage G5 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5% confidence intervals)</a:t>
                      </a:r>
                      <a:endParaRPr kumimoji="1" lang="ja-JP" altLang="en-US" dirty="0"/>
                    </a:p>
                  </a:txBody>
                  <a:tcPr marL="9525" marR="9525" marT="9525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/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4767241"/>
                  </a:ext>
                </a:extLst>
              </a:tr>
              <a:tr h="370100">
                <a:tc gridSpan="2" vMerge="1">
                  <a:txBody>
                    <a:bodyPr/>
                    <a:lstStyle/>
                    <a:p>
                      <a:pPr algn="ctr"/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 hMerge="1" vMerge="1">
                  <a:txBody>
                    <a:bodyPr/>
                    <a:lstStyle/>
                    <a:p>
                      <a:pPr algn="ctr"/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</a:t>
                      </a:r>
                      <a:r>
                        <a:rPr kumimoji="1" lang="ja-JP" altLang="en-US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≤ 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GFR</a:t>
                      </a:r>
                      <a:r>
                        <a:rPr kumimoji="1" lang="ja-JP" altLang="en-US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&lt;30 ml/min/1.73m</a:t>
                      </a:r>
                      <a:r>
                        <a:rPr kumimoji="1" lang="en-US" altLang="ja-JP" sz="1100" b="1" baseline="30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dirty="0"/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GFR</a:t>
                      </a:r>
                      <a:r>
                        <a:rPr kumimoji="1" lang="ja-JP" altLang="en-US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≥ 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</a:t>
                      </a:r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l/min/1.73m</a:t>
                      </a:r>
                      <a:r>
                        <a:rPr kumimoji="1" lang="en-US" altLang="ja-JP" sz="1100" b="1" baseline="30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dirty="0"/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2391322"/>
                  </a:ext>
                </a:extLst>
              </a:tr>
              <a:tr h="283411">
                <a:tc rowSpan="14"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i="0" u="none" strike="noStrike" kern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hange in eGFR slope (ml/min/1.73m2/year)</a:t>
                      </a:r>
                      <a:endParaRPr kumimoji="1"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vert270"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least-squares method (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-year slope</a:t>
                      </a:r>
                      <a:r>
                        <a:rPr lang="en-US" altLang="ja-JP" sz="1100" b="1" i="0" u="none" strike="noStrike" dirty="0">
                          <a:solidFill>
                            <a:schemeClr val="tx1">
                              <a:lumMod val="85000"/>
                              <a:lumOff val="15000"/>
                            </a:schemeClr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rgbClr val="FF1111">
                        <a:alpha val="2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230957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/>
                        <a:t>eGFR slope reduction (ml/min/1.73m2/year)</a:t>
                      </a:r>
                      <a:endParaRPr kumimoji="1" lang="ja-JP" altLang="en-US" sz="1600" dirty="0"/>
                    </a:p>
                  </a:txBody>
                  <a:tcPr vert="vert270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0.25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62 (0.932,0.993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81 (0.976,0.987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0209514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0.50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26 (0.869,0.987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63 (0.952,0.974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6839283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0.75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91 (0.809,0.981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45 (0.929,0.961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2504804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1.00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57 (0.754,0.974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27 (0.906,0.948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9818780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1.25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25 (0.703,0.968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09 (0.884,0.935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465399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1.50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794 (0.655,0.961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92 (0.863,0.923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6984919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mixed-effects model (2-year slope)</a:t>
                      </a:r>
                      <a:endParaRPr kumimoji="1" lang="ja-JP" altLang="en-US" sz="11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rgbClr val="DAE3F3">
                        <a:alpha val="6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6381256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0.25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38 (0.892,0.985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75 (0.967,0.982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6515003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0.50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79 (0.796,0.970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50 (0.935,0.965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5420909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0.75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24 (0.710,0.956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25 (0.903,0.948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8991012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1.00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773 (0.634,0.942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902 (0.873,0.931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7672056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1.25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724 (0.566,0.928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79 (0.844,0.915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8384419"/>
                  </a:ext>
                </a:extLst>
              </a:tr>
              <a:tr h="283411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+1.50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679 (0.505,0.914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56 (0.816,0.898)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67375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9187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2DCAFC569C336745A316F455BC4486A3" ma:contentTypeVersion="14" ma:contentTypeDescription="新しいドキュメントを作成します。" ma:contentTypeScope="" ma:versionID="7f9477e849c5dd1e0b993f63e8e15ea6">
  <xsd:schema xmlns:xsd="http://www.w3.org/2001/XMLSchema" xmlns:xs="http://www.w3.org/2001/XMLSchema" xmlns:p="http://schemas.microsoft.com/office/2006/metadata/properties" xmlns:ns3="e3d37cd5-7083-4bbb-b422-504e40562006" xmlns:ns4="d789ee47-cb74-476d-8cd8-d491f5c3ba4d" targetNamespace="http://schemas.microsoft.com/office/2006/metadata/properties" ma:root="true" ma:fieldsID="ef460e5422dd0ff387cfd75f1b66ca28" ns3:_="" ns4:_="">
    <xsd:import namespace="e3d37cd5-7083-4bbb-b422-504e40562006"/>
    <xsd:import namespace="d789ee47-cb74-476d-8cd8-d491f5c3ba4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3d37cd5-7083-4bbb-b422-504e4056200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789ee47-cb74-476d-8cd8-d491f5c3ba4d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BEFD415-5320-472B-8384-F428B6F97E2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3d37cd5-7083-4bbb-b422-504e40562006"/>
    <ds:schemaRef ds:uri="d789ee47-cb74-476d-8cd8-d491f5c3ba4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918BD4F-66A5-40F8-A155-1F39D016AD94}">
  <ds:schemaRefs>
    <ds:schemaRef ds:uri="http://schemas.microsoft.com/office/2006/metadata/properties"/>
    <ds:schemaRef ds:uri="d789ee47-cb74-476d-8cd8-d491f5c3ba4d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e3d37cd5-7083-4bbb-b422-504e40562006"/>
    <ds:schemaRef ds:uri="http://purl.org/dc/elements/1.1/"/>
    <ds:schemaRef ds:uri="http://schemas.microsoft.com/office/infopath/2007/PartnerControl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DD322334-3E2E-4BD4-8369-85161FD9167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4</TotalTime>
  <Words>182</Words>
  <Application>Microsoft Office PowerPoint</Application>
  <PresentationFormat>A4 210 x 297 mm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板野 精之</dc:creator>
  <cp:lastModifiedBy>SEIJI ITANO</cp:lastModifiedBy>
  <cp:revision>17</cp:revision>
  <cp:lastPrinted>2022-09-08T03:26:50Z</cp:lastPrinted>
  <dcterms:created xsi:type="dcterms:W3CDTF">2022-09-07T05:27:49Z</dcterms:created>
  <dcterms:modified xsi:type="dcterms:W3CDTF">2023-06-26T06:56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CAFC569C336745A316F455BC4486A3</vt:lpwstr>
  </property>
</Properties>
</file>